
<file path=[Content_Types].xml><?xml version="1.0" encoding="utf-8"?>
<Types xmlns="http://schemas.openxmlformats.org/package/2006/content-types">
  <Default Extension="fntdata" ContentType="application/x-fontdata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trictFirstAndLastChars="0" embedTrueTypeFonts="1" saveSubsetFonts="1" autoCompressPictures="0">
  <p:sldMasterIdLst>
    <p:sldMasterId id="2147483691" r:id="rId1"/>
  </p:sldMasterIdLst>
  <p:notesMasterIdLst>
    <p:notesMasterId r:id="rId15"/>
  </p:notesMasterIdLst>
  <p:sldIdLst>
    <p:sldId id="262" r:id="rId2"/>
    <p:sldId id="273" r:id="rId3"/>
    <p:sldId id="274" r:id="rId4"/>
    <p:sldId id="275" r:id="rId5"/>
    <p:sldId id="276" r:id="rId6"/>
    <p:sldId id="277" r:id="rId7"/>
    <p:sldId id="278" r:id="rId8"/>
    <p:sldId id="279" r:id="rId9"/>
    <p:sldId id="280" r:id="rId10"/>
    <p:sldId id="281" r:id="rId11"/>
    <p:sldId id="282" r:id="rId12"/>
    <p:sldId id="283" r:id="rId13"/>
    <p:sldId id="284" r:id="rId14"/>
  </p:sldIdLst>
  <p:sldSz cx="12192000" cy="6858000"/>
  <p:notesSz cx="7010400" cy="9296400"/>
  <p:embeddedFontLst>
    <p:embeddedFont>
      <p:font typeface="Montserrat" pitchFamily="2" charset="77"/>
      <p:regular r:id="rId16"/>
      <p:bold r:id="rId17"/>
      <p:italic r:id="rId18"/>
      <p:boldItalic r:id="rId19"/>
    </p:embeddedFont>
  </p:embeddedFont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008">
          <p15:clr>
            <a:srgbClr val="A4A3A4"/>
          </p15:clr>
        </p15:guide>
        <p15:guide id="2" pos="7248">
          <p15:clr>
            <a:srgbClr val="A4A3A4"/>
          </p15:clr>
        </p15:guide>
      </p15:sldGuideLst>
    </p:ext>
    <p:ext uri="GoogleSlidesCustomDataVersion2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31" roundtripDataSignature="AMtx7mgYfHK01VSZr1O7qcxF2HBYIj3xiA==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Meera Prasad" initials="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07C328A-9CFD-A84E-8E54-BFA755AC32C3}" v="20" dt="2024-04-11T19:25:13.010"/>
  </p1510:revLst>
</p1510:revInfo>
</file>

<file path=ppt/tableStyles.xml><?xml version="1.0" encoding="utf-8"?>
<a:tblStyleLst xmlns:a="http://schemas.openxmlformats.org/drawingml/2006/main" def="{633E41C2-94C5-44B2-B323-6E28DEAA064A}">
  <a:tblStyle styleId="{633E41C2-94C5-44B2-B323-6E28DEAA064A}" styleName="Table_0">
    <a:wholeTbl>
      <a:tcTxStyle b="off" i="off">
        <a:font>
          <a:latin typeface="Gotham Book"/>
          <a:ea typeface="Gotham Book"/>
          <a:cs typeface="Gotham Book"/>
        </a:font>
        <a:schemeClr val="dk1"/>
      </a:tcTxStyle>
      <a:tcStyle>
        <a:tcBdr>
          <a:left>
            <a:ln w="9525" cap="flat" cmpd="sng">
              <a:solidFill>
                <a:srgbClr val="000000">
                  <a:alpha val="0"/>
                </a:srgbClr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9525" cap="flat" cmpd="sng">
              <a:solidFill>
                <a:srgbClr val="000000">
                  <a:alpha val="0"/>
                </a:srgbClr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254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254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9525" cap="flat" cmpd="sng">
              <a:solidFill>
                <a:srgbClr val="000000">
                  <a:alpha val="0"/>
                </a:srgbClr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9525" cap="flat" cmpd="sng">
              <a:solidFill>
                <a:srgbClr val="000000">
                  <a:alpha val="0"/>
                </a:srgbClr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chemeClr val="lt1"/>
          </a:solidFill>
        </a:fill>
      </a:tcStyle>
    </a:wholeTbl>
    <a:band1H>
      <a:tcTxStyle/>
      <a:tcStyle>
        <a:tcBdr/>
        <a:fill>
          <a:solidFill>
            <a:srgbClr val="E7E8E8"/>
          </a:solidFill>
        </a:fill>
      </a:tcStyle>
    </a:band1H>
    <a:band2H>
      <a:tcTxStyle/>
      <a:tcStyle>
        <a:tcBdr/>
      </a:tcStyle>
    </a:band2H>
    <a:band1V>
      <a:tcTxStyle/>
      <a:tcStyle>
        <a:tcBdr/>
        <a:fill>
          <a:solidFill>
            <a:srgbClr val="E7E8E8"/>
          </a:solidFill>
        </a:fill>
      </a:tcStyle>
    </a:band1V>
    <a:band2V>
      <a:tcTxStyle/>
      <a:tcStyle>
        <a:tcBdr/>
      </a:tcStyle>
    </a:band2V>
    <a:lastCol>
      <a:tcTxStyle b="on" i="off">
        <a:font>
          <a:latin typeface="Gotham Book"/>
          <a:ea typeface="Gotham Book"/>
          <a:cs typeface="Gotham Book"/>
        </a:font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 i="off">
        <a:font>
          <a:latin typeface="Gotham Book"/>
          <a:ea typeface="Gotham Book"/>
          <a:cs typeface="Gotham Book"/>
        </a:font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 i="off"/>
      <a:tcStyle>
        <a:tcBdr>
          <a:top>
            <a:ln w="508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top>
        </a:tcBdr>
        <a:fill>
          <a:solidFill>
            <a:schemeClr val="lt1"/>
          </a:solidFill>
        </a:fill>
      </a:tcStyle>
    </a:lastRow>
    <a:seCell>
      <a:tcTxStyle b="on" i="off">
        <a:font>
          <a:latin typeface="Gotham Book"/>
          <a:ea typeface="Gotham Book"/>
          <a:cs typeface="Gotham Book"/>
        </a:font>
        <a:schemeClr val="dk1"/>
      </a:tcTxStyle>
      <a:tcStyle>
        <a:tcBdr/>
      </a:tcStyle>
    </a:seCell>
    <a:swCell>
      <a:tcTxStyle b="on" i="off">
        <a:font>
          <a:latin typeface="Gotham Book"/>
          <a:ea typeface="Gotham Book"/>
          <a:cs typeface="Gotham Book"/>
        </a:font>
        <a:schemeClr val="dk1"/>
      </a:tcTxStyle>
      <a:tcStyle>
        <a:tcBdr/>
      </a:tcStyle>
    </a:swCell>
    <a:firstRow>
      <a:tcTxStyle b="on" i="off">
        <a:font>
          <a:latin typeface="Gotham Book"/>
          <a:ea typeface="Gotham Book"/>
          <a:cs typeface="Gotham Book"/>
        </a:font>
        <a:schemeClr val="lt1"/>
      </a:tcTxStyle>
      <a:tcStyle>
        <a:tcBdr>
          <a:bottom>
            <a:ln w="254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bottom>
        </a:tcBdr>
        <a:fill>
          <a:solidFill>
            <a:schemeClr val="accent1"/>
          </a:solidFill>
        </a:fill>
      </a:tcStyle>
    </a:firstRow>
    <a:neCell>
      <a:tcTxStyle/>
      <a:tcStyle>
        <a:tcBdr/>
      </a:tcStyle>
    </a:neCell>
    <a:nwCell>
      <a:tcTxStyle/>
      <a:tcStyle>
        <a:tcBdr/>
      </a:tcStyle>
    </a:nwCell>
  </a:tblStyle>
  <a:tblStyle styleId="{FC385875-93DB-4323-932E-BDD0430E097A}" styleName="Table_1">
    <a:wholeTbl>
      <a:tcTxStyle b="off" i="off">
        <a:font>
          <a:latin typeface="Gotham Book"/>
          <a:ea typeface="Gotham Book"/>
          <a:cs typeface="Gotham Book"/>
        </a:font>
        <a:schemeClr val="dk1"/>
      </a:tcTxStyle>
      <a:tcStyle>
        <a:tcBdr>
          <a:left>
            <a:ln w="9525" cap="flat" cmpd="sng">
              <a:solidFill>
                <a:schemeClr val="accent1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9525" cap="flat" cmpd="sng">
              <a:solidFill>
                <a:schemeClr val="accent1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9525" cap="flat" cmpd="sng">
              <a:solidFill>
                <a:schemeClr val="accent1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9525" cap="flat" cmpd="sng">
              <a:solidFill>
                <a:schemeClr val="accent1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9525" cap="flat" cmpd="sng">
              <a:solidFill>
                <a:srgbClr val="000000">
                  <a:alpha val="0"/>
                </a:srgbClr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9525" cap="flat" cmpd="sng">
              <a:solidFill>
                <a:srgbClr val="000000">
                  <a:alpha val="0"/>
                </a:srgbClr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rgbClr val="FFFFFF">
              <a:alpha val="0"/>
            </a:srgbClr>
          </a:solidFill>
        </a:fill>
      </a:tcStyle>
    </a:wholeTbl>
    <a:band1H>
      <a:tcTxStyle/>
      <a:tcStyle>
        <a:tcBdr>
          <a:top>
            <a:ln w="9525" cap="flat" cmpd="sng">
              <a:solidFill>
                <a:schemeClr val="accent1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9525" cap="flat" cmpd="sng">
              <a:solidFill>
                <a:schemeClr val="accent1"/>
              </a:solidFill>
              <a:prstDash val="solid"/>
              <a:round/>
              <a:headEnd type="none" w="sm" len="sm"/>
              <a:tailEnd type="none" w="sm" len="sm"/>
            </a:ln>
          </a:bottom>
        </a:tcBdr>
      </a:tcStyle>
    </a:band1H>
    <a:band2H>
      <a:tcTxStyle/>
      <a:tcStyle>
        <a:tcBdr/>
      </a:tcStyle>
    </a:band2H>
    <a:band1V>
      <a:tcTxStyle/>
      <a:tcStyle>
        <a:tcBdr>
          <a:left>
            <a:ln w="9525" cap="flat" cmpd="sng">
              <a:solidFill>
                <a:schemeClr val="accent1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9525" cap="flat" cmpd="sng">
              <a:solidFill>
                <a:schemeClr val="accent1"/>
              </a:solidFill>
              <a:prstDash val="solid"/>
              <a:round/>
              <a:headEnd type="none" w="sm" len="sm"/>
              <a:tailEnd type="none" w="sm" len="sm"/>
            </a:ln>
          </a:right>
        </a:tcBdr>
      </a:tcStyle>
    </a:band1V>
    <a:band2V>
      <a:tcTxStyle/>
      <a:tcStyle>
        <a:tcBdr>
          <a:left>
            <a:ln w="9525" cap="flat" cmpd="sng">
              <a:solidFill>
                <a:schemeClr val="accent1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9525" cap="flat" cmpd="sng">
              <a:solidFill>
                <a:schemeClr val="accent1"/>
              </a:solidFill>
              <a:prstDash val="solid"/>
              <a:round/>
              <a:headEnd type="none" w="sm" len="sm"/>
              <a:tailEnd type="none" w="sm" len="sm"/>
            </a:ln>
          </a:right>
        </a:tcBdr>
      </a:tcStyle>
    </a:band2V>
    <a:lastCol>
      <a:tcTxStyle b="on" i="off"/>
      <a:tcStyle>
        <a:tcBdr/>
      </a:tcStyle>
    </a:lastCol>
    <a:firstCol>
      <a:tcTxStyle b="on" i="off"/>
      <a:tcStyle>
        <a:tcBdr/>
      </a:tcStyle>
    </a:firstCol>
    <a:lastRow>
      <a:tcTxStyle b="on" i="off"/>
      <a:tcStyle>
        <a:tcBdr>
          <a:top>
            <a:ln w="50800" cap="flat" cmpd="sng">
              <a:solidFill>
                <a:schemeClr val="accent1"/>
              </a:solidFill>
              <a:prstDash val="solid"/>
              <a:round/>
              <a:headEnd type="none" w="sm" len="sm"/>
              <a:tailEnd type="none" w="sm" len="sm"/>
            </a:ln>
          </a:top>
        </a:tcBdr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 b="on" i="off">
        <a:font>
          <a:latin typeface="Gotham Book"/>
          <a:ea typeface="Gotham Book"/>
          <a:cs typeface="Gotham Book"/>
        </a:font>
        <a:schemeClr val="lt1"/>
      </a:tcTxStyle>
      <a:tcStyle>
        <a:tcBdr/>
        <a:fill>
          <a:solidFill>
            <a:schemeClr val="accent1"/>
          </a:solidFill>
        </a:fill>
      </a:tcStyle>
    </a:firstRow>
    <a:neCell>
      <a:tcTxStyle/>
      <a:tcStyle>
        <a:tcBdr/>
      </a:tcStyle>
    </a:neCell>
    <a:nwCell>
      <a:tcTxStyle/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285"/>
    <p:restoredTop sz="94693"/>
  </p:normalViewPr>
  <p:slideViewPr>
    <p:cSldViewPr snapToGrid="0">
      <p:cViewPr varScale="1">
        <p:scale>
          <a:sx n="141" d="100"/>
          <a:sy n="141" d="100"/>
        </p:scale>
        <p:origin x="1040" y="176"/>
      </p:cViewPr>
      <p:guideLst>
        <p:guide orient="horz" pos="4008"/>
        <p:guide pos="72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font" Target="fonts/font3.fntdata"/><Relationship Id="rId3" Type="http://schemas.openxmlformats.org/officeDocument/2006/relationships/slide" Target="slides/slide2.xml"/><Relationship Id="rId34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font" Target="fonts/font2.fntdata"/><Relationship Id="rId33" Type="http://schemas.openxmlformats.org/officeDocument/2006/relationships/presProps" Target="presProps.xml"/><Relationship Id="rId38" Type="http://schemas.microsoft.com/office/2015/10/relationships/revisionInfo" Target="revisionInfo.xml"/><Relationship Id="rId2" Type="http://schemas.openxmlformats.org/officeDocument/2006/relationships/slide" Target="slides/slide1.xml"/><Relationship Id="rId16" Type="http://schemas.openxmlformats.org/officeDocument/2006/relationships/font" Target="fonts/font1.fntdata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32" Type="http://schemas.openxmlformats.org/officeDocument/2006/relationships/commentAuthors" Target="commentAuthors.xml"/><Relationship Id="rId37" Type="http://schemas.microsoft.com/office/2016/11/relationships/changesInfo" Target="changesInfos/changesInfo1.xml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36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font" Target="fonts/font4.fntdata"/><Relationship Id="rId31" Type="http://customschemas.google.com/relationships/presentationmetadata" Target="metadata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35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incoln Pasquina" userId="9a36d1e4-706f-4785-b8b1-88ca851b6fd6" providerId="ADAL" clId="{9861CB29-4046-41D1-B037-DCA4825F3146}"/>
    <pc:docChg chg="undo custSel modSld">
      <pc:chgData name="Lincoln Pasquina" userId="9a36d1e4-706f-4785-b8b1-88ca851b6fd6" providerId="ADAL" clId="{9861CB29-4046-41D1-B037-DCA4825F3146}" dt="2024-04-11T19:30:41.053" v="212" actId="20577"/>
      <pc:docMkLst>
        <pc:docMk/>
      </pc:docMkLst>
      <pc:sldChg chg="modSp mod">
        <pc:chgData name="Lincoln Pasquina" userId="9a36d1e4-706f-4785-b8b1-88ca851b6fd6" providerId="ADAL" clId="{9861CB29-4046-41D1-B037-DCA4825F3146}" dt="2024-04-11T19:23:45.432" v="111" actId="20577"/>
        <pc:sldMkLst>
          <pc:docMk/>
          <pc:sldMk cId="0" sldId="273"/>
        </pc:sldMkLst>
        <pc:spChg chg="mod">
          <ac:chgData name="Lincoln Pasquina" userId="9a36d1e4-706f-4785-b8b1-88ca851b6fd6" providerId="ADAL" clId="{9861CB29-4046-41D1-B037-DCA4825F3146}" dt="2024-04-11T19:10:30.341" v="80" actId="114"/>
          <ac:spMkLst>
            <pc:docMk/>
            <pc:sldMk cId="0" sldId="273"/>
            <ac:spMk id="724" creationId="{00000000-0000-0000-0000-000000000000}"/>
          </ac:spMkLst>
        </pc:spChg>
        <pc:spChg chg="mod">
          <ac:chgData name="Lincoln Pasquina" userId="9a36d1e4-706f-4785-b8b1-88ca851b6fd6" providerId="ADAL" clId="{9861CB29-4046-41D1-B037-DCA4825F3146}" dt="2024-04-11T19:10:32.613" v="81" actId="114"/>
          <ac:spMkLst>
            <pc:docMk/>
            <pc:sldMk cId="0" sldId="273"/>
            <ac:spMk id="726" creationId="{00000000-0000-0000-0000-000000000000}"/>
          </ac:spMkLst>
        </pc:spChg>
        <pc:spChg chg="mod">
          <ac:chgData name="Lincoln Pasquina" userId="9a36d1e4-706f-4785-b8b1-88ca851b6fd6" providerId="ADAL" clId="{9861CB29-4046-41D1-B037-DCA4825F3146}" dt="2024-04-11T19:02:33.683" v="1" actId="114"/>
          <ac:spMkLst>
            <pc:docMk/>
            <pc:sldMk cId="0" sldId="273"/>
            <ac:spMk id="742" creationId="{00000000-0000-0000-0000-000000000000}"/>
          </ac:spMkLst>
        </pc:spChg>
        <pc:spChg chg="mod">
          <ac:chgData name="Lincoln Pasquina" userId="9a36d1e4-706f-4785-b8b1-88ca851b6fd6" providerId="ADAL" clId="{9861CB29-4046-41D1-B037-DCA4825F3146}" dt="2024-04-11T19:02:39.972" v="3" actId="114"/>
          <ac:spMkLst>
            <pc:docMk/>
            <pc:sldMk cId="0" sldId="273"/>
            <ac:spMk id="743" creationId="{00000000-0000-0000-0000-000000000000}"/>
          </ac:spMkLst>
        </pc:spChg>
        <pc:spChg chg="mod">
          <ac:chgData name="Lincoln Pasquina" userId="9a36d1e4-706f-4785-b8b1-88ca851b6fd6" providerId="ADAL" clId="{9861CB29-4046-41D1-B037-DCA4825F3146}" dt="2024-04-11T19:11:02.500" v="93" actId="114"/>
          <ac:spMkLst>
            <pc:docMk/>
            <pc:sldMk cId="0" sldId="273"/>
            <ac:spMk id="744" creationId="{00000000-0000-0000-0000-000000000000}"/>
          </ac:spMkLst>
        </pc:spChg>
        <pc:spChg chg="mod">
          <ac:chgData name="Lincoln Pasquina" userId="9a36d1e4-706f-4785-b8b1-88ca851b6fd6" providerId="ADAL" clId="{9861CB29-4046-41D1-B037-DCA4825F3146}" dt="2024-04-11T19:23:45.432" v="111" actId="20577"/>
          <ac:spMkLst>
            <pc:docMk/>
            <pc:sldMk cId="0" sldId="273"/>
            <ac:spMk id="747" creationId="{00000000-0000-0000-0000-000000000000}"/>
          </ac:spMkLst>
        </pc:spChg>
      </pc:sldChg>
      <pc:sldChg chg="modSp mod">
        <pc:chgData name="Lincoln Pasquina" userId="9a36d1e4-706f-4785-b8b1-88ca851b6fd6" providerId="ADAL" clId="{9861CB29-4046-41D1-B037-DCA4825F3146}" dt="2024-04-11T19:24:02.374" v="115" actId="2711"/>
        <pc:sldMkLst>
          <pc:docMk/>
          <pc:sldMk cId="0" sldId="274"/>
        </pc:sldMkLst>
        <pc:spChg chg="mod">
          <ac:chgData name="Lincoln Pasquina" userId="9a36d1e4-706f-4785-b8b1-88ca851b6fd6" providerId="ADAL" clId="{9861CB29-4046-41D1-B037-DCA4825F3146}" dt="2024-04-11T19:24:02.374" v="115" actId="2711"/>
          <ac:spMkLst>
            <pc:docMk/>
            <pc:sldMk cId="0" sldId="274"/>
            <ac:spMk id="766" creationId="{00000000-0000-0000-0000-000000000000}"/>
          </ac:spMkLst>
        </pc:spChg>
      </pc:sldChg>
      <pc:sldChg chg="modSp mod">
        <pc:chgData name="Lincoln Pasquina" userId="9a36d1e4-706f-4785-b8b1-88ca851b6fd6" providerId="ADAL" clId="{9861CB29-4046-41D1-B037-DCA4825F3146}" dt="2024-04-11T19:25:04.339" v="133" actId="20577"/>
        <pc:sldMkLst>
          <pc:docMk/>
          <pc:sldMk cId="0" sldId="275"/>
        </pc:sldMkLst>
        <pc:spChg chg="mod">
          <ac:chgData name="Lincoln Pasquina" userId="9a36d1e4-706f-4785-b8b1-88ca851b6fd6" providerId="ADAL" clId="{9861CB29-4046-41D1-B037-DCA4825F3146}" dt="2024-04-11T19:25:04.339" v="133" actId="20577"/>
          <ac:spMkLst>
            <pc:docMk/>
            <pc:sldMk cId="0" sldId="275"/>
            <ac:spMk id="772" creationId="{00000000-0000-0000-0000-000000000000}"/>
          </ac:spMkLst>
        </pc:spChg>
      </pc:sldChg>
      <pc:sldChg chg="modSp mod">
        <pc:chgData name="Lincoln Pasquina" userId="9a36d1e4-706f-4785-b8b1-88ca851b6fd6" providerId="ADAL" clId="{9861CB29-4046-41D1-B037-DCA4825F3146}" dt="2024-04-11T19:24:48.062" v="126" actId="14100"/>
        <pc:sldMkLst>
          <pc:docMk/>
          <pc:sldMk cId="0" sldId="276"/>
        </pc:sldMkLst>
        <pc:spChg chg="mod">
          <ac:chgData name="Lincoln Pasquina" userId="9a36d1e4-706f-4785-b8b1-88ca851b6fd6" providerId="ADAL" clId="{9861CB29-4046-41D1-B037-DCA4825F3146}" dt="2024-04-11T19:24:48.062" v="126" actId="14100"/>
          <ac:spMkLst>
            <pc:docMk/>
            <pc:sldMk cId="0" sldId="276"/>
            <ac:spMk id="788" creationId="{00000000-0000-0000-0000-000000000000}"/>
          </ac:spMkLst>
        </pc:spChg>
      </pc:sldChg>
      <pc:sldChg chg="modSp mod">
        <pc:chgData name="Lincoln Pasquina" userId="9a36d1e4-706f-4785-b8b1-88ca851b6fd6" providerId="ADAL" clId="{9861CB29-4046-41D1-B037-DCA4825F3146}" dt="2024-04-11T19:24:26.859" v="119" actId="1076"/>
        <pc:sldMkLst>
          <pc:docMk/>
          <pc:sldMk cId="0" sldId="277"/>
        </pc:sldMkLst>
        <pc:spChg chg="mod">
          <ac:chgData name="Lincoln Pasquina" userId="9a36d1e4-706f-4785-b8b1-88ca851b6fd6" providerId="ADAL" clId="{9861CB29-4046-41D1-B037-DCA4825F3146}" dt="2024-04-11T19:24:26.859" v="119" actId="1076"/>
          <ac:spMkLst>
            <pc:docMk/>
            <pc:sldMk cId="0" sldId="277"/>
            <ac:spMk id="802" creationId="{00000000-0000-0000-0000-000000000000}"/>
          </ac:spMkLst>
        </pc:spChg>
      </pc:sldChg>
      <pc:sldChg chg="modSp mod">
        <pc:chgData name="Lincoln Pasquina" userId="9a36d1e4-706f-4785-b8b1-88ca851b6fd6" providerId="ADAL" clId="{9861CB29-4046-41D1-B037-DCA4825F3146}" dt="2024-04-11T19:25:40.758" v="138" actId="255"/>
        <pc:sldMkLst>
          <pc:docMk/>
          <pc:sldMk cId="0" sldId="278"/>
        </pc:sldMkLst>
        <pc:spChg chg="mod">
          <ac:chgData name="Lincoln Pasquina" userId="9a36d1e4-706f-4785-b8b1-88ca851b6fd6" providerId="ADAL" clId="{9861CB29-4046-41D1-B037-DCA4825F3146}" dt="2024-04-11T19:25:40.758" v="138" actId="255"/>
          <ac:spMkLst>
            <pc:docMk/>
            <pc:sldMk cId="0" sldId="278"/>
            <ac:spMk id="819" creationId="{00000000-0000-0000-0000-000000000000}"/>
          </ac:spMkLst>
        </pc:spChg>
      </pc:sldChg>
      <pc:sldChg chg="modSp mod">
        <pc:chgData name="Lincoln Pasquina" userId="9a36d1e4-706f-4785-b8b1-88ca851b6fd6" providerId="ADAL" clId="{9861CB29-4046-41D1-B037-DCA4825F3146}" dt="2024-04-11T19:25:57.016" v="146" actId="2711"/>
        <pc:sldMkLst>
          <pc:docMk/>
          <pc:sldMk cId="3640774013" sldId="279"/>
        </pc:sldMkLst>
        <pc:spChg chg="mod">
          <ac:chgData name="Lincoln Pasquina" userId="9a36d1e4-706f-4785-b8b1-88ca851b6fd6" providerId="ADAL" clId="{9861CB29-4046-41D1-B037-DCA4825F3146}" dt="2024-04-11T19:25:57.016" v="146" actId="2711"/>
          <ac:spMkLst>
            <pc:docMk/>
            <pc:sldMk cId="3640774013" sldId="279"/>
            <ac:spMk id="4" creationId="{5E49E098-7298-DD90-B553-49D3481A3B6E}"/>
          </ac:spMkLst>
        </pc:spChg>
      </pc:sldChg>
      <pc:sldChg chg="modSp mod">
        <pc:chgData name="Lincoln Pasquina" userId="9a36d1e4-706f-4785-b8b1-88ca851b6fd6" providerId="ADAL" clId="{9861CB29-4046-41D1-B037-DCA4825F3146}" dt="2024-04-11T19:26:28.742" v="151" actId="6549"/>
        <pc:sldMkLst>
          <pc:docMk/>
          <pc:sldMk cId="2776125627" sldId="280"/>
        </pc:sldMkLst>
        <pc:spChg chg="mod">
          <ac:chgData name="Lincoln Pasquina" userId="9a36d1e4-706f-4785-b8b1-88ca851b6fd6" providerId="ADAL" clId="{9861CB29-4046-41D1-B037-DCA4825F3146}" dt="2024-04-11T19:26:28.742" v="151" actId="6549"/>
          <ac:spMkLst>
            <pc:docMk/>
            <pc:sldMk cId="2776125627" sldId="280"/>
            <ac:spMk id="21" creationId="{0B0C2602-0D25-EB67-0E26-0311DD81ED21}"/>
          </ac:spMkLst>
        </pc:spChg>
      </pc:sldChg>
      <pc:sldChg chg="modSp mod">
        <pc:chgData name="Lincoln Pasquina" userId="9a36d1e4-706f-4785-b8b1-88ca851b6fd6" providerId="ADAL" clId="{9861CB29-4046-41D1-B037-DCA4825F3146}" dt="2024-04-11T19:27:16.212" v="162" actId="114"/>
        <pc:sldMkLst>
          <pc:docMk/>
          <pc:sldMk cId="0" sldId="281"/>
        </pc:sldMkLst>
        <pc:spChg chg="mod">
          <ac:chgData name="Lincoln Pasquina" userId="9a36d1e4-706f-4785-b8b1-88ca851b6fd6" providerId="ADAL" clId="{9861CB29-4046-41D1-B037-DCA4825F3146}" dt="2024-04-11T19:27:16.212" v="162" actId="114"/>
          <ac:spMkLst>
            <pc:docMk/>
            <pc:sldMk cId="0" sldId="281"/>
            <ac:spMk id="832" creationId="{00000000-0000-0000-0000-000000000000}"/>
          </ac:spMkLst>
        </pc:spChg>
      </pc:sldChg>
      <pc:sldChg chg="delSp modSp mod">
        <pc:chgData name="Lincoln Pasquina" userId="9a36d1e4-706f-4785-b8b1-88ca851b6fd6" providerId="ADAL" clId="{9861CB29-4046-41D1-B037-DCA4825F3146}" dt="2024-04-11T19:29:29.926" v="192" actId="255"/>
        <pc:sldMkLst>
          <pc:docMk/>
          <pc:sldMk cId="0" sldId="282"/>
        </pc:sldMkLst>
        <pc:spChg chg="mod">
          <ac:chgData name="Lincoln Pasquina" userId="9a36d1e4-706f-4785-b8b1-88ca851b6fd6" providerId="ADAL" clId="{9861CB29-4046-41D1-B037-DCA4825F3146}" dt="2024-04-11T19:29:29.926" v="192" actId="255"/>
          <ac:spMkLst>
            <pc:docMk/>
            <pc:sldMk cId="0" sldId="282"/>
            <ac:spMk id="842" creationId="{00000000-0000-0000-0000-000000000000}"/>
          </ac:spMkLst>
        </pc:spChg>
        <pc:spChg chg="del mod">
          <ac:chgData name="Lincoln Pasquina" userId="9a36d1e4-706f-4785-b8b1-88ca851b6fd6" providerId="ADAL" clId="{9861CB29-4046-41D1-B037-DCA4825F3146}" dt="2024-04-11T19:29:10.563" v="187" actId="478"/>
          <ac:spMkLst>
            <pc:docMk/>
            <pc:sldMk cId="0" sldId="282"/>
            <ac:spMk id="843" creationId="{00000000-0000-0000-0000-000000000000}"/>
          </ac:spMkLst>
        </pc:spChg>
        <pc:graphicFrameChg chg="modGraphic">
          <ac:chgData name="Lincoln Pasquina" userId="9a36d1e4-706f-4785-b8b1-88ca851b6fd6" providerId="ADAL" clId="{9861CB29-4046-41D1-B037-DCA4825F3146}" dt="2024-04-11T19:29:24.617" v="190" actId="2711"/>
          <ac:graphicFrameMkLst>
            <pc:docMk/>
            <pc:sldMk cId="0" sldId="282"/>
            <ac:graphicFrameMk id="841" creationId="{00000000-0000-0000-0000-000000000000}"/>
          </ac:graphicFrameMkLst>
        </pc:graphicFrameChg>
      </pc:sldChg>
      <pc:sldChg chg="delSp modSp mod">
        <pc:chgData name="Lincoln Pasquina" userId="9a36d1e4-706f-4785-b8b1-88ca851b6fd6" providerId="ADAL" clId="{9861CB29-4046-41D1-B037-DCA4825F3146}" dt="2024-04-11T19:30:15.460" v="204" actId="20577"/>
        <pc:sldMkLst>
          <pc:docMk/>
          <pc:sldMk cId="0" sldId="283"/>
        </pc:sldMkLst>
        <pc:spChg chg="mod">
          <ac:chgData name="Lincoln Pasquina" userId="9a36d1e4-706f-4785-b8b1-88ca851b6fd6" providerId="ADAL" clId="{9861CB29-4046-41D1-B037-DCA4825F3146}" dt="2024-04-11T19:29:45.861" v="194" actId="255"/>
          <ac:spMkLst>
            <pc:docMk/>
            <pc:sldMk cId="0" sldId="283"/>
            <ac:spMk id="850" creationId="{00000000-0000-0000-0000-000000000000}"/>
          </ac:spMkLst>
        </pc:spChg>
        <pc:spChg chg="del">
          <ac:chgData name="Lincoln Pasquina" userId="9a36d1e4-706f-4785-b8b1-88ca851b6fd6" providerId="ADAL" clId="{9861CB29-4046-41D1-B037-DCA4825F3146}" dt="2024-04-11T19:29:12.291" v="188" actId="478"/>
          <ac:spMkLst>
            <pc:docMk/>
            <pc:sldMk cId="0" sldId="283"/>
            <ac:spMk id="851" creationId="{00000000-0000-0000-0000-000000000000}"/>
          </ac:spMkLst>
        </pc:spChg>
        <pc:graphicFrameChg chg="mod modGraphic">
          <ac:chgData name="Lincoln Pasquina" userId="9a36d1e4-706f-4785-b8b1-88ca851b6fd6" providerId="ADAL" clId="{9861CB29-4046-41D1-B037-DCA4825F3146}" dt="2024-04-11T19:30:15.460" v="204" actId="20577"/>
          <ac:graphicFrameMkLst>
            <pc:docMk/>
            <pc:sldMk cId="0" sldId="283"/>
            <ac:graphicFrameMk id="849" creationId="{00000000-0000-0000-0000-000000000000}"/>
          </ac:graphicFrameMkLst>
        </pc:graphicFrameChg>
      </pc:sldChg>
      <pc:sldChg chg="modSp mod">
        <pc:chgData name="Lincoln Pasquina" userId="9a36d1e4-706f-4785-b8b1-88ca851b6fd6" providerId="ADAL" clId="{9861CB29-4046-41D1-B037-DCA4825F3146}" dt="2024-04-11T19:30:41.053" v="212" actId="20577"/>
        <pc:sldMkLst>
          <pc:docMk/>
          <pc:sldMk cId="0" sldId="284"/>
        </pc:sldMkLst>
        <pc:spChg chg="mod">
          <ac:chgData name="Lincoln Pasquina" userId="9a36d1e4-706f-4785-b8b1-88ca851b6fd6" providerId="ADAL" clId="{9861CB29-4046-41D1-B037-DCA4825F3146}" dt="2024-04-11T19:30:41.053" v="212" actId="20577"/>
          <ac:spMkLst>
            <pc:docMk/>
            <pc:sldMk cId="0" sldId="284"/>
            <ac:spMk id="863" creationId="{00000000-0000-0000-0000-000000000000}"/>
          </ac:spMkLst>
        </pc:spChg>
      </pc:sldChg>
    </pc:docChg>
  </pc:docChgLst>
  <pc:docChgLst>
    <pc:chgData name="Julia Quintanilha" userId="c2bb46bc-320b-4d68-ae76-3d1e186a62f2" providerId="ADAL" clId="{207C328A-9CFD-A84E-8E54-BFA755AC32C3}"/>
    <pc:docChg chg="modSld">
      <pc:chgData name="Julia Quintanilha" userId="c2bb46bc-320b-4d68-ae76-3d1e186a62f2" providerId="ADAL" clId="{207C328A-9CFD-A84E-8E54-BFA755AC32C3}" dt="2024-04-16T12:42:36.164" v="20" actId="20577"/>
      <pc:docMkLst>
        <pc:docMk/>
      </pc:docMkLst>
      <pc:sldChg chg="modSp mod">
        <pc:chgData name="Julia Quintanilha" userId="c2bb46bc-320b-4d68-ae76-3d1e186a62f2" providerId="ADAL" clId="{207C328A-9CFD-A84E-8E54-BFA755AC32C3}" dt="2024-04-11T19:25:13.011" v="18" actId="20577"/>
        <pc:sldMkLst>
          <pc:docMk/>
          <pc:sldMk cId="0" sldId="273"/>
        </pc:sldMkLst>
        <pc:spChg chg="mod">
          <ac:chgData name="Julia Quintanilha" userId="c2bb46bc-320b-4d68-ae76-3d1e186a62f2" providerId="ADAL" clId="{207C328A-9CFD-A84E-8E54-BFA755AC32C3}" dt="2024-04-11T19:24:56.132" v="8" actId="20577"/>
          <ac:spMkLst>
            <pc:docMk/>
            <pc:sldMk cId="0" sldId="273"/>
            <ac:spMk id="724" creationId="{00000000-0000-0000-0000-000000000000}"/>
          </ac:spMkLst>
        </pc:spChg>
        <pc:spChg chg="mod">
          <ac:chgData name="Julia Quintanilha" userId="c2bb46bc-320b-4d68-ae76-3d1e186a62f2" providerId="ADAL" clId="{207C328A-9CFD-A84E-8E54-BFA755AC32C3}" dt="2024-04-11T19:25:13.011" v="18" actId="20577"/>
          <ac:spMkLst>
            <pc:docMk/>
            <pc:sldMk cId="0" sldId="273"/>
            <ac:spMk id="726" creationId="{00000000-0000-0000-0000-000000000000}"/>
          </ac:spMkLst>
        </pc:spChg>
      </pc:sldChg>
      <pc:sldChg chg="modSp mod">
        <pc:chgData name="Julia Quintanilha" userId="c2bb46bc-320b-4d68-ae76-3d1e186a62f2" providerId="ADAL" clId="{207C328A-9CFD-A84E-8E54-BFA755AC32C3}" dt="2024-04-16T12:42:36.164" v="20" actId="20577"/>
        <pc:sldMkLst>
          <pc:docMk/>
          <pc:sldMk cId="3640774013" sldId="279"/>
        </pc:sldMkLst>
        <pc:spChg chg="mod">
          <ac:chgData name="Julia Quintanilha" userId="c2bb46bc-320b-4d68-ae76-3d1e186a62f2" providerId="ADAL" clId="{207C328A-9CFD-A84E-8E54-BFA755AC32C3}" dt="2024-04-16T12:42:36.164" v="20" actId="20577"/>
          <ac:spMkLst>
            <pc:docMk/>
            <pc:sldMk cId="3640774013" sldId="279"/>
            <ac:spMk id="4" creationId="{5E49E098-7298-DD90-B553-49D3481A3B6E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3037840" cy="4664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t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970938" y="0"/>
            <a:ext cx="3037840" cy="4664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t" anchorCtr="0">
            <a:noAutofit/>
          </a:bodyPr>
          <a:lstStyle>
            <a:lvl1pPr marR="0" lvl="0" algn="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717550" y="1162050"/>
            <a:ext cx="5575300" cy="31369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t" anchorCtr="0">
            <a:noAutofit/>
          </a:bodyPr>
          <a:lstStyle>
            <a:lvl1pPr marL="457200" marR="0" lvl="0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829967"/>
            <a:ext cx="3037840" cy="4664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b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b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70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2" name="Google Shape;702;p7:notes"/>
          <p:cNvSpPr txBox="1">
            <a:spLocks noGrp="1"/>
          </p:cNvSpPr>
          <p:nvPr>
            <p:ph type="body" idx="1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703" name="Google Shape;703;p7:notes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5" name="Google Shape;845;p16:notes"/>
          <p:cNvSpPr txBox="1">
            <a:spLocks noGrp="1"/>
          </p:cNvSpPr>
          <p:nvPr>
            <p:ph type="body" idx="1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46" name="Google Shape;846;p16:notes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5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3" name="Google Shape;853;p17:notes"/>
          <p:cNvSpPr txBox="1">
            <a:spLocks noGrp="1"/>
          </p:cNvSpPr>
          <p:nvPr>
            <p:ph type="body" idx="1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54" name="Google Shape;854;p17:notes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70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9" name="Google Shape;709;p8:notes"/>
          <p:cNvSpPr txBox="1">
            <a:spLocks noGrp="1"/>
          </p:cNvSpPr>
          <p:nvPr>
            <p:ph type="body" idx="1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710" name="Google Shape;710;p8:notes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7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0" name="Google Shape;750;p9:notes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751" name="Google Shape;751;p9:notes"/>
          <p:cNvSpPr txBox="1">
            <a:spLocks noGrp="1"/>
          </p:cNvSpPr>
          <p:nvPr>
            <p:ph type="body" idx="1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7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9" name="Google Shape;769;p10:notes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770" name="Google Shape;770;p10:notes"/>
          <p:cNvSpPr txBox="1">
            <a:spLocks noGrp="1"/>
          </p:cNvSpPr>
          <p:nvPr>
            <p:ph type="body" idx="1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7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4" name="Google Shape;784;p11:notes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785" name="Google Shape;785;p11:notes"/>
          <p:cNvSpPr txBox="1">
            <a:spLocks noGrp="1"/>
          </p:cNvSpPr>
          <p:nvPr>
            <p:ph type="body" idx="1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79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9" name="Google Shape;799;p12:notes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800" name="Google Shape;800;p12:notes"/>
          <p:cNvSpPr txBox="1">
            <a:spLocks noGrp="1"/>
          </p:cNvSpPr>
          <p:nvPr>
            <p:ph type="body" idx="1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0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0" name="Google Shape;810;p13:notes"/>
          <p:cNvSpPr txBox="1">
            <a:spLocks noGrp="1"/>
          </p:cNvSpPr>
          <p:nvPr>
            <p:ph type="body" idx="1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11" name="Google Shape;811;p13:notes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6" name="Google Shape;826;p14:notes"/>
          <p:cNvSpPr txBox="1">
            <a:spLocks noGrp="1"/>
          </p:cNvSpPr>
          <p:nvPr>
            <p:ph type="body" idx="1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27" name="Google Shape;827;p14:notes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7" name="Google Shape;837;p15:notes"/>
          <p:cNvSpPr txBox="1">
            <a:spLocks noGrp="1"/>
          </p:cNvSpPr>
          <p:nvPr>
            <p:ph type="body" idx="1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38" name="Google Shape;838;p15:notes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91A270-05BE-D5F8-1684-DC700B3B7A3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011AD47-9A66-FA37-C218-857968D3F8A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4D84D7-3945-DFB7-55E3-0B2E57F80E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0E6B96-E51E-6A84-9320-9862B9A2F3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B4D958-3EE0-EF2A-BD88-46DE775A3F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8EB92-CD55-2847-B7D4-31AED43CB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7461406"/>
      </p:ext>
    </p:extLst>
  </p:cSld>
  <p:clrMapOvr>
    <a:masterClrMapping/>
  </p:clrMapOvr>
  <p:hf sldNum="0" hdr="0" ftr="0" dt="0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5166CC-A7A8-64F5-D3BD-D9DD6B1D5C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533AB33-F069-7EBD-4D14-CB6C96431FA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AAC64E-1843-9929-F0D8-D2B2A012B8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D087B6-592C-021F-DFE2-2026AAE202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148CFB-DE22-52BD-1B86-CCA165CFF6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8EB92-CD55-2847-B7D4-31AED43CB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968474"/>
      </p:ext>
    </p:extLst>
  </p:cSld>
  <p:clrMapOvr>
    <a:masterClrMapping/>
  </p:clrMapOvr>
  <p:hf sldNum="0" hdr="0" ftr="0" dt="0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876C085-87F4-76C1-688B-E32F98DD759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6E7A804-BA53-B832-5BB7-3EF7C676A4E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A92A0F-D04B-B8E3-7343-3F4161D818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7D590C-CE15-20DE-9AD0-112F0DE7C5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F78AF4-073B-C145-C0F4-561BDFBC72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8EB92-CD55-2847-B7D4-31AED43CB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1000608"/>
      </p:ext>
    </p:extLst>
  </p:cSld>
  <p:clrMapOvr>
    <a:masterClrMapping/>
  </p:clrMapOvr>
  <p:hf sldNum="0" hdr="0" ftr="0" dt="0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60D109-787D-414C-DC2E-09E78C0829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B238105-BEF7-7B5F-6200-22E394710CE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BA6522-1BF0-7FCC-0A38-16120DA663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0BA5B1A-0F5E-7AE1-41DE-C086F5E55A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865492-70B1-28DB-CEC9-73D1C97F68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8EB92-CD55-2847-B7D4-31AED43CB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8246050"/>
      </p:ext>
    </p:extLst>
  </p:cSld>
  <p:clrMapOvr>
    <a:masterClrMapping/>
  </p:clrMapOvr>
  <p:hf sldNum="0" hdr="0" ftr="0" dt="0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1B16B1-E24A-A76B-9EDC-3F44BAE931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FB71E0E-614B-1F26-02AE-9684CD7BB5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EE848E-3D02-0B3F-FC96-39FD073CB6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A60378-6428-49FE-B8D1-ACE8C422D6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DF06B7-3A37-8CBF-720A-D51F91E6BE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8EB92-CD55-2847-B7D4-31AED43CB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7538159"/>
      </p:ext>
    </p:extLst>
  </p:cSld>
  <p:clrMapOvr>
    <a:masterClrMapping/>
  </p:clrMapOvr>
  <p:hf sldNum="0" hdr="0" ftr="0" dt="0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7CFE0F-CA52-0BA4-D96D-F09ADDEFCE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25846C9-32BE-79EB-8283-AA3A86F2620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7542DDF-B695-C016-DC66-D9C1355490F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F346F6E-EF2C-2E0F-E588-35ED01EBE0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3BD1B37-8586-0B86-95D3-B6212F50EC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9E566B4-6010-3746-6A88-A756B1A12E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8EB92-CD55-2847-B7D4-31AED43CB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1255435"/>
      </p:ext>
    </p:extLst>
  </p:cSld>
  <p:clrMapOvr>
    <a:masterClrMapping/>
  </p:clrMapOvr>
  <p:hf sldNum="0" hdr="0" ftr="0" dt="0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B23CD8-8F7D-3C03-3E4D-86B573CE3D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8A31C96-733B-C197-1199-049D8067D1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978EE0C-3C79-BE9A-84F0-1A2743F4B48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20C5E8C-1200-5343-2284-7A8C1FD7EA2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28E66DE-1254-4E6C-3010-C41EF5A74CC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02D0C7F-5858-8200-393F-A678B7821E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F8F9E86-28A3-66A7-3422-6C2B4E30E7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920EBB5-0177-B3B3-2D7D-12169A34FF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8EB92-CD55-2847-B7D4-31AED43CB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5252240"/>
      </p:ext>
    </p:extLst>
  </p:cSld>
  <p:clrMapOvr>
    <a:masterClrMapping/>
  </p:clrMapOvr>
  <p:hf sldNum="0" hdr="0" ftr="0" dt="0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942126-2744-4EBA-5EAA-41364E9ED4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9409DCB-23F4-D3BF-0D71-F3C96B6BFC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EA864-0D67-3044-A40A-EF1F1BB4BAE0}" type="datetimeFigureOut">
              <a:rPr lang="en-US" smtClean="0"/>
              <a:t>4/16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16E33F2-EEC2-2C5D-50B8-3B2644820D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1DEA14D-119D-4B2D-3F7E-4723EF9A49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8EB92-CD55-2847-B7D4-31AED43CB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5847083"/>
      </p:ext>
    </p:extLst>
  </p:cSld>
  <p:clrMapOvr>
    <a:masterClrMapping/>
  </p:clrMapOvr>
  <p:transition spd="med">
    <p:fade/>
  </p:transition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51D3BD6-7388-05E7-4493-71B1182A53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EA864-0D67-3044-A40A-EF1F1BB4BAE0}" type="datetimeFigureOut">
              <a:rPr lang="en-US" smtClean="0"/>
              <a:t>4/16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A5FE296-6A83-975C-0A63-F248D8827C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351ABB7-1688-BA56-DB98-EF12B3AA6A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8EB92-CD55-2847-B7D4-31AED43CB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5119474"/>
      </p:ext>
    </p:extLst>
  </p:cSld>
  <p:clrMapOvr>
    <a:masterClrMapping/>
  </p:clrMapOvr>
  <p:transition spd="med">
    <p:fade/>
  </p:transition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15155C-227C-7F48-767E-92FE08D905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111248D-5AAC-65FE-E219-92AB329ABD0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54EDFE5-9745-43AE-EA26-5E83DDDFB01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05BB5A1-D864-C760-5393-6F77FD56C0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1BD3022-5484-793A-E661-C4280449F8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451A4A-5381-DE0E-E991-0DDE39112C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8EB92-CD55-2847-B7D4-31AED43CB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9388199"/>
      </p:ext>
    </p:extLst>
  </p:cSld>
  <p:clrMapOvr>
    <a:masterClrMapping/>
  </p:clrMapOvr>
  <p:hf sldNum="0" hdr="0" ftr="0" dt="0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98EF76-46CE-48B9-704A-DB022AC404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90557AB-D62B-D78F-DDE4-72451D47260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0708D77-7FCC-BE35-932A-D7DD31AFD94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995D005-582E-530C-5A4F-CC9F8E3D9E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A4A7342-0EF1-DF73-4F8D-0FE8C4C6B2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43F719A-5489-FFC1-459E-9FF4054A9F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8EB92-CD55-2847-B7D4-31AED43CB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9360011"/>
      </p:ext>
    </p:extLst>
  </p:cSld>
  <p:clrMapOvr>
    <a:masterClrMapping/>
  </p:clrMapOvr>
  <p:hf sldNum="0" hdr="0" ftr="0" dt="0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8C420DD-0D23-99F9-3326-4A3E7A9A0A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284FE2F-F6CB-FFC6-ED95-0E95BF2903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E379E6-083D-759B-C334-22F6564BF01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6F4247-872A-0DF3-C8A7-01C39175345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D6893B-DFD4-54B1-83E0-210C88525AB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118EB92-CD55-2847-B7D4-31AED43CB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42124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2" r:id="rId1"/>
    <p:sldLayoutId id="2147483693" r:id="rId2"/>
    <p:sldLayoutId id="2147483694" r:id="rId3"/>
    <p:sldLayoutId id="2147483695" r:id="rId4"/>
    <p:sldLayoutId id="2147483696" r:id="rId5"/>
    <p:sldLayoutId id="2147483697" r:id="rId6"/>
    <p:sldLayoutId id="2147483698" r:id="rId7"/>
    <p:sldLayoutId id="2147483699" r:id="rId8"/>
    <p:sldLayoutId id="2147483700" r:id="rId9"/>
    <p:sldLayoutId id="2147483701" r:id="rId10"/>
    <p:sldLayoutId id="2147483702" r:id="rId11"/>
  </p:sldLayoutIdLst>
  <p:hf sldNum="0"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/>
    </p:ext>
  </p:extLst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9.png"/><Relationship Id="rId4" Type="http://schemas.openxmlformats.org/officeDocument/2006/relationships/image" Target="../media/image28.png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5.png"/><Relationship Id="rId3" Type="http://schemas.openxmlformats.org/officeDocument/2006/relationships/image" Target="../media/image30.png"/><Relationship Id="rId7" Type="http://schemas.openxmlformats.org/officeDocument/2006/relationships/image" Target="../media/image34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3.png"/><Relationship Id="rId5" Type="http://schemas.openxmlformats.org/officeDocument/2006/relationships/image" Target="../media/image32.png"/><Relationship Id="rId4" Type="http://schemas.openxmlformats.org/officeDocument/2006/relationships/image" Target="../media/image31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3" Type="http://schemas.openxmlformats.org/officeDocument/2006/relationships/image" Target="../media/image4.png"/><Relationship Id="rId7" Type="http://schemas.openxmlformats.org/officeDocument/2006/relationships/image" Target="../media/image9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3" Type="http://schemas.openxmlformats.org/officeDocument/2006/relationships/image" Target="../media/image11.png"/><Relationship Id="rId7" Type="http://schemas.openxmlformats.org/officeDocument/2006/relationships/image" Target="../media/image13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png"/><Relationship Id="rId5" Type="http://schemas.openxmlformats.org/officeDocument/2006/relationships/image" Target="../media/image15.png"/><Relationship Id="rId4" Type="http://schemas.openxmlformats.org/officeDocument/2006/relationships/image" Target="../media/image5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7" Type="http://schemas.openxmlformats.org/officeDocument/2006/relationships/image" Target="../media/image21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png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6.png"/><Relationship Id="rId4" Type="http://schemas.openxmlformats.org/officeDocument/2006/relationships/image" Target="../media/image2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70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5" name="Google Shape;705;p7"/>
          <p:cNvSpPr txBox="1">
            <a:spLocks noGrp="1"/>
          </p:cNvSpPr>
          <p:nvPr>
            <p:ph type="title"/>
          </p:nvPr>
        </p:nvSpPr>
        <p:spPr>
          <a:xfrm>
            <a:off x="547477" y="5670937"/>
            <a:ext cx="10962290" cy="5122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b" anchorCtr="0">
            <a:normAutofit fontScale="90000"/>
          </a:bodyPr>
          <a:lstStyle/>
          <a:p>
            <a:pPr marL="0" lvl="0" indent="0" algn="l" rtl="0">
              <a:lnSpc>
                <a:spcPct val="83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rial"/>
              <a:buNone/>
            </a:pPr>
            <a:r>
              <a:rPr lang="en-US"/>
              <a:t>SUPPLEMENTARY FIGURES AND TABLES</a:t>
            </a:r>
            <a:endParaRPr/>
          </a:p>
        </p:txBody>
      </p:sp>
      <p:sp>
        <p:nvSpPr>
          <p:cNvPr id="706" name="Google Shape;706;p7"/>
          <p:cNvSpPr/>
          <p:nvPr/>
        </p:nvSpPr>
        <p:spPr>
          <a:xfrm>
            <a:off x="562234" y="6106923"/>
            <a:ext cx="2402007" cy="667503"/>
          </a:xfrm>
          <a:prstGeom prst="rect">
            <a:avLst/>
          </a:prstGeom>
          <a:solidFill>
            <a:schemeClr val="lt1"/>
          </a:solidFill>
          <a:ln w="1270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2000">
              <a:solidFill>
                <a:schemeClr val="lt2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707" name="Google Shape;707;p7"/>
          <p:cNvSpPr/>
          <p:nvPr/>
        </p:nvSpPr>
        <p:spPr>
          <a:xfrm>
            <a:off x="9789993" y="6183193"/>
            <a:ext cx="2402007" cy="667503"/>
          </a:xfrm>
          <a:prstGeom prst="rect">
            <a:avLst/>
          </a:prstGeom>
          <a:solidFill>
            <a:schemeClr val="lt1"/>
          </a:solidFill>
          <a:ln w="1270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2000">
              <a:solidFill>
                <a:schemeClr val="lt2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9" name="Google Shape;829;p14"/>
          <p:cNvSpPr txBox="1"/>
          <p:nvPr/>
        </p:nvSpPr>
        <p:spPr>
          <a:xfrm>
            <a:off x="1327793" y="1767464"/>
            <a:ext cx="3059203" cy="4308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A) PI3K pathway alterations 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o-occurrence in 1</a:t>
            </a:r>
            <a:r>
              <a:rPr lang="en-US" sz="1100" b="1" baseline="300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t</a:t>
            </a:r>
            <a:r>
              <a:rPr lang="en-US" sz="11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line (n=2,154)</a:t>
            </a:r>
            <a:endParaRPr/>
          </a:p>
        </p:txBody>
      </p:sp>
      <p:sp>
        <p:nvSpPr>
          <p:cNvPr id="830" name="Google Shape;830;p14"/>
          <p:cNvSpPr txBox="1"/>
          <p:nvPr/>
        </p:nvSpPr>
        <p:spPr>
          <a:xfrm>
            <a:off x="4689462" y="1786870"/>
            <a:ext cx="3059203" cy="4308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B) PI3K pathway alterations 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o-occurrence in 2</a:t>
            </a:r>
            <a:r>
              <a:rPr lang="en-US" sz="1100" b="1" baseline="300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nd</a:t>
            </a:r>
            <a:r>
              <a:rPr lang="en-US" sz="11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line (n=269)</a:t>
            </a:r>
            <a:endParaRPr/>
          </a:p>
        </p:txBody>
      </p:sp>
      <p:sp>
        <p:nvSpPr>
          <p:cNvPr id="831" name="Google Shape;831;p14"/>
          <p:cNvSpPr txBox="1"/>
          <p:nvPr/>
        </p:nvSpPr>
        <p:spPr>
          <a:xfrm>
            <a:off x="8093912" y="1762036"/>
            <a:ext cx="3059203" cy="4308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C) PI3K pathway alterations 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o-occurrence in 3</a:t>
            </a:r>
            <a:r>
              <a:rPr lang="en-US" sz="1100" b="1" baseline="300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rd</a:t>
            </a:r>
            <a:r>
              <a:rPr lang="en-US" sz="11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line (n=216)</a:t>
            </a:r>
            <a:endParaRPr/>
          </a:p>
        </p:txBody>
      </p:sp>
      <p:sp>
        <p:nvSpPr>
          <p:cNvPr id="832" name="Google Shape;832;p14"/>
          <p:cNvSpPr txBox="1"/>
          <p:nvPr/>
        </p:nvSpPr>
        <p:spPr>
          <a:xfrm>
            <a:off x="1034980" y="4787045"/>
            <a:ext cx="4638233" cy="93867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b="1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SUPPLEMENTARY FIGURE S9. Co-occurrence of PI3K pathway alterations detected in tissue specimens of HR(+)HER2(-) </a:t>
            </a:r>
            <a:r>
              <a:rPr lang="en-US" sz="1100" b="1" dirty="0" err="1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mBC</a:t>
            </a:r>
            <a:r>
              <a:rPr lang="en-US" sz="1100" b="1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 in the first three metastatic lines of therapy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  <a:sym typeface="Montserrat"/>
              </a:rPr>
              <a:t>L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oss: copy loss; mut: mutation; PI3K alterations include </a:t>
            </a:r>
            <a:r>
              <a:rPr lang="en-US" sz="1100" i="1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AKT1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mut, </a:t>
            </a:r>
            <a:r>
              <a:rPr lang="en-US" sz="1100" i="1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PIK3CA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mut, </a:t>
            </a:r>
            <a:r>
              <a:rPr lang="en-US" sz="1100" i="1" dirty="0" err="1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PTEN</a:t>
            </a:r>
            <a:r>
              <a:rPr lang="en-US" sz="1100" dirty="0" err="1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mut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 and </a:t>
            </a:r>
            <a:r>
              <a:rPr lang="en-US" sz="1100" i="1" dirty="0" err="1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PTEN</a:t>
            </a:r>
            <a:r>
              <a:rPr lang="en-US" sz="1100" dirty="0" err="1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loss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.</a:t>
            </a:r>
            <a:endParaRPr sz="1100" dirty="0">
              <a:solidFill>
                <a:schemeClr val="dk1"/>
              </a:solidFill>
              <a:latin typeface="Arial" panose="020B0604020202020204" pitchFamily="34" charset="0"/>
              <a:ea typeface="Arial"/>
              <a:cs typeface="Arial" panose="020B0604020202020204" pitchFamily="34" charset="0"/>
              <a:sym typeface="Arial"/>
            </a:endParaRPr>
          </a:p>
        </p:txBody>
      </p:sp>
      <p:pic>
        <p:nvPicPr>
          <p:cNvPr id="833" name="Google Shape;833;p14" descr="A diagram of a heart&#10;&#10;Description automatically generated"/>
          <p:cNvPicPr preferRelativeResize="0"/>
          <p:nvPr/>
        </p:nvPicPr>
        <p:blipFill rotWithShape="1">
          <a:blip r:embed="rId3">
            <a:alphaModFix/>
          </a:blip>
          <a:srcRect l="4987" t="18193" b="7131"/>
          <a:stretch/>
        </p:blipFill>
        <p:spPr>
          <a:xfrm>
            <a:off x="1251225" y="2289291"/>
            <a:ext cx="2850200" cy="2240101"/>
          </a:xfrm>
          <a:prstGeom prst="rect">
            <a:avLst/>
          </a:prstGeom>
          <a:noFill/>
          <a:ln>
            <a:noFill/>
          </a:ln>
        </p:spPr>
      </p:pic>
      <p:pic>
        <p:nvPicPr>
          <p:cNvPr id="834" name="Google Shape;834;p14" descr="A diagram of a heart&#10;&#10;Description automatically generated"/>
          <p:cNvPicPr preferRelativeResize="0"/>
          <p:nvPr/>
        </p:nvPicPr>
        <p:blipFill rotWithShape="1">
          <a:blip r:embed="rId4">
            <a:alphaModFix/>
          </a:blip>
          <a:srcRect l="5452" t="17459" b="7090"/>
          <a:stretch/>
        </p:blipFill>
        <p:spPr>
          <a:xfrm>
            <a:off x="4493322" y="2272095"/>
            <a:ext cx="2850201" cy="2274491"/>
          </a:xfrm>
          <a:prstGeom prst="rect">
            <a:avLst/>
          </a:prstGeom>
          <a:noFill/>
          <a:ln>
            <a:noFill/>
          </a:ln>
        </p:spPr>
      </p:pic>
      <p:pic>
        <p:nvPicPr>
          <p:cNvPr id="835" name="Google Shape;835;p14" descr="A diagram of a heart&#10;&#10;Description automatically generated"/>
          <p:cNvPicPr preferRelativeResize="0"/>
          <p:nvPr/>
        </p:nvPicPr>
        <p:blipFill rotWithShape="1">
          <a:blip r:embed="rId5">
            <a:alphaModFix/>
          </a:blip>
          <a:srcRect l="5452" t="18193" b="6511"/>
          <a:stretch/>
        </p:blipFill>
        <p:spPr>
          <a:xfrm>
            <a:off x="7961290" y="2272095"/>
            <a:ext cx="2856069" cy="2274491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3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0" name="Google Shape;840;p15"/>
          <p:cNvSpPr/>
          <p:nvPr/>
        </p:nvSpPr>
        <p:spPr>
          <a:xfrm>
            <a:off x="9661989" y="6106923"/>
            <a:ext cx="2402007" cy="667503"/>
          </a:xfrm>
          <a:prstGeom prst="rect">
            <a:avLst/>
          </a:prstGeom>
          <a:solidFill>
            <a:schemeClr val="lt1"/>
          </a:solidFill>
          <a:ln w="1270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2000">
              <a:solidFill>
                <a:schemeClr val="lt2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aphicFrame>
        <p:nvGraphicFramePr>
          <p:cNvPr id="841" name="Google Shape;841;p15"/>
          <p:cNvGraphicFramePr/>
          <p:nvPr>
            <p:extLst>
              <p:ext uri="{D42A27DB-BD31-4B8C-83A1-F6EECF244321}">
                <p14:modId xmlns:p14="http://schemas.microsoft.com/office/powerpoint/2010/main" val="2821086011"/>
              </p:ext>
            </p:extLst>
          </p:nvPr>
        </p:nvGraphicFramePr>
        <p:xfrm>
          <a:off x="4031311" y="212320"/>
          <a:ext cx="7588000" cy="6455664"/>
        </p:xfrm>
        <a:graphic>
          <a:graphicData uri="http://schemas.openxmlformats.org/drawingml/2006/table">
            <a:tbl>
              <a:tblPr firstRow="1" bandRow="1">
                <a:noFill/>
                <a:tableStyleId>{633E41C2-94C5-44B2-B323-6E28DEAA064A}</a:tableStyleId>
              </a:tblPr>
              <a:tblGrid>
                <a:gridCol w="299465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56922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47217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55195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24175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100"/>
                        <a:buFont typeface="Arial"/>
                        <a:buNone/>
                      </a:pPr>
                      <a:endParaRPr sz="1100" b="1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lt1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1" i="1" u="none" strike="noStrike" cap="none" dirty="0">
                          <a:solidFill>
                            <a:schemeClr val="lt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SR1</a:t>
                      </a:r>
                      <a:r>
                        <a:rPr lang="en-US" sz="1100" b="1" u="none" strike="noStrike" cap="none" dirty="0">
                          <a:solidFill>
                            <a:schemeClr val="lt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 </a:t>
                      </a:r>
                      <a:endParaRPr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lt1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1" u="none" strike="noStrike" cap="none" dirty="0">
                          <a:solidFill>
                            <a:schemeClr val="lt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551)</a:t>
                      </a:r>
                      <a:endParaRPr sz="1100" b="1" i="0" u="none" strike="noStrike" cap="none" dirty="0">
                        <a:solidFill>
                          <a:schemeClr val="lt1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lt1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1" i="1" u="none" strike="noStrike" cap="none">
                          <a:solidFill>
                            <a:schemeClr val="lt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SR1</a:t>
                      </a:r>
                      <a:r>
                        <a:rPr lang="en-US" sz="1100" b="1" u="none" strike="noStrike" cap="none">
                          <a:solidFill>
                            <a:schemeClr val="lt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t 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lt1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1" u="none" strike="noStrike" cap="none">
                          <a:solidFill>
                            <a:schemeClr val="lt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22)</a:t>
                      </a:r>
                      <a:endParaRPr sz="1100" b="1" i="0" u="none" strike="noStrike" cap="none">
                        <a:solidFill>
                          <a:schemeClr val="lt1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lt1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1" i="0" u="none" strike="noStrike" cap="none">
                          <a:solidFill>
                            <a:schemeClr val="lt1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P-value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5" marR="6075" marT="9144" marB="9144" anchor="b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7015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1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 at Tx Start</a:t>
                      </a:r>
                      <a:endParaRPr sz="1100" b="1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0.465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7015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 Median (Q1, Q3)</a:t>
                      </a:r>
                      <a:endParaRPr sz="11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63.0 (54.0, 70.0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 gridSpan="2"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    61.0 (58.2, 74.2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7015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1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Gender</a:t>
                      </a:r>
                      <a:endParaRPr sz="1100" b="1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0.595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72825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  Female</a:t>
                      </a: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544 (98.7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22 (100.0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72825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  Male</a:t>
                      </a: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7 (1.3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0 (0.0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70150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1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Areal socioeconomic status (quintile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0.449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7015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  1 - Lowest SES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86 (17.0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  <a:extLst>
                            <a:ext uri="http://customooxmlschemas.google.com/">
                        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xmlns:lc="http://schemas.openxmlformats.org/drawingml/2006/lockedCanvas" textRoundtripDataId="0"/>
                            </a:ext>
                          </a:extLst>
                        </a:rPr>
                        <a:t>≤</a:t>
                      </a:r>
                      <a:r>
                        <a:rPr lang="en-US" sz="11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  <a:extLst>
                            <a:ext uri="http://customooxmlschemas.google.com/">
                              <go:slidesCustomData xmlns:lc="http://schemas.openxmlformats.org/drawingml/2006/lockedCanvas"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textRoundtripDataId="0"/>
                            </a:ext>
                          </a:extLst>
                        </a:rPr>
                        <a:t>5</a:t>
                      </a:r>
                      <a:endParaRPr lang="en-US" sz="11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  <a:sym typeface="Arial"/>
                        <a:extLst>
                          <a:ext uri="http://customooxmlschemas.google.com/">
                            <go:slidesCustomData xmlns:lc="http://schemas.openxmlformats.org/drawingml/2006/lockedCanvas"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textRoundtripDataId="0"/>
                          </a:ext>
                        </a:extLst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7015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  2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91 (17.9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  <a:extLst>
                            <a:ext uri="http://customooxmlschemas.google.com/">
                        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textRoundtripDataId="0"/>
                            </a:ext>
                          </a:extLst>
                        </a:rPr>
                        <a:t>≤</a:t>
                      </a:r>
                      <a:r>
                        <a:rPr lang="en-US" sz="11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  <a:extLst>
                            <a:ext uri="http://customooxmlschemas.google.com/">
                        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textRoundtripDataId="0"/>
                            </a:ext>
                          </a:extLst>
                        </a:rPr>
                        <a:t>5</a:t>
                      </a:r>
                      <a:endParaRPr sz="11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  <a:sym typeface="Arial"/>
                        <a:extLst>
                          <a:ext uri="http://customooxmlschemas.google.com/">
                      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textRoundtripDataId="0"/>
                          </a:ext>
                        </a:extLst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7015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  3</a:t>
                      </a:r>
                      <a:endParaRPr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103 (20.3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  <a:extLst>
                            <a:ext uri="http://customooxmlschemas.google.com/">
                        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xmlns:lc="http://schemas.openxmlformats.org/drawingml/2006/lockedCanvas" textRoundtripDataId="0"/>
                            </a:ext>
                          </a:extLst>
                        </a:rPr>
                        <a:t>≤</a:t>
                      </a:r>
                      <a:r>
                        <a:rPr lang="en-US" sz="11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  <a:extLst>
                            <a:ext uri="http://customooxmlschemas.google.com/">
                              <go:slidesCustomData xmlns:lc="http://schemas.openxmlformats.org/drawingml/2006/lockedCanvas"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textRoundtripDataId="0"/>
                            </a:ext>
                          </a:extLst>
                        </a:rPr>
                        <a:t>5</a:t>
                      </a:r>
                      <a:endParaRPr lang="en-US" sz="11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  <a:sym typeface="Arial"/>
                        <a:extLst>
                          <a:ext uri="http://customooxmlschemas.google.com/">
                            <go:slidesCustomData xmlns:lc="http://schemas.openxmlformats.org/drawingml/2006/lockedCanvas"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textRoundtripDataId="0"/>
                          </a:ext>
                        </a:extLst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7015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  4</a:t>
                      </a:r>
                      <a:endParaRPr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110 (21.7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8 (38.1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7015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  5 - Highest SES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117 (23.1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  <a:extLst>
                            <a:ext uri="http://customooxmlschemas.google.com/">
                              <go:slidesCustomData xmlns:lc="http://schemas.openxmlformats.org/drawingml/2006/lockedCanvas"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textRoundtripDataId="0"/>
                            </a:ext>
                          </a:extLst>
                        </a:rPr>
                        <a:t>≤</a:t>
                      </a:r>
                      <a:r>
                        <a:rPr lang="en-US" sz="11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  <a:extLst>
                            <a:ext uri="http://customooxmlschemas.google.com/">
                              <go:slidesCustomData xmlns:lc="http://schemas.openxmlformats.org/drawingml/2006/lockedCanvas"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textRoundtripDataId="0"/>
                            </a:ext>
                          </a:extLst>
                        </a:rPr>
                        <a:t>5</a:t>
                      </a:r>
                      <a:endParaRPr lang="en-US" sz="11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  <a:sym typeface="Arial"/>
                        <a:extLst>
                          <a:ext uri="http://customooxmlschemas.google.com/">
                            <go:slidesCustomData xmlns:lc="http://schemas.openxmlformats.org/drawingml/2006/lockedCanvas"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textRoundtripDataId="0"/>
                          </a:ext>
                        </a:extLst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7015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  Missing</a:t>
                      </a:r>
                      <a:endParaRPr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44</a:t>
                      </a:r>
                      <a:endParaRPr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  <a:extLst>
                            <a:ext uri="http://customooxmlschemas.google.com/">
                        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textRoundtripDataId="4"/>
                            </a:ext>
                          </a:extLst>
                        </a:rPr>
                        <a:t>1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7015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1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ECOG PS</a:t>
                      </a:r>
                      <a:endParaRPr sz="1100" b="1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0.137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72825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  0</a:t>
                      </a: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234 (52.5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10 (52.6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72825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  1</a:t>
                      </a: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158 (35.4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  <a:extLst>
                            <a:ext uri="http://customooxmlschemas.google.com/">
                              <go:slidesCustomData xmlns:lc="http://schemas.openxmlformats.org/drawingml/2006/lockedCanvas"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textRoundtripDataId="0"/>
                            </a:ext>
                          </a:extLst>
                        </a:rPr>
                        <a:t>≤</a:t>
                      </a:r>
                      <a:r>
                        <a:rPr lang="en-US" sz="11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  <a:extLst>
                            <a:ext uri="http://customooxmlschemas.google.com/">
                              <go:slidesCustomData xmlns:lc="http://schemas.openxmlformats.org/drawingml/2006/lockedCanvas"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textRoundtripDataId="0"/>
                            </a:ext>
                          </a:extLst>
                        </a:rPr>
                        <a:t>5</a:t>
                      </a:r>
                      <a:endParaRPr lang="en-US" sz="11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  <a:sym typeface="Arial"/>
                        <a:extLst>
                          <a:ext uri="http://customooxmlschemas.google.com/">
                            <go:slidesCustomData xmlns:lc="http://schemas.openxmlformats.org/drawingml/2006/lockedCanvas"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textRoundtripDataId="0"/>
                          </a:ext>
                        </a:extLst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72825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  2 +</a:t>
                      </a: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54 (12.1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  <a:extLst>
                            <a:ext uri="http://customooxmlschemas.google.com/">
                              <go:slidesCustomData xmlns:lc="http://schemas.openxmlformats.org/drawingml/2006/lockedCanvas"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textRoundtripDataId="0"/>
                            </a:ext>
                          </a:extLst>
                        </a:rPr>
                        <a:t>≤</a:t>
                      </a:r>
                      <a:r>
                        <a:rPr lang="en-US" sz="11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  <a:extLst>
                            <a:ext uri="http://customooxmlschemas.google.com/">
                              <go:slidesCustomData xmlns:lc="http://schemas.openxmlformats.org/drawingml/2006/lockedCanvas"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textRoundtripDataId="0"/>
                            </a:ext>
                          </a:extLst>
                        </a:rPr>
                        <a:t>5</a:t>
                      </a:r>
                      <a:endParaRPr lang="en-US" sz="11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  <a:sym typeface="Arial"/>
                        <a:extLst>
                          <a:ext uri="http://customooxmlschemas.google.com/">
                            <go:slidesCustomData xmlns:lc="http://schemas.openxmlformats.org/drawingml/2006/lockedCanvas"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textRoundtripDataId="0"/>
                          </a:ext>
                        </a:extLst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72825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  Missing</a:t>
                      </a:r>
                      <a:endParaRPr sz="1100" b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105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3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7015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1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Adjuvant Tx</a:t>
                      </a:r>
                      <a:endParaRPr sz="1100" b="1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0.013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72825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 Adjuvant ET with AI</a:t>
                      </a: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95 (17.2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9 (40.9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72825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 Adjuvant ET with Tamoxifen</a:t>
                      </a: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32 (5.8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0 (0.0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72825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 No adjuvant ET / de novo met/ unknown</a:t>
                      </a:r>
                      <a:endParaRPr sz="1100" b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424 (77.0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13 (59.1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7282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1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Menopause status*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0.026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7282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 Postmenopausal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117 (21.2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10 (45.5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7282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 Premenopausal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89 (16.2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3 (13.6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17282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 Unknown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345 (62.6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9 (40.9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7282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1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Histology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0.82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17282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 Invasive ductal carcinoma (IDC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185 (33.6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8 (36.4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17282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 Invasive lobular carcinoma (ILC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45 (8.2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  <a:extLst>
                            <a:ext uri="http://customooxmlschemas.google.com/">
                              <go:slidesCustomData xmlns:lc="http://schemas.openxmlformats.org/drawingml/2006/lockedCanvas"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textRoundtripDataId="0"/>
                            </a:ext>
                          </a:extLst>
                        </a:rPr>
                        <a:t>≤</a:t>
                      </a:r>
                      <a:r>
                        <a:rPr lang="en-US" sz="11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  <a:extLst>
                            <a:ext uri="http://customooxmlschemas.google.com/">
                              <go:slidesCustomData xmlns:lc="http://schemas.openxmlformats.org/drawingml/2006/lockedCanvas"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textRoundtripDataId="0"/>
                            </a:ext>
                          </a:extLst>
                        </a:rPr>
                        <a:t>5</a:t>
                      </a:r>
                      <a:endParaRPr lang="en-US" sz="11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  <a:sym typeface="Arial"/>
                        <a:extLst>
                          <a:ext uri="http://customooxmlschemas.google.com/">
                            <go:slidesCustomData xmlns:lc="http://schemas.openxmlformats.org/drawingml/2006/lockedCanvas"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textRoundtripDataId="0"/>
                          </a:ext>
                        </a:extLst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17282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 Other/unknown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321 (58.3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13 (59.1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17282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1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astasis Site(s)</a:t>
                      </a:r>
                      <a:endParaRPr sz="1100" b="1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0.290</a:t>
                      </a:r>
                      <a:endParaRPr sz="1100" b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172825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Bone only</a:t>
                      </a:r>
                      <a:endParaRPr sz="11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190 (34.5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10 (45.5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100"/>
                        <a:buFont typeface="Arial"/>
                        <a:buNone/>
                      </a:pPr>
                      <a:endParaRPr sz="1100" b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172825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50"/>
                        <a:buFont typeface="Arial"/>
                        <a:buNone/>
                      </a:pPr>
                      <a:r>
                        <a:rPr lang="en-US" sz="1050" b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Visceral (CNS, liver, adrenal, other) with or without bone</a:t>
                      </a:r>
                      <a:endParaRPr sz="105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361 (65.5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12 (54.5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100"/>
                        <a:buFont typeface="Arial"/>
                        <a:buNone/>
                      </a:pPr>
                      <a:endParaRPr sz="1100" b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</a:tbl>
          </a:graphicData>
        </a:graphic>
      </p:graphicFrame>
      <p:sp>
        <p:nvSpPr>
          <p:cNvPr id="842" name="Google Shape;842;p15"/>
          <p:cNvSpPr txBox="1"/>
          <p:nvPr/>
        </p:nvSpPr>
        <p:spPr>
          <a:xfrm>
            <a:off x="187653" y="1189337"/>
            <a:ext cx="3710444" cy="167734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Montserrat"/>
              <a:buNone/>
            </a:pPr>
            <a:r>
              <a:rPr lang="en-US" sz="1100" b="1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SUPPLEMENTARY TABLE 1: Comparison of baseline characteristics of patients receiving 1</a:t>
            </a:r>
            <a:r>
              <a:rPr lang="en-US" sz="1100" b="1" baseline="300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st</a:t>
            </a:r>
            <a:r>
              <a:rPr lang="en-US" sz="1100" b="1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 line AI + CDK4/6i.</a:t>
            </a:r>
            <a:endParaRPr sz="1100" b="1" dirty="0">
              <a:solidFill>
                <a:schemeClr val="dk1"/>
              </a:solidFill>
              <a:latin typeface="Arial" panose="020B0604020202020204" pitchFamily="34" charset="0"/>
              <a:ea typeface="Montserrat"/>
              <a:cs typeface="Arial" panose="020B0604020202020204" pitchFamily="34" charset="0"/>
              <a:sym typeface="Montserrat"/>
            </a:endParaRPr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CDK4/6i: CDK 4/6 inhibitors; CNS: central nervous system; ECOG PS: Eastern Cooperative Oncology Group performance status; </a:t>
            </a:r>
            <a:r>
              <a:rPr lang="en-US" sz="1100" i="1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ESR1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mut: </a:t>
            </a:r>
            <a:r>
              <a:rPr lang="en-US" sz="1100" i="1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ESR1 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mutations; </a:t>
            </a:r>
            <a:r>
              <a:rPr lang="en-US" sz="1100" i="1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ESR1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wt:</a:t>
            </a:r>
            <a:r>
              <a:rPr lang="en-US" sz="1100" i="1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 ESR1 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wild type; ET: endocrine therapy; SES: socioeconomic status; Tx: therapy. *Menopausal status only abstracted for patients diagnosed at stage I-III.</a:t>
            </a:r>
            <a:endParaRPr sz="1100" dirty="0">
              <a:solidFill>
                <a:schemeClr val="dk1"/>
              </a:solidFill>
              <a:latin typeface="Arial" panose="020B0604020202020204" pitchFamily="34" charset="0"/>
              <a:ea typeface="Montserrat"/>
              <a:cs typeface="Arial" panose="020B0604020202020204" pitchFamily="34" charset="0"/>
              <a:sym typeface="Montserrat"/>
            </a:endParaRPr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4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8" name="Google Shape;848;p16"/>
          <p:cNvSpPr/>
          <p:nvPr/>
        </p:nvSpPr>
        <p:spPr>
          <a:xfrm>
            <a:off x="9524337" y="6106922"/>
            <a:ext cx="2402007" cy="667503"/>
          </a:xfrm>
          <a:prstGeom prst="rect">
            <a:avLst/>
          </a:prstGeom>
          <a:solidFill>
            <a:schemeClr val="lt1"/>
          </a:solidFill>
          <a:ln w="1270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2000">
              <a:solidFill>
                <a:schemeClr val="lt2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aphicFrame>
        <p:nvGraphicFramePr>
          <p:cNvPr id="849" name="Google Shape;849;p16"/>
          <p:cNvGraphicFramePr/>
          <p:nvPr>
            <p:extLst>
              <p:ext uri="{D42A27DB-BD31-4B8C-83A1-F6EECF244321}">
                <p14:modId xmlns:p14="http://schemas.microsoft.com/office/powerpoint/2010/main" val="2027204548"/>
              </p:ext>
            </p:extLst>
          </p:nvPr>
        </p:nvGraphicFramePr>
        <p:xfrm>
          <a:off x="4245429" y="119854"/>
          <a:ext cx="7373875" cy="6470904"/>
        </p:xfrm>
        <a:graphic>
          <a:graphicData uri="http://schemas.openxmlformats.org/drawingml/2006/table">
            <a:tbl>
              <a:tblPr firstRow="1" bandRow="1">
                <a:noFill/>
                <a:tableStyleId>{633E41C2-94C5-44B2-B323-6E28DEAA064A}</a:tableStyleId>
              </a:tblPr>
              <a:tblGrid>
                <a:gridCol w="278052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56922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47217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55195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24175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100"/>
                        <a:buFont typeface="Arial"/>
                        <a:buNone/>
                      </a:pPr>
                      <a:endParaRPr sz="1100" b="1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lt1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1" i="1" u="none" strike="noStrike" cap="none">
                          <a:solidFill>
                            <a:schemeClr val="lt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SR1</a:t>
                      </a:r>
                      <a:r>
                        <a:rPr lang="en-US" sz="1100" b="1" u="none" strike="noStrike" cap="none">
                          <a:solidFill>
                            <a:schemeClr val="lt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 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lt1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1" u="none" strike="noStrike" cap="none">
                          <a:solidFill>
                            <a:schemeClr val="lt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289)</a:t>
                      </a:r>
                      <a:endParaRPr sz="1100" b="1" i="0" u="none" strike="noStrike" cap="none">
                        <a:solidFill>
                          <a:schemeClr val="lt1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lt1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1" i="1" u="none" strike="noStrike" cap="none">
                          <a:solidFill>
                            <a:schemeClr val="lt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SR1</a:t>
                      </a:r>
                      <a:r>
                        <a:rPr lang="en-US" sz="1100" b="1" u="none" strike="noStrike" cap="none">
                          <a:solidFill>
                            <a:schemeClr val="lt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t 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lt1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1" u="none" strike="noStrike" cap="none">
                          <a:solidFill>
                            <a:schemeClr val="lt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59)</a:t>
                      </a:r>
                      <a:endParaRPr sz="1100" b="1" i="0" u="none" strike="noStrike" cap="none">
                        <a:solidFill>
                          <a:schemeClr val="lt1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lt1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1" i="0" u="none" strike="noStrike" cap="none">
                          <a:solidFill>
                            <a:schemeClr val="lt1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P-value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5" marR="6075" marT="9144" marB="9144" anchor="b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7015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1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 at Tx Start</a:t>
                      </a:r>
                      <a:endParaRPr sz="1100" b="1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0.236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7015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 Median (Q1, Q3)</a:t>
                      </a:r>
                      <a:endParaRPr sz="11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64.0 (56.0, 71.0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 gridSpan="2"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    66.0 (57.5, 73.0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7015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1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der</a:t>
                      </a:r>
                      <a:endParaRPr sz="1100" b="1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0.363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72825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 Male</a:t>
                      </a:r>
                      <a:endParaRPr sz="11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285 (98.6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59 (100.0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72825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 Female</a:t>
                      </a:r>
                      <a:endParaRPr sz="11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4 (1.4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0 (0.0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75300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1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Areal socioeconomic status (quintile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0.485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7530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  1 - Lowest SES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41 (15.1%)</a:t>
                      </a:r>
                      <a:endParaRPr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8 (14.0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7530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  2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41 (15.1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9 (15.8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7530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  3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55 (20.3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7 (12.3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7530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  4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66 (24.4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13 (22.8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7530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  5 - Highest SES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68 (25.1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20 (35.1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7530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  Missing</a:t>
                      </a:r>
                      <a:endParaRPr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18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2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7530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1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COG PS</a:t>
                      </a:r>
                      <a:endParaRPr sz="1100" b="1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0.954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72825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 0</a:t>
                      </a:r>
                      <a:endParaRPr sz="11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124 (49.6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27 (51.9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72825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 1</a:t>
                      </a:r>
                      <a:endParaRPr sz="11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101 (40.4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20 (38.5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72825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 2 +</a:t>
                      </a:r>
                      <a:endParaRPr sz="11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25 (10.0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5 (9.6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72825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 Missing</a:t>
                      </a:r>
                      <a:endParaRPr sz="11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39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7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7015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1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juvant Tx</a:t>
                      </a:r>
                      <a:endParaRPr sz="1100" b="1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0.065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72825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djuvant ET with AI</a:t>
                      </a:r>
                      <a:endParaRPr sz="11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149 (51.6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40 (67.8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72825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Adjuvant ET with Tamoxifen</a:t>
                      </a:r>
                      <a:endParaRPr sz="11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13 (4.5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1 (1.7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72825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No adjuvant ET / de novo met/ unknown</a:t>
                      </a:r>
                      <a:endParaRPr sz="11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127 (43.9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18 (30.5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6937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1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Menopause status*</a:t>
                      </a:r>
                      <a:endParaRPr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0.826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7282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 Postmenopausal</a:t>
                      </a:r>
                      <a:endParaRPr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156 (54.0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34 (57.6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7282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 Premenopausal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64 (22.1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13 (22.0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17282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 Unknown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69 (23.9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12 (20.3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7282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1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Histology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0.115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17282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 Invasive ductal carcinoma (IDC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175 (60.6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38 (64.4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17282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 Invasive lobular carcinoma (ILC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48 (16.6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14 (23.7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17282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 Other/unknown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66 (22.8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7 (11.9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17282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1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astasis Site(s)</a:t>
                      </a:r>
                      <a:endParaRPr sz="1100" b="1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0.533</a:t>
                      </a: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172825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Bone only</a:t>
                      </a:r>
                      <a:endParaRPr sz="11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80 (27.7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14 (23.7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100"/>
                        <a:buFont typeface="Arial"/>
                        <a:buNone/>
                      </a:pPr>
                      <a:endParaRPr sz="1100" b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172825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</a:pPr>
                      <a:r>
                        <a:rPr lang="en-US" sz="1100" b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Visceral (CNS, liver, adrenal, other) with or without bone</a:t>
                      </a:r>
                      <a:endParaRPr sz="11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6075" marR="607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209 (72.3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Arial"/>
                          <a:cs typeface="Arial" panose="020B0604020202020204" pitchFamily="34" charset="0"/>
                          <a:sym typeface="Arial"/>
                        </a:rPr>
                        <a:t>45 (76.3%)</a:t>
                      </a:r>
                      <a:endParaRPr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144" marB="9144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100"/>
                        <a:buFont typeface="Arial"/>
                        <a:buNone/>
                      </a:pPr>
                      <a:endParaRPr sz="1100" b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"/>
                        <a:cs typeface="Arial" panose="020B0604020202020204" pitchFamily="34" charset="0"/>
                        <a:sym typeface="Arial"/>
                      </a:endParaRPr>
                    </a:p>
                  </a:txBody>
                  <a:tcPr marL="9525" marR="9525" marT="9144" marB="9144" anchor="b"/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</a:tbl>
          </a:graphicData>
        </a:graphic>
      </p:graphicFrame>
      <p:sp>
        <p:nvSpPr>
          <p:cNvPr id="850" name="Google Shape;850;p16"/>
          <p:cNvSpPr txBox="1"/>
          <p:nvPr/>
        </p:nvSpPr>
        <p:spPr>
          <a:xfrm>
            <a:off x="187653" y="1189337"/>
            <a:ext cx="3710444" cy="178506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Montserrat"/>
              <a:buNone/>
            </a:pPr>
            <a:r>
              <a:rPr lang="en-US" sz="1100" b="1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SUPPLEMENTARY TABLE 2: Comparison of baseline characteristics of patients receiving 1</a:t>
            </a:r>
            <a:r>
              <a:rPr lang="en-US" sz="1100" b="1" baseline="300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st</a:t>
            </a:r>
            <a:r>
              <a:rPr lang="en-US" sz="1100" b="1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 line </a:t>
            </a:r>
            <a:r>
              <a:rPr lang="en-US" sz="1100" b="1" dirty="0" err="1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fulvestrant</a:t>
            </a:r>
            <a:r>
              <a:rPr lang="en-US" sz="1100" b="1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 + CDK4/6i.</a:t>
            </a:r>
            <a:endParaRPr sz="1100" b="1" dirty="0">
              <a:solidFill>
                <a:schemeClr val="dk1"/>
              </a:solidFill>
              <a:latin typeface="Arial" panose="020B0604020202020204" pitchFamily="34" charset="0"/>
              <a:ea typeface="Montserrat"/>
              <a:cs typeface="Arial" panose="020B0604020202020204" pitchFamily="34" charset="0"/>
              <a:sym typeface="Montserrat"/>
            </a:endParaRPr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b="1" u="sng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Caption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: CDK4/6i: CDK 4/6 inhibitors; CNS: central nervous system; ECOG PS: Eastern Cooperative Oncology Group performance status; </a:t>
            </a:r>
            <a:r>
              <a:rPr lang="en-US" sz="1100" i="1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ESR1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mut: </a:t>
            </a:r>
            <a:r>
              <a:rPr lang="en-US" sz="1100" i="1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ESR1 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mutations; </a:t>
            </a:r>
            <a:r>
              <a:rPr lang="en-US" sz="1100" i="1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ESR1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wt:</a:t>
            </a:r>
            <a:r>
              <a:rPr lang="en-US" sz="1100" i="1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 ESR1 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wild type; ET: endocrine therapy; SES: socioeconomic status; Tx: therapy. *Menopausal status only abstracted for patients diagnosed at stage I-III.</a:t>
            </a:r>
            <a:endParaRPr sz="1100" dirty="0">
              <a:solidFill>
                <a:schemeClr val="dk1"/>
              </a:solidFill>
              <a:latin typeface="Arial" panose="020B0604020202020204" pitchFamily="34" charset="0"/>
              <a:ea typeface="Montserrat"/>
              <a:cs typeface="Arial" panose="020B0604020202020204" pitchFamily="34" charset="0"/>
              <a:sym typeface="Montserrat"/>
            </a:endParaRPr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5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56" name="Google Shape;856;p17" descr="A table with numbers and a number of items&#10;&#10;Description automatically generated with medium confidence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7907771" y="2615370"/>
            <a:ext cx="3212514" cy="1927508"/>
          </a:xfrm>
          <a:prstGeom prst="rect">
            <a:avLst/>
          </a:prstGeom>
          <a:noFill/>
          <a:ln>
            <a:noFill/>
          </a:ln>
        </p:spPr>
      </p:pic>
      <p:sp>
        <p:nvSpPr>
          <p:cNvPr id="857" name="Google Shape;857;p17"/>
          <p:cNvSpPr/>
          <p:nvPr/>
        </p:nvSpPr>
        <p:spPr>
          <a:xfrm>
            <a:off x="9711150" y="6190497"/>
            <a:ext cx="2402007" cy="667503"/>
          </a:xfrm>
          <a:prstGeom prst="rect">
            <a:avLst/>
          </a:prstGeom>
          <a:solidFill>
            <a:schemeClr val="lt1"/>
          </a:solidFill>
          <a:ln w="1270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2000">
              <a:solidFill>
                <a:schemeClr val="lt2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58" name="Google Shape;858;p17"/>
          <p:cNvSpPr txBox="1"/>
          <p:nvPr/>
        </p:nvSpPr>
        <p:spPr>
          <a:xfrm>
            <a:off x="4191677" y="4503005"/>
            <a:ext cx="2189458" cy="30773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C) </a:t>
            </a:r>
            <a:r>
              <a:rPr lang="en-US" sz="1400" b="1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rwOS</a:t>
            </a:r>
            <a:r>
              <a:rPr lang="en-US" sz="14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: AI + CDK4/6i</a:t>
            </a:r>
            <a:endParaRPr sz="1400" b="1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59" name="Google Shape;859;p17"/>
          <p:cNvSpPr txBox="1"/>
          <p:nvPr/>
        </p:nvSpPr>
        <p:spPr>
          <a:xfrm>
            <a:off x="4131395" y="2294588"/>
            <a:ext cx="2611501" cy="30773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B) </a:t>
            </a:r>
            <a:r>
              <a:rPr lang="en-US" sz="1400" b="1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rwPFS</a:t>
            </a:r>
            <a:r>
              <a:rPr lang="en-US" sz="14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: AI + CDK4/6i</a:t>
            </a:r>
            <a:endParaRPr sz="1400" b="1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60" name="Google Shape;860;p17"/>
          <p:cNvSpPr txBox="1"/>
          <p:nvPr/>
        </p:nvSpPr>
        <p:spPr>
          <a:xfrm>
            <a:off x="7832261" y="4482458"/>
            <a:ext cx="2898550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F) </a:t>
            </a:r>
            <a:r>
              <a:rPr lang="en-US" sz="1400" b="1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rwOS</a:t>
            </a:r>
            <a:r>
              <a:rPr lang="en-US" sz="14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: </a:t>
            </a:r>
            <a:r>
              <a:rPr lang="en-US" sz="1400" b="1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ulvestrant</a:t>
            </a:r>
            <a:r>
              <a:rPr lang="en-US" sz="14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+ CDK4/6i</a:t>
            </a:r>
            <a:endParaRPr sz="1400" b="1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61" name="Google Shape;861;p17"/>
          <p:cNvSpPr txBox="1"/>
          <p:nvPr/>
        </p:nvSpPr>
        <p:spPr>
          <a:xfrm>
            <a:off x="7832261" y="2317403"/>
            <a:ext cx="2980303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E) </a:t>
            </a:r>
            <a:r>
              <a:rPr lang="en-US" sz="1400" b="1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rwPFS</a:t>
            </a:r>
            <a:r>
              <a:rPr lang="en-US" sz="14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: </a:t>
            </a:r>
            <a:r>
              <a:rPr lang="en-US" sz="1400" b="1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ulvestrant</a:t>
            </a:r>
            <a:r>
              <a:rPr lang="en-US" sz="14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+ CDK4/6i</a:t>
            </a:r>
            <a:endParaRPr sz="1400" b="1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62" name="Google Shape;862;p17"/>
          <p:cNvSpPr/>
          <p:nvPr/>
        </p:nvSpPr>
        <p:spPr>
          <a:xfrm>
            <a:off x="562234" y="6106923"/>
            <a:ext cx="2402007" cy="667503"/>
          </a:xfrm>
          <a:prstGeom prst="rect">
            <a:avLst/>
          </a:prstGeom>
          <a:solidFill>
            <a:schemeClr val="lt1"/>
          </a:solidFill>
          <a:ln w="1270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2000">
              <a:solidFill>
                <a:schemeClr val="lt2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63" name="Google Shape;863;p17"/>
          <p:cNvSpPr txBox="1"/>
          <p:nvPr/>
        </p:nvSpPr>
        <p:spPr>
          <a:xfrm>
            <a:off x="407038" y="1395969"/>
            <a:ext cx="3349219" cy="330855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Montserrat"/>
              <a:buNone/>
            </a:pPr>
            <a:r>
              <a:rPr lang="en-US" sz="1100" b="1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SUPPLEMENTARY FIGURE S10: Multivariable models for HR(+)HER2(-) metastatic breast cancer patients receiving AI + CDK4/6i or </a:t>
            </a:r>
            <a:r>
              <a:rPr lang="en-US" sz="1100" b="1" dirty="0" err="1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fulvestrant</a:t>
            </a:r>
            <a:r>
              <a:rPr lang="en-US" sz="1100" b="1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 + CDK4/6i.</a:t>
            </a:r>
            <a:endParaRPr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Multivariable models for </a:t>
            </a:r>
            <a:r>
              <a:rPr lang="en-US" sz="1100" i="1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ESR1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mut vs. </a:t>
            </a:r>
            <a:r>
              <a:rPr lang="en-US" sz="1100" i="1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ESR1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wt in patients receiving AI + CDK4/6i: </a:t>
            </a:r>
            <a:r>
              <a:rPr lang="en-US" sz="1100" dirty="0" err="1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rwTTD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 (A), </a:t>
            </a:r>
            <a:r>
              <a:rPr lang="en-US" sz="1100" dirty="0" err="1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rwPFS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 (B) and </a:t>
            </a:r>
            <a:r>
              <a:rPr lang="en-US" sz="1100" dirty="0" err="1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rwOS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 (C). Multivariable models for </a:t>
            </a:r>
            <a:r>
              <a:rPr lang="en-US" sz="1100" i="1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ESR1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mut vs. </a:t>
            </a:r>
            <a:r>
              <a:rPr lang="en-US" sz="1100" i="1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ESR1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wt in patients receiving fulvestrant + CDK4/6i: </a:t>
            </a:r>
            <a:r>
              <a:rPr lang="en-US" sz="1100" dirty="0" err="1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rwTTD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 (D), </a:t>
            </a:r>
            <a:r>
              <a:rPr lang="en-US" sz="1100" dirty="0" err="1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rwPFS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 (E) and </a:t>
            </a:r>
            <a:r>
              <a:rPr lang="en-US" sz="1100" dirty="0" err="1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rwOS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 (F). AI: aromatase inhibitors; CI: confidence interval; CDK4/6i: CDK4/6 inhibitors; ECOG PS: Eastern Cooperative Oncology Group performance score; ET: endocrine therapy; </a:t>
            </a:r>
            <a:r>
              <a:rPr lang="en-US" sz="1100" i="1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ESR1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mut: </a:t>
            </a:r>
            <a:r>
              <a:rPr lang="en-US" sz="1100" i="1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ESR1 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mutations; </a:t>
            </a:r>
            <a:r>
              <a:rPr lang="en-US" sz="1100" i="1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ESR1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wt:</a:t>
            </a:r>
            <a:r>
              <a:rPr lang="en-US" sz="1100" i="1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 ESR1 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wild type;  HR: hazard ratio; IDC:  Invasive ductal carcinoma; ILC:  Invasive lobular carcinoma; Met; metastasis; OS: overall survival; PFS: progression-free survival; </a:t>
            </a:r>
            <a:r>
              <a:rPr lang="en-US" sz="1100" dirty="0" err="1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rw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: real-world; TBx: tissue biopsy; Tx: therapy.</a:t>
            </a:r>
            <a:endParaRPr sz="1100" dirty="0">
              <a:solidFill>
                <a:schemeClr val="dk1"/>
              </a:solidFill>
              <a:latin typeface="Arial" panose="020B0604020202020204" pitchFamily="34" charset="0"/>
              <a:ea typeface="Arial"/>
              <a:cs typeface="Arial" panose="020B0604020202020204" pitchFamily="34" charset="0"/>
              <a:sym typeface="Arial"/>
            </a:endParaRPr>
          </a:p>
        </p:txBody>
      </p:sp>
      <p:pic>
        <p:nvPicPr>
          <p:cNvPr id="864" name="Google Shape;864;p17" descr="A table with numbers and a line&#10;&#10;Description automatically generated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7907772" y="4759696"/>
            <a:ext cx="3212514" cy="1927508"/>
          </a:xfrm>
          <a:prstGeom prst="rect">
            <a:avLst/>
          </a:prstGeom>
          <a:noFill/>
          <a:ln>
            <a:noFill/>
          </a:ln>
        </p:spPr>
      </p:pic>
      <p:pic>
        <p:nvPicPr>
          <p:cNvPr id="865" name="Google Shape;865;p17" descr="A table with numbers and a number of items&#10;&#10;Description automatically generated with medium confidence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4221040" y="2602365"/>
            <a:ext cx="3133489" cy="1880093"/>
          </a:xfrm>
          <a:prstGeom prst="rect">
            <a:avLst/>
          </a:prstGeom>
          <a:noFill/>
          <a:ln>
            <a:noFill/>
          </a:ln>
        </p:spPr>
      </p:pic>
      <p:pic>
        <p:nvPicPr>
          <p:cNvPr id="866" name="Google Shape;866;p17" descr="A table with numbers and a number of items&#10;&#10;Description automatically generated with medium confidence"/>
          <p:cNvPicPr preferRelativeResize="0"/>
          <p:nvPr/>
        </p:nvPicPr>
        <p:blipFill rotWithShape="1">
          <a:blip r:embed="rId6">
            <a:alphaModFix/>
          </a:blip>
          <a:srcRect/>
          <a:stretch/>
        </p:blipFill>
        <p:spPr>
          <a:xfrm>
            <a:off x="4233989" y="4759697"/>
            <a:ext cx="3133489" cy="1880094"/>
          </a:xfrm>
          <a:prstGeom prst="rect">
            <a:avLst/>
          </a:prstGeom>
          <a:noFill/>
          <a:ln>
            <a:noFill/>
          </a:ln>
        </p:spPr>
      </p:pic>
      <p:pic>
        <p:nvPicPr>
          <p:cNvPr id="867" name="Google Shape;867;p17" descr="A table with numbers and symbols&#10;&#10;Description automatically generated"/>
          <p:cNvPicPr preferRelativeResize="0"/>
          <p:nvPr/>
        </p:nvPicPr>
        <p:blipFill rotWithShape="1">
          <a:blip r:embed="rId7">
            <a:alphaModFix/>
          </a:blip>
          <a:srcRect/>
          <a:stretch/>
        </p:blipFill>
        <p:spPr>
          <a:xfrm>
            <a:off x="4191677" y="414495"/>
            <a:ext cx="3133490" cy="1880094"/>
          </a:xfrm>
          <a:prstGeom prst="rect">
            <a:avLst/>
          </a:prstGeom>
          <a:noFill/>
          <a:ln>
            <a:noFill/>
          </a:ln>
        </p:spPr>
      </p:pic>
      <p:pic>
        <p:nvPicPr>
          <p:cNvPr id="868" name="Google Shape;868;p17" descr="A table with numbers and black dots&#10;&#10;Description automatically generated"/>
          <p:cNvPicPr preferRelativeResize="0"/>
          <p:nvPr/>
        </p:nvPicPr>
        <p:blipFill rotWithShape="1">
          <a:blip r:embed="rId8">
            <a:alphaModFix/>
          </a:blip>
          <a:srcRect/>
          <a:stretch/>
        </p:blipFill>
        <p:spPr>
          <a:xfrm>
            <a:off x="7907771" y="414495"/>
            <a:ext cx="3212515" cy="1927510"/>
          </a:xfrm>
          <a:prstGeom prst="rect">
            <a:avLst/>
          </a:prstGeom>
          <a:noFill/>
          <a:ln>
            <a:noFill/>
          </a:ln>
        </p:spPr>
      </p:pic>
      <p:sp>
        <p:nvSpPr>
          <p:cNvPr id="869" name="Google Shape;869;p17"/>
          <p:cNvSpPr txBox="1"/>
          <p:nvPr/>
        </p:nvSpPr>
        <p:spPr>
          <a:xfrm>
            <a:off x="4113763" y="83534"/>
            <a:ext cx="2611502" cy="30773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A) </a:t>
            </a:r>
            <a:r>
              <a:rPr lang="en-US" sz="1400" b="1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rwTTD</a:t>
            </a:r>
            <a:r>
              <a:rPr lang="en-US" sz="14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: AI + CDK4/6i</a:t>
            </a:r>
            <a:endParaRPr sz="1400" b="1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70" name="Google Shape;870;p17"/>
          <p:cNvSpPr txBox="1"/>
          <p:nvPr/>
        </p:nvSpPr>
        <p:spPr>
          <a:xfrm>
            <a:off x="7832261" y="63832"/>
            <a:ext cx="2997937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D) </a:t>
            </a:r>
            <a:r>
              <a:rPr lang="en-US" sz="1400" b="1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rwTTD</a:t>
            </a:r>
            <a:r>
              <a:rPr lang="en-US" sz="14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: </a:t>
            </a:r>
            <a:r>
              <a:rPr lang="en-US" sz="1400" b="1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ulvestrant</a:t>
            </a:r>
            <a:r>
              <a:rPr lang="en-US" sz="14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+ CDK4/6i</a:t>
            </a:r>
            <a:endParaRPr sz="1400" b="1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7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737" name="Google Shape;737;p8"/>
          <p:cNvCxnSpPr>
            <a:cxnSpLocks/>
            <a:endCxn id="733" idx="1"/>
          </p:cNvCxnSpPr>
          <p:nvPr/>
        </p:nvCxnSpPr>
        <p:spPr>
          <a:xfrm>
            <a:off x="6136673" y="424295"/>
            <a:ext cx="550722" cy="444509"/>
          </a:xfrm>
          <a:prstGeom prst="bentConnector3">
            <a:avLst>
              <a:gd name="adj1" fmla="val 50000"/>
            </a:avLst>
          </a:prstGeom>
          <a:noFill/>
          <a:ln w="9525" cap="flat" cmpd="sng">
            <a:solidFill>
              <a:schemeClr val="accent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736" name="Google Shape;736;p8"/>
          <p:cNvCxnSpPr>
            <a:cxnSpLocks/>
            <a:endCxn id="732" idx="3"/>
          </p:cNvCxnSpPr>
          <p:nvPr/>
        </p:nvCxnSpPr>
        <p:spPr>
          <a:xfrm rot="10800000" flipV="1">
            <a:off x="5202394" y="331303"/>
            <a:ext cx="737075" cy="535413"/>
          </a:xfrm>
          <a:prstGeom prst="bentConnector3">
            <a:avLst>
              <a:gd name="adj1" fmla="val 64674"/>
            </a:avLst>
          </a:prstGeom>
          <a:noFill/>
          <a:ln w="9525" cap="flat" cmpd="sng">
            <a:solidFill>
              <a:schemeClr val="accent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sp>
        <p:nvSpPr>
          <p:cNvPr id="712" name="Google Shape;712;p8"/>
          <p:cNvSpPr/>
          <p:nvPr/>
        </p:nvSpPr>
        <p:spPr>
          <a:xfrm>
            <a:off x="562234" y="6106923"/>
            <a:ext cx="2402007" cy="667503"/>
          </a:xfrm>
          <a:prstGeom prst="rect">
            <a:avLst/>
          </a:prstGeom>
          <a:solidFill>
            <a:schemeClr val="lt1"/>
          </a:solidFill>
          <a:ln w="1270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2000">
              <a:solidFill>
                <a:schemeClr val="lt2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713" name="Google Shape;713;p8"/>
          <p:cNvSpPr/>
          <p:nvPr/>
        </p:nvSpPr>
        <p:spPr>
          <a:xfrm>
            <a:off x="2133602" y="5382804"/>
            <a:ext cx="3736256" cy="1268116"/>
          </a:xfrm>
          <a:prstGeom prst="rect">
            <a:avLst/>
          </a:prstGeom>
          <a:gradFill>
            <a:gsLst>
              <a:gs pos="0">
                <a:srgbClr val="B2E4E2"/>
              </a:gs>
              <a:gs pos="50000">
                <a:srgbClr val="A5DEDC"/>
              </a:gs>
              <a:gs pos="100000">
                <a:srgbClr val="95DCDA"/>
              </a:gs>
            </a:gsLst>
            <a:lin ang="5400000" scaled="0"/>
          </a:gradFill>
          <a:ln w="9525" cap="flat" cmpd="sng">
            <a:solidFill>
              <a:schemeClr val="accent3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2000">
              <a:solidFill>
                <a:schemeClr val="lt2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714" name="Google Shape;714;p8"/>
          <p:cNvSpPr/>
          <p:nvPr/>
        </p:nvSpPr>
        <p:spPr>
          <a:xfrm>
            <a:off x="3752610" y="64182"/>
            <a:ext cx="4373710" cy="444101"/>
          </a:xfrm>
          <a:prstGeom prst="rect">
            <a:avLst/>
          </a:prstGeom>
          <a:solidFill>
            <a:srgbClr val="313F49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b="1" u="sng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61,970</a:t>
            </a:r>
            <a:r>
              <a:rPr lang="en-US" sz="1100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 LOT associated with BC specimens profiled with CGP with </a:t>
            </a:r>
            <a:r>
              <a:rPr lang="en-US" sz="1100" dirty="0" err="1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clinico</a:t>
            </a:r>
            <a:r>
              <a:rPr lang="en-US" sz="1100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-pathological features and outcomes  (Q1 2024)</a:t>
            </a:r>
            <a:endParaRPr dirty="0"/>
          </a:p>
        </p:txBody>
      </p:sp>
      <p:sp>
        <p:nvSpPr>
          <p:cNvPr id="715" name="Google Shape;715;p8"/>
          <p:cNvSpPr/>
          <p:nvPr/>
        </p:nvSpPr>
        <p:spPr>
          <a:xfrm>
            <a:off x="2964242" y="1475196"/>
            <a:ext cx="2238151" cy="409162"/>
          </a:xfrm>
          <a:prstGeom prst="rect">
            <a:avLst/>
          </a:prstGeom>
          <a:solidFill>
            <a:srgbClr val="313F49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b="1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50,273</a:t>
            </a:r>
            <a:r>
              <a:rPr lang="en-US" sz="11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 LOT </a:t>
            </a:r>
            <a:endParaRPr/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b="1" u="sng">
                <a:solidFill>
                  <a:schemeClr val="accent2"/>
                </a:solidFill>
                <a:latin typeface="Calibri"/>
                <a:ea typeface="Calibri"/>
                <a:cs typeface="Calibri"/>
                <a:sym typeface="Calibri"/>
              </a:rPr>
              <a:t>10,918 patients</a:t>
            </a:r>
            <a:endParaRPr/>
          </a:p>
        </p:txBody>
      </p:sp>
      <p:sp>
        <p:nvSpPr>
          <p:cNvPr id="716" name="Google Shape;716;p8"/>
          <p:cNvSpPr/>
          <p:nvPr/>
        </p:nvSpPr>
        <p:spPr>
          <a:xfrm>
            <a:off x="6687395" y="1463519"/>
            <a:ext cx="2238152" cy="451844"/>
          </a:xfrm>
          <a:prstGeom prst="rect">
            <a:avLst/>
          </a:prstGeom>
          <a:solidFill>
            <a:srgbClr val="313F49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b="1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13,234</a:t>
            </a:r>
            <a:r>
              <a:rPr lang="en-US" sz="11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 LOT</a:t>
            </a:r>
            <a:endParaRPr/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b="1" u="sng">
                <a:solidFill>
                  <a:schemeClr val="accent2"/>
                </a:solidFill>
                <a:latin typeface="Calibri"/>
                <a:ea typeface="Calibri"/>
                <a:cs typeface="Calibri"/>
                <a:sym typeface="Calibri"/>
              </a:rPr>
              <a:t>2,874 patients</a:t>
            </a:r>
            <a:endParaRPr/>
          </a:p>
        </p:txBody>
      </p:sp>
      <p:sp>
        <p:nvSpPr>
          <p:cNvPr id="717" name="Google Shape;717;p8"/>
          <p:cNvSpPr/>
          <p:nvPr/>
        </p:nvSpPr>
        <p:spPr>
          <a:xfrm>
            <a:off x="690540" y="1190413"/>
            <a:ext cx="3304050" cy="171045"/>
          </a:xfrm>
          <a:prstGeom prst="rect">
            <a:avLst/>
          </a:prstGeom>
          <a:solidFill>
            <a:schemeClr val="lt1"/>
          </a:solidFill>
          <a:ln w="12700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iltering 181 LOT (49 patients) associated with older tissue baitsets</a:t>
            </a:r>
            <a:endParaRPr sz="9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718" name="Google Shape;718;p8"/>
          <p:cNvSpPr/>
          <p:nvPr/>
        </p:nvSpPr>
        <p:spPr>
          <a:xfrm>
            <a:off x="8478758" y="127949"/>
            <a:ext cx="1392829" cy="368857"/>
          </a:xfrm>
          <a:prstGeom prst="rect">
            <a:avLst/>
          </a:prstGeom>
          <a:solidFill>
            <a:schemeClr val="lt1"/>
          </a:solidFill>
          <a:ln w="12700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3,334 LOT associated with both TBx and LBx</a:t>
            </a:r>
            <a:endParaRPr sz="9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719" name="Google Shape;719;p8"/>
          <p:cNvSpPr/>
          <p:nvPr/>
        </p:nvSpPr>
        <p:spPr>
          <a:xfrm>
            <a:off x="1064340" y="2003407"/>
            <a:ext cx="2915277" cy="194518"/>
          </a:xfrm>
          <a:prstGeom prst="rect">
            <a:avLst/>
          </a:prstGeom>
          <a:solidFill>
            <a:schemeClr val="lt1"/>
          </a:solidFill>
          <a:ln w="12700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iltering 17,479 LOT (2,012 patients) non-metastatic </a:t>
            </a:r>
            <a:endParaRPr/>
          </a:p>
        </p:txBody>
      </p:sp>
      <p:sp>
        <p:nvSpPr>
          <p:cNvPr id="720" name="Google Shape;720;p8"/>
          <p:cNvSpPr/>
          <p:nvPr/>
        </p:nvSpPr>
        <p:spPr>
          <a:xfrm>
            <a:off x="2957244" y="2253719"/>
            <a:ext cx="2238148" cy="451844"/>
          </a:xfrm>
          <a:prstGeom prst="rect">
            <a:avLst/>
          </a:prstGeom>
          <a:solidFill>
            <a:srgbClr val="313F49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b="1" u="sng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32,794 LOT</a:t>
            </a:r>
            <a:endParaRPr/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b="1" u="sng">
                <a:solidFill>
                  <a:schemeClr val="accent2"/>
                </a:solidFill>
                <a:latin typeface="Calibri"/>
                <a:ea typeface="Calibri"/>
                <a:cs typeface="Calibri"/>
                <a:sym typeface="Calibri"/>
              </a:rPr>
              <a:t>8,906 patients</a:t>
            </a:r>
            <a:endParaRPr/>
          </a:p>
        </p:txBody>
      </p:sp>
      <p:sp>
        <p:nvSpPr>
          <p:cNvPr id="721" name="Google Shape;721;p8"/>
          <p:cNvSpPr/>
          <p:nvPr/>
        </p:nvSpPr>
        <p:spPr>
          <a:xfrm>
            <a:off x="6687412" y="2256516"/>
            <a:ext cx="2238135" cy="446249"/>
          </a:xfrm>
          <a:prstGeom prst="rect">
            <a:avLst/>
          </a:prstGeom>
          <a:solidFill>
            <a:srgbClr val="313F49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b="1" u="sng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8,847 LOT</a:t>
            </a:r>
            <a:endParaRPr/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b="1" u="sng">
                <a:solidFill>
                  <a:schemeClr val="accent2"/>
                </a:solidFill>
                <a:latin typeface="Calibri"/>
                <a:ea typeface="Calibri"/>
                <a:cs typeface="Calibri"/>
                <a:sym typeface="Calibri"/>
              </a:rPr>
              <a:t>2,425 patients</a:t>
            </a:r>
            <a:endParaRPr sz="1100">
              <a:solidFill>
                <a:schemeClr val="accent2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722" name="Google Shape;722;p8"/>
          <p:cNvSpPr/>
          <p:nvPr/>
        </p:nvSpPr>
        <p:spPr>
          <a:xfrm>
            <a:off x="7970216" y="1996263"/>
            <a:ext cx="2634998" cy="181650"/>
          </a:xfrm>
          <a:prstGeom prst="rect">
            <a:avLst/>
          </a:prstGeom>
          <a:solidFill>
            <a:schemeClr val="lt1"/>
          </a:solidFill>
          <a:ln w="12700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iltering 4,387 LOT (449 patients) non-metastatic</a:t>
            </a:r>
            <a:endParaRPr/>
          </a:p>
        </p:txBody>
      </p:sp>
      <p:sp>
        <p:nvSpPr>
          <p:cNvPr id="723" name="Google Shape;723;p8"/>
          <p:cNvSpPr/>
          <p:nvPr/>
        </p:nvSpPr>
        <p:spPr>
          <a:xfrm>
            <a:off x="1498172" y="2797016"/>
            <a:ext cx="2464612" cy="179470"/>
          </a:xfrm>
          <a:prstGeom prst="rect">
            <a:avLst/>
          </a:prstGeom>
          <a:solidFill>
            <a:schemeClr val="lt1"/>
          </a:solidFill>
          <a:ln w="12700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iltering 3,126 patients non HR(+)HER2(-)</a:t>
            </a:r>
            <a:endParaRPr/>
          </a:p>
        </p:txBody>
      </p:sp>
      <p:sp>
        <p:nvSpPr>
          <p:cNvPr id="724" name="Google Shape;724;p8"/>
          <p:cNvSpPr/>
          <p:nvPr/>
        </p:nvSpPr>
        <p:spPr>
          <a:xfrm>
            <a:off x="2964241" y="3064169"/>
            <a:ext cx="2218490" cy="569203"/>
          </a:xfrm>
          <a:prstGeom prst="rect">
            <a:avLst/>
          </a:prstGeom>
          <a:solidFill>
            <a:srgbClr val="313F49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b="1" u="sng" dirty="0">
                <a:solidFill>
                  <a:schemeClr val="accent2"/>
                </a:solidFill>
                <a:latin typeface="Calibri"/>
                <a:ea typeface="Calibri"/>
                <a:cs typeface="Calibri"/>
                <a:sym typeface="Calibri"/>
              </a:rPr>
              <a:t>5,780 patients HR(+) HER2(-)</a:t>
            </a:r>
            <a:endParaRPr dirty="0"/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associated with at least one LOT and one TBx (</a:t>
            </a:r>
            <a:r>
              <a:rPr lang="en-US" sz="1100" i="1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Fig. 1A, </a:t>
            </a:r>
            <a:r>
              <a:rPr lang="en-US" sz="1100" i="1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2A, and </a:t>
            </a:r>
            <a:r>
              <a:rPr lang="en-US" sz="1100" i="1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3</a:t>
            </a:r>
            <a:r>
              <a:rPr lang="en-US" sz="1100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)*</a:t>
            </a:r>
            <a:endParaRPr dirty="0"/>
          </a:p>
        </p:txBody>
      </p:sp>
      <p:sp>
        <p:nvSpPr>
          <p:cNvPr id="725" name="Google Shape;725;p8"/>
          <p:cNvSpPr/>
          <p:nvPr/>
        </p:nvSpPr>
        <p:spPr>
          <a:xfrm>
            <a:off x="8001978" y="2735697"/>
            <a:ext cx="2088063" cy="309886"/>
          </a:xfrm>
          <a:prstGeom prst="rect">
            <a:avLst/>
          </a:prstGeom>
          <a:solidFill>
            <a:schemeClr val="lt1"/>
          </a:solidFill>
          <a:ln w="12700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iltering 555 patients non HR(+)HER2(-)</a:t>
            </a:r>
            <a:endParaRPr dirty="0"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iltering 200 TF unavailable</a:t>
            </a:r>
            <a:endParaRPr dirty="0"/>
          </a:p>
        </p:txBody>
      </p:sp>
      <p:sp>
        <p:nvSpPr>
          <p:cNvPr id="726" name="Google Shape;726;p8"/>
          <p:cNvSpPr/>
          <p:nvPr/>
        </p:nvSpPr>
        <p:spPr>
          <a:xfrm>
            <a:off x="6687395" y="3077338"/>
            <a:ext cx="2336018" cy="569203"/>
          </a:xfrm>
          <a:prstGeom prst="rect">
            <a:avLst/>
          </a:prstGeom>
          <a:solidFill>
            <a:srgbClr val="313F49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b="1" u="sng" dirty="0">
                <a:solidFill>
                  <a:schemeClr val="accent2"/>
                </a:solidFill>
                <a:latin typeface="Calibri"/>
                <a:ea typeface="Calibri"/>
                <a:cs typeface="Calibri"/>
                <a:sym typeface="Calibri"/>
              </a:rPr>
              <a:t>1,670 patients HR(+) HER2(-)</a:t>
            </a:r>
            <a:endParaRPr dirty="0"/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associated with at least one LOT and one LBx (</a:t>
            </a:r>
            <a:r>
              <a:rPr lang="en-US" sz="1100" i="1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Fig. 1B</a:t>
            </a:r>
            <a:r>
              <a:rPr lang="en-US" sz="1100" i="1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 and 2A-B</a:t>
            </a:r>
            <a:r>
              <a:rPr lang="en-US" sz="1100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)*</a:t>
            </a:r>
            <a:endParaRPr dirty="0"/>
          </a:p>
        </p:txBody>
      </p:sp>
      <p:sp>
        <p:nvSpPr>
          <p:cNvPr id="727" name="Google Shape;727;p8"/>
          <p:cNvSpPr/>
          <p:nvPr/>
        </p:nvSpPr>
        <p:spPr>
          <a:xfrm>
            <a:off x="7970216" y="1179032"/>
            <a:ext cx="3513229" cy="181650"/>
          </a:xfrm>
          <a:prstGeom prst="rect">
            <a:avLst/>
          </a:prstGeom>
          <a:solidFill>
            <a:schemeClr val="lt1"/>
          </a:solidFill>
          <a:ln w="12700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iltering 1,616 LOT (279 patients) associated with older liquid baitsets</a:t>
            </a:r>
            <a:endParaRPr sz="9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728" name="Google Shape;728;p8"/>
          <p:cNvCxnSpPr>
            <a:stCxn id="715" idx="2"/>
          </p:cNvCxnSpPr>
          <p:nvPr/>
        </p:nvCxnSpPr>
        <p:spPr>
          <a:xfrm>
            <a:off x="4083318" y="1884358"/>
            <a:ext cx="0" cy="341100"/>
          </a:xfrm>
          <a:prstGeom prst="straightConnector1">
            <a:avLst/>
          </a:prstGeom>
          <a:noFill/>
          <a:ln w="9525" cap="flat" cmpd="sng">
            <a:solidFill>
              <a:schemeClr val="accent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729" name="Google Shape;729;p8"/>
          <p:cNvCxnSpPr>
            <a:stCxn id="720" idx="2"/>
          </p:cNvCxnSpPr>
          <p:nvPr/>
        </p:nvCxnSpPr>
        <p:spPr>
          <a:xfrm flipH="1">
            <a:off x="4074518" y="2705563"/>
            <a:ext cx="1800" cy="333600"/>
          </a:xfrm>
          <a:prstGeom prst="straightConnector1">
            <a:avLst/>
          </a:prstGeom>
          <a:noFill/>
          <a:ln w="9525" cap="flat" cmpd="sng">
            <a:solidFill>
              <a:schemeClr val="accent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730" name="Google Shape;730;p8"/>
          <p:cNvCxnSpPr/>
          <p:nvPr/>
        </p:nvCxnSpPr>
        <p:spPr>
          <a:xfrm>
            <a:off x="7795581" y="1883566"/>
            <a:ext cx="0" cy="341783"/>
          </a:xfrm>
          <a:prstGeom prst="straightConnector1">
            <a:avLst/>
          </a:prstGeom>
          <a:noFill/>
          <a:ln w="9525" cap="flat" cmpd="sng">
            <a:solidFill>
              <a:schemeClr val="accent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731" name="Google Shape;731;p8"/>
          <p:cNvCxnSpPr/>
          <p:nvPr/>
        </p:nvCxnSpPr>
        <p:spPr>
          <a:xfrm>
            <a:off x="7806472" y="2698979"/>
            <a:ext cx="0" cy="340158"/>
          </a:xfrm>
          <a:prstGeom prst="straightConnector1">
            <a:avLst/>
          </a:prstGeom>
          <a:noFill/>
          <a:ln w="9525" cap="flat" cmpd="sng">
            <a:solidFill>
              <a:schemeClr val="accent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sp>
        <p:nvSpPr>
          <p:cNvPr id="732" name="Google Shape;732;p8"/>
          <p:cNvSpPr/>
          <p:nvPr/>
        </p:nvSpPr>
        <p:spPr>
          <a:xfrm>
            <a:off x="2964241" y="599158"/>
            <a:ext cx="2238152" cy="535117"/>
          </a:xfrm>
          <a:prstGeom prst="rect">
            <a:avLst/>
          </a:prstGeom>
          <a:solidFill>
            <a:srgbClr val="313F49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b="1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50,454</a:t>
            </a:r>
            <a:r>
              <a:rPr lang="en-US" sz="11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 LOT associated with TBx</a:t>
            </a:r>
            <a:endParaRPr sz="11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b="1" u="sng">
                <a:solidFill>
                  <a:schemeClr val="accent2"/>
                </a:solidFill>
                <a:latin typeface="Calibri"/>
                <a:ea typeface="Calibri"/>
                <a:cs typeface="Calibri"/>
                <a:sym typeface="Calibri"/>
              </a:rPr>
              <a:t>10,967 patients</a:t>
            </a:r>
            <a:endParaRPr/>
          </a:p>
        </p:txBody>
      </p:sp>
      <p:sp>
        <p:nvSpPr>
          <p:cNvPr id="733" name="Google Shape;733;p8"/>
          <p:cNvSpPr/>
          <p:nvPr/>
        </p:nvSpPr>
        <p:spPr>
          <a:xfrm>
            <a:off x="6687395" y="611747"/>
            <a:ext cx="2238152" cy="514113"/>
          </a:xfrm>
          <a:prstGeom prst="rect">
            <a:avLst/>
          </a:prstGeom>
          <a:solidFill>
            <a:srgbClr val="313F49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b="1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14,850</a:t>
            </a:r>
            <a:r>
              <a:rPr lang="en-US" sz="11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 LOT associated with LBx</a:t>
            </a:r>
            <a:endParaRPr sz="11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b="1" u="sng">
                <a:solidFill>
                  <a:schemeClr val="accent2"/>
                </a:solidFill>
                <a:latin typeface="Calibri"/>
                <a:ea typeface="Calibri"/>
                <a:cs typeface="Calibri"/>
                <a:sym typeface="Calibri"/>
              </a:rPr>
              <a:t>3,153 patients</a:t>
            </a:r>
            <a:endParaRPr/>
          </a:p>
        </p:txBody>
      </p:sp>
      <p:cxnSp>
        <p:nvCxnSpPr>
          <p:cNvPr id="734" name="Google Shape;734;p8"/>
          <p:cNvCxnSpPr>
            <a:stCxn id="733" idx="2"/>
            <a:endCxn id="716" idx="0"/>
          </p:cNvCxnSpPr>
          <p:nvPr/>
        </p:nvCxnSpPr>
        <p:spPr>
          <a:xfrm>
            <a:off x="7806471" y="1125860"/>
            <a:ext cx="0" cy="337800"/>
          </a:xfrm>
          <a:prstGeom prst="straightConnector1">
            <a:avLst/>
          </a:prstGeom>
          <a:noFill/>
          <a:ln w="9525" cap="flat" cmpd="sng">
            <a:solidFill>
              <a:schemeClr val="accent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735" name="Google Shape;735;p8"/>
          <p:cNvCxnSpPr/>
          <p:nvPr/>
        </p:nvCxnSpPr>
        <p:spPr>
          <a:xfrm>
            <a:off x="4122839" y="1078549"/>
            <a:ext cx="0" cy="379259"/>
          </a:xfrm>
          <a:prstGeom prst="straightConnector1">
            <a:avLst/>
          </a:prstGeom>
          <a:noFill/>
          <a:ln w="9525" cap="flat" cmpd="sng">
            <a:solidFill>
              <a:schemeClr val="accent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sp>
        <p:nvSpPr>
          <p:cNvPr id="738" name="Google Shape;738;p8"/>
          <p:cNvSpPr/>
          <p:nvPr/>
        </p:nvSpPr>
        <p:spPr>
          <a:xfrm>
            <a:off x="1086463" y="3668982"/>
            <a:ext cx="2690722" cy="483574"/>
          </a:xfrm>
          <a:prstGeom prst="rect">
            <a:avLst/>
          </a:prstGeom>
          <a:solidFill>
            <a:schemeClr val="lt1"/>
          </a:solidFill>
          <a:ln w="12700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00" u="sng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iltering (n=3626)</a:t>
            </a:r>
            <a:endParaRPr/>
          </a:p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2242 more than 60 days between specimen collection and line start</a:t>
            </a:r>
            <a:endParaRPr sz="700" u="sng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431 possible missing treatment information</a:t>
            </a:r>
            <a:endParaRPr/>
          </a:p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953 collected around 2+ line start</a:t>
            </a:r>
            <a:endParaRPr sz="9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739" name="Google Shape;739;p8"/>
          <p:cNvCxnSpPr/>
          <p:nvPr/>
        </p:nvCxnSpPr>
        <p:spPr>
          <a:xfrm>
            <a:off x="4059035" y="3539482"/>
            <a:ext cx="0" cy="621119"/>
          </a:xfrm>
          <a:prstGeom prst="straightConnector1">
            <a:avLst/>
          </a:prstGeom>
          <a:noFill/>
          <a:ln w="9525" cap="flat" cmpd="sng">
            <a:solidFill>
              <a:schemeClr val="accent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sp>
        <p:nvSpPr>
          <p:cNvPr id="740" name="Google Shape;740;p8"/>
          <p:cNvSpPr/>
          <p:nvPr/>
        </p:nvSpPr>
        <p:spPr>
          <a:xfrm>
            <a:off x="2925877" y="4190827"/>
            <a:ext cx="2238144" cy="509194"/>
          </a:xfrm>
          <a:prstGeom prst="rect">
            <a:avLst/>
          </a:prstGeom>
          <a:solidFill>
            <a:srgbClr val="313F49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b="1" u="sng">
                <a:solidFill>
                  <a:schemeClr val="accent2"/>
                </a:solidFill>
                <a:latin typeface="Calibri"/>
                <a:ea typeface="Calibri"/>
                <a:cs typeface="Calibri"/>
                <a:sym typeface="Calibri"/>
              </a:rPr>
              <a:t>2,154 patients</a:t>
            </a:r>
            <a:r>
              <a:rPr lang="en-US" sz="11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 with tissue specimens collected at 1</a:t>
            </a:r>
            <a:r>
              <a:rPr lang="en-US" sz="1100" baseline="300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st</a:t>
            </a:r>
            <a:r>
              <a:rPr lang="en-US" sz="11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 line</a:t>
            </a:r>
            <a:r>
              <a:rPr lang="en-US" sz="1100" baseline="300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endParaRPr sz="11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741" name="Google Shape;741;p8"/>
          <p:cNvSpPr/>
          <p:nvPr/>
        </p:nvSpPr>
        <p:spPr>
          <a:xfrm>
            <a:off x="1871112" y="4725709"/>
            <a:ext cx="1752397" cy="571827"/>
          </a:xfrm>
          <a:prstGeom prst="rect">
            <a:avLst/>
          </a:prstGeom>
          <a:solidFill>
            <a:schemeClr val="lt1"/>
          </a:solidFill>
          <a:ln w="12700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00" u="sng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iltering (n=1233)</a:t>
            </a:r>
            <a:endParaRPr dirty="0"/>
          </a:p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683 immortal time</a:t>
            </a:r>
            <a:endParaRPr dirty="0"/>
          </a:p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550 not receiving AI+CDK4/6i or Fulvestrant+CDK4/6i</a:t>
            </a:r>
            <a:endParaRPr sz="7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742" name="Google Shape;742;p8"/>
          <p:cNvSpPr/>
          <p:nvPr/>
        </p:nvSpPr>
        <p:spPr>
          <a:xfrm>
            <a:off x="2242679" y="5425698"/>
            <a:ext cx="1570413" cy="806593"/>
          </a:xfrm>
          <a:prstGeom prst="rect">
            <a:avLst/>
          </a:prstGeom>
          <a:solidFill>
            <a:srgbClr val="313F49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b="1" u="sng" dirty="0">
                <a:solidFill>
                  <a:schemeClr val="accent2"/>
                </a:solidFill>
                <a:latin typeface="Calibri"/>
                <a:ea typeface="Calibri"/>
                <a:cs typeface="Calibri"/>
                <a:sym typeface="Calibri"/>
              </a:rPr>
              <a:t>573 patients</a:t>
            </a:r>
            <a:r>
              <a:rPr lang="en-US" sz="1100" b="1" dirty="0">
                <a:solidFill>
                  <a:schemeClr val="accent2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n-US" sz="1100" b="1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receiving AI + CDK4/6i</a:t>
            </a:r>
            <a:endParaRPr sz="1100" b="1" dirty="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b="1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551 </a:t>
            </a:r>
            <a:r>
              <a:rPr lang="en-US" sz="1100" b="1" i="1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ESR1</a:t>
            </a:r>
            <a:r>
              <a:rPr lang="en-US" sz="1100" b="1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wt (96.2%)</a:t>
            </a:r>
            <a:endParaRPr dirty="0"/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b="1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22 </a:t>
            </a:r>
            <a:r>
              <a:rPr lang="en-US" sz="1100" b="1" i="1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ESR1</a:t>
            </a:r>
            <a:r>
              <a:rPr lang="en-US" sz="1100" b="1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mut (3.8%)</a:t>
            </a:r>
            <a:endParaRPr sz="1100" dirty="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743" name="Google Shape;743;p8"/>
          <p:cNvSpPr/>
          <p:nvPr/>
        </p:nvSpPr>
        <p:spPr>
          <a:xfrm>
            <a:off x="4231623" y="5441056"/>
            <a:ext cx="1560205" cy="823280"/>
          </a:xfrm>
          <a:prstGeom prst="rect">
            <a:avLst/>
          </a:prstGeom>
          <a:solidFill>
            <a:srgbClr val="313F49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b="1" u="sng" dirty="0">
                <a:solidFill>
                  <a:schemeClr val="accent2"/>
                </a:solidFill>
                <a:latin typeface="Calibri"/>
                <a:ea typeface="Calibri"/>
                <a:cs typeface="Calibri"/>
                <a:sym typeface="Calibri"/>
              </a:rPr>
              <a:t>348 patients</a:t>
            </a:r>
            <a:r>
              <a:rPr lang="en-US" sz="1100" b="1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 receiving </a:t>
            </a:r>
            <a:r>
              <a:rPr lang="en-US" sz="1100" b="1" dirty="0" err="1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Fulvestrant</a:t>
            </a:r>
            <a:r>
              <a:rPr lang="en-US" sz="1100" b="1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 + CDK4/6i</a:t>
            </a:r>
            <a:endParaRPr sz="1100" b="1" dirty="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b="1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289 </a:t>
            </a:r>
            <a:r>
              <a:rPr lang="en-US" sz="1100" b="1" i="1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ESR1</a:t>
            </a:r>
            <a:r>
              <a:rPr lang="en-US" sz="1100" b="1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wt (83.0%)</a:t>
            </a:r>
            <a:endParaRPr dirty="0"/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b="1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59 </a:t>
            </a:r>
            <a:r>
              <a:rPr lang="en-US" sz="1100" b="1" i="1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ESR1</a:t>
            </a:r>
            <a:r>
              <a:rPr lang="en-US" sz="1100" b="1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mut (17.0%)</a:t>
            </a:r>
            <a:endParaRPr sz="1100" dirty="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744" name="Google Shape;744;p8"/>
          <p:cNvSpPr txBox="1"/>
          <p:nvPr/>
        </p:nvSpPr>
        <p:spPr>
          <a:xfrm>
            <a:off x="2242679" y="6310613"/>
            <a:ext cx="3549149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ohort for outcomes analyses (</a:t>
            </a:r>
            <a:r>
              <a:rPr lang="en-US" sz="1200" i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able 1,</a:t>
            </a:r>
            <a:r>
              <a:rPr lang="en-US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en-US" sz="1200" i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ig. 4-5</a:t>
            </a:r>
            <a:r>
              <a:rPr lang="en-US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)</a:t>
            </a:r>
            <a:endParaRPr sz="1600" dirty="0"/>
          </a:p>
        </p:txBody>
      </p:sp>
      <p:cxnSp>
        <p:nvCxnSpPr>
          <p:cNvPr id="745" name="Google Shape;745;p8"/>
          <p:cNvCxnSpPr>
            <a:stCxn id="740" idx="2"/>
            <a:endCxn id="743" idx="1"/>
          </p:cNvCxnSpPr>
          <p:nvPr/>
        </p:nvCxnSpPr>
        <p:spPr>
          <a:xfrm rot="-5400000" flipH="1">
            <a:off x="3561949" y="5183021"/>
            <a:ext cx="1152600" cy="186600"/>
          </a:xfrm>
          <a:prstGeom prst="bentConnector2">
            <a:avLst/>
          </a:prstGeom>
          <a:noFill/>
          <a:ln w="9525" cap="flat" cmpd="sng">
            <a:solidFill>
              <a:schemeClr val="accent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746" name="Google Shape;746;p8"/>
          <p:cNvCxnSpPr/>
          <p:nvPr/>
        </p:nvCxnSpPr>
        <p:spPr>
          <a:xfrm rot="5400000">
            <a:off x="3364550" y="5168186"/>
            <a:ext cx="1128900" cy="231900"/>
          </a:xfrm>
          <a:prstGeom prst="bentConnector2">
            <a:avLst/>
          </a:prstGeom>
          <a:noFill/>
          <a:ln w="9525" cap="flat" cmpd="sng">
            <a:solidFill>
              <a:schemeClr val="accent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sp>
        <p:nvSpPr>
          <p:cNvPr id="747" name="Google Shape;747;p8"/>
          <p:cNvSpPr txBox="1"/>
          <p:nvPr/>
        </p:nvSpPr>
        <p:spPr>
          <a:xfrm>
            <a:off x="6488873" y="4684455"/>
            <a:ext cx="4718848" cy="15696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Montserrat"/>
              <a:buNone/>
            </a:pPr>
            <a:r>
              <a:rPr lang="en-US" sz="1200" b="1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SUPPLEMENTARY FIGURE S1: CONSORT chart.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800"/>
              <a:buFont typeface="Montserrat"/>
              <a:buNone/>
            </a:pPr>
            <a:r>
              <a:rPr lang="en-US" sz="12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*For </a:t>
            </a:r>
            <a:r>
              <a:rPr lang="en-US" sz="1200" i="1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ESR1</a:t>
            </a:r>
            <a:r>
              <a:rPr lang="en-US" sz="12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 spectrum analysis selected the latest specimen collected. For the </a:t>
            </a:r>
            <a:r>
              <a:rPr lang="en-US" sz="1200" i="1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ESR1</a:t>
            </a:r>
            <a:r>
              <a:rPr lang="en-US" sz="12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mut prevalence analysis selected LOT and specimen with closest collection date;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800"/>
              <a:buFont typeface="Montserrat"/>
              <a:buNone/>
            </a:pPr>
            <a:r>
              <a:rPr lang="en-US" sz="12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AI: aromatase inhibitors; BC: breast cancer; CDK4/6i: CDK 4/6 inhibitors; CGP: comprehensive genomic profiling; HR: hormone receptor; LBx: liquid biopsy; LOT: line of therapy; TBx: tissue biopsy; TF: tumor fraction.</a:t>
            </a:r>
            <a:endParaRPr sz="1200" dirty="0">
              <a:solidFill>
                <a:schemeClr val="dk1"/>
              </a:solidFill>
              <a:latin typeface="Arial" panose="020B0604020202020204" pitchFamily="34" charset="0"/>
              <a:ea typeface="Arial"/>
              <a:cs typeface="Arial" panose="020B0604020202020204" pitchFamily="34" charset="0"/>
              <a:sym typeface="Arial"/>
            </a:endParaRPr>
          </a:p>
        </p:txBody>
      </p:sp>
      <p:sp>
        <p:nvSpPr>
          <p:cNvPr id="748" name="Google Shape;748;p8"/>
          <p:cNvSpPr/>
          <p:nvPr/>
        </p:nvSpPr>
        <p:spPr>
          <a:xfrm>
            <a:off x="9940413" y="6145161"/>
            <a:ext cx="1710813" cy="629265"/>
          </a:xfrm>
          <a:prstGeom prst="rect">
            <a:avLst/>
          </a:prstGeom>
          <a:solidFill>
            <a:schemeClr val="lt1"/>
          </a:solidFill>
          <a:ln w="1270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2000">
              <a:solidFill>
                <a:schemeClr val="lt2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75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53" name="Google Shape;753;p9" descr="A graph with orange bars&#10;&#10;Description automatically generated"/>
          <p:cNvPicPr preferRelativeResize="0"/>
          <p:nvPr/>
        </p:nvPicPr>
        <p:blipFill rotWithShape="1">
          <a:blip r:embed="rId3">
            <a:alphaModFix/>
          </a:blip>
          <a:srcRect t="14047"/>
          <a:stretch/>
        </p:blipFill>
        <p:spPr>
          <a:xfrm>
            <a:off x="2716576" y="3937963"/>
            <a:ext cx="4486024" cy="2699084"/>
          </a:xfrm>
          <a:prstGeom prst="rect">
            <a:avLst/>
          </a:prstGeom>
          <a:noFill/>
          <a:ln>
            <a:noFill/>
          </a:ln>
        </p:spPr>
      </p:pic>
      <p:pic>
        <p:nvPicPr>
          <p:cNvPr id="754" name="Google Shape;754;p9" descr="A graph with blue and green bars&#10;&#10;Description automatically generated"/>
          <p:cNvPicPr preferRelativeResize="0"/>
          <p:nvPr/>
        </p:nvPicPr>
        <p:blipFill rotWithShape="1">
          <a:blip r:embed="rId4">
            <a:alphaModFix/>
          </a:blip>
          <a:srcRect t="14204"/>
          <a:stretch/>
        </p:blipFill>
        <p:spPr>
          <a:xfrm>
            <a:off x="2626401" y="546095"/>
            <a:ext cx="4613298" cy="2770606"/>
          </a:xfrm>
          <a:prstGeom prst="rect">
            <a:avLst/>
          </a:prstGeom>
          <a:noFill/>
          <a:ln>
            <a:noFill/>
          </a:ln>
        </p:spPr>
      </p:pic>
      <p:pic>
        <p:nvPicPr>
          <p:cNvPr id="755" name="Google Shape;755;p9" descr="A graph of a number of cells&#10;&#10;Description automatically generated with medium confidence"/>
          <p:cNvPicPr preferRelativeResize="0"/>
          <p:nvPr/>
        </p:nvPicPr>
        <p:blipFill rotWithShape="1">
          <a:blip r:embed="rId5">
            <a:alphaModFix/>
          </a:blip>
          <a:srcRect t="13481"/>
          <a:stretch/>
        </p:blipFill>
        <p:spPr>
          <a:xfrm>
            <a:off x="7517518" y="1151967"/>
            <a:ext cx="3040750" cy="1841570"/>
          </a:xfrm>
          <a:prstGeom prst="rect">
            <a:avLst/>
          </a:prstGeom>
          <a:noFill/>
          <a:ln>
            <a:noFill/>
          </a:ln>
        </p:spPr>
      </p:pic>
      <p:sp>
        <p:nvSpPr>
          <p:cNvPr id="756" name="Google Shape;756;p9"/>
          <p:cNvSpPr/>
          <p:nvPr/>
        </p:nvSpPr>
        <p:spPr>
          <a:xfrm>
            <a:off x="9790098" y="6190129"/>
            <a:ext cx="1954306" cy="461390"/>
          </a:xfrm>
          <a:prstGeom prst="rect">
            <a:avLst/>
          </a:prstGeom>
          <a:solidFill>
            <a:schemeClr val="lt1"/>
          </a:solidFill>
          <a:ln w="1270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2000">
              <a:solidFill>
                <a:schemeClr val="lt2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757" name="Google Shape;757;p9"/>
          <p:cNvSpPr txBox="1"/>
          <p:nvPr/>
        </p:nvSpPr>
        <p:spPr>
          <a:xfrm>
            <a:off x="767877" y="290382"/>
            <a:ext cx="9234766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A) </a:t>
            </a:r>
            <a:r>
              <a:rPr lang="en-US" sz="1200" b="1" i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ESR1</a:t>
            </a:r>
            <a:r>
              <a:rPr lang="en-US" sz="12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mutations detected in TBx of HR(+)HER2(-) mBC (n=1,002/5,780)</a:t>
            </a:r>
            <a:endParaRPr/>
          </a:p>
        </p:txBody>
      </p:sp>
      <p:sp>
        <p:nvSpPr>
          <p:cNvPr id="758" name="Google Shape;758;p9"/>
          <p:cNvSpPr txBox="1"/>
          <p:nvPr/>
        </p:nvSpPr>
        <p:spPr>
          <a:xfrm>
            <a:off x="618565" y="3673309"/>
            <a:ext cx="9234765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B) </a:t>
            </a:r>
            <a:r>
              <a:rPr lang="en-US" sz="1200" b="1" i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ESR1</a:t>
            </a:r>
            <a:r>
              <a:rPr lang="en-US" sz="12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mutations detected in LBx of HR(+)HER2(-) mBC (n=503/1,670) </a:t>
            </a:r>
            <a:endParaRPr/>
          </a:p>
        </p:txBody>
      </p:sp>
      <p:sp>
        <p:nvSpPr>
          <p:cNvPr id="759" name="Google Shape;759;p9"/>
          <p:cNvSpPr txBox="1"/>
          <p:nvPr/>
        </p:nvSpPr>
        <p:spPr>
          <a:xfrm>
            <a:off x="10767251" y="5265296"/>
            <a:ext cx="1063763" cy="83099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6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*Other LBD indels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4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L536_Y537&gt;S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4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G344_L345insC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4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Y537_D538insY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4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L536_D538&gt;P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4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N532_L536&gt;I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4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Y537del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4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L536_Y537&gt;S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4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Y328_S329del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4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209del</a:t>
            </a:r>
            <a:endParaRPr/>
          </a:p>
        </p:txBody>
      </p:sp>
      <p:sp>
        <p:nvSpPr>
          <p:cNvPr id="760" name="Google Shape;760;p9"/>
          <p:cNvSpPr/>
          <p:nvPr/>
        </p:nvSpPr>
        <p:spPr>
          <a:xfrm>
            <a:off x="7182018" y="1136071"/>
            <a:ext cx="285274" cy="1701208"/>
          </a:xfrm>
          <a:prstGeom prst="leftBrace">
            <a:avLst>
              <a:gd name="adj1" fmla="val 8333"/>
              <a:gd name="adj2" fmla="val 88744"/>
            </a:avLst>
          </a:prstGeom>
          <a:noFill/>
          <a:ln w="9525" cap="flat" cmpd="sng">
            <a:solidFill>
              <a:schemeClr val="accent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761" name="Google Shape;761;p9"/>
          <p:cNvSpPr/>
          <p:nvPr/>
        </p:nvSpPr>
        <p:spPr>
          <a:xfrm>
            <a:off x="7139335" y="4341151"/>
            <a:ext cx="285274" cy="1701208"/>
          </a:xfrm>
          <a:prstGeom prst="leftBrace">
            <a:avLst>
              <a:gd name="adj1" fmla="val 8333"/>
              <a:gd name="adj2" fmla="val 80969"/>
            </a:avLst>
          </a:prstGeom>
          <a:noFill/>
          <a:ln w="9525" cap="flat" cmpd="sng">
            <a:solidFill>
              <a:schemeClr val="accent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762" name="Google Shape;762;p9"/>
          <p:cNvSpPr txBox="1"/>
          <p:nvPr/>
        </p:nvSpPr>
        <p:spPr>
          <a:xfrm>
            <a:off x="10051804" y="6204629"/>
            <a:ext cx="1723549" cy="33855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800">
                <a:solidFill>
                  <a:srgbClr val="FF0000"/>
                </a:solidFill>
                <a:latin typeface="Arial"/>
                <a:ea typeface="Arial"/>
                <a:cs typeface="Arial"/>
                <a:sym typeface="Arial"/>
              </a:rPr>
              <a:t>Elacestrant CDx variants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8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Other activating </a:t>
            </a:r>
            <a:r>
              <a:rPr lang="en-US" sz="800" i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ESR1</a:t>
            </a:r>
            <a:r>
              <a:rPr lang="en-US" sz="8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variants</a:t>
            </a:r>
            <a:endParaRPr/>
          </a:p>
        </p:txBody>
      </p:sp>
      <p:sp>
        <p:nvSpPr>
          <p:cNvPr id="763" name="Google Shape;763;p9"/>
          <p:cNvSpPr/>
          <p:nvPr/>
        </p:nvSpPr>
        <p:spPr>
          <a:xfrm>
            <a:off x="618565" y="6373906"/>
            <a:ext cx="1954306" cy="367553"/>
          </a:xfrm>
          <a:prstGeom prst="rect">
            <a:avLst/>
          </a:prstGeom>
          <a:solidFill>
            <a:schemeClr val="lt1"/>
          </a:solidFill>
          <a:ln w="1270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2000">
              <a:solidFill>
                <a:schemeClr val="lt2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764" name="Google Shape;764;p9"/>
          <p:cNvPicPr preferRelativeResize="0"/>
          <p:nvPr/>
        </p:nvPicPr>
        <p:blipFill rotWithShape="1">
          <a:blip r:embed="rId6">
            <a:alphaModFix/>
          </a:blip>
          <a:srcRect/>
          <a:stretch/>
        </p:blipFill>
        <p:spPr>
          <a:xfrm>
            <a:off x="8621933" y="184951"/>
            <a:ext cx="738880" cy="559674"/>
          </a:xfrm>
          <a:prstGeom prst="rect">
            <a:avLst/>
          </a:prstGeom>
          <a:noFill/>
          <a:ln>
            <a:noFill/>
          </a:ln>
        </p:spPr>
      </p:pic>
      <p:pic>
        <p:nvPicPr>
          <p:cNvPr id="765" name="Google Shape;765;p9"/>
          <p:cNvPicPr preferRelativeResize="0"/>
          <p:nvPr/>
        </p:nvPicPr>
        <p:blipFill rotWithShape="1">
          <a:blip r:embed="rId7">
            <a:alphaModFix/>
          </a:blip>
          <a:srcRect/>
          <a:stretch/>
        </p:blipFill>
        <p:spPr>
          <a:xfrm>
            <a:off x="8736024" y="3627140"/>
            <a:ext cx="301869" cy="621647"/>
          </a:xfrm>
          <a:prstGeom prst="rect">
            <a:avLst/>
          </a:prstGeom>
          <a:noFill/>
          <a:ln>
            <a:noFill/>
          </a:ln>
        </p:spPr>
      </p:pic>
      <p:sp>
        <p:nvSpPr>
          <p:cNvPr id="766" name="Google Shape;766;p9"/>
          <p:cNvSpPr txBox="1"/>
          <p:nvPr/>
        </p:nvSpPr>
        <p:spPr>
          <a:xfrm>
            <a:off x="282408" y="833465"/>
            <a:ext cx="2116663" cy="20928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Montserrat"/>
              <a:buNone/>
            </a:pPr>
            <a:r>
              <a:rPr lang="en-US" sz="1100" b="1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SUPPLEMENTARY FIGURE S2: Spectrum of </a:t>
            </a:r>
            <a:r>
              <a:rPr lang="en-US" sz="1100" b="1" i="1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ESR1</a:t>
            </a:r>
            <a:r>
              <a:rPr lang="en-US" sz="1100" b="1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 activating mutations detected in tissue and liquid specimens of HR(+)HER2(-) metastatic breast cancer patients.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Montserrat"/>
              <a:buNone/>
            </a:pPr>
            <a:r>
              <a:rPr lang="en-US" sz="1100" i="1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ESR1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 mutations detected in TBx (A) and LBx (B)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  <a:sym typeface="Montserrat"/>
              </a:rPr>
              <a:t> </a:t>
            </a:r>
            <a:r>
              <a:rPr lang="en-US" sz="8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HR: hormone receptor; LBx: liquid biopsy; </a:t>
            </a:r>
            <a:r>
              <a:rPr lang="en-US" sz="800" dirty="0" err="1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mBC</a:t>
            </a:r>
            <a:r>
              <a:rPr lang="en-US" sz="8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: metastatic breast cancer; TBx: tissue biopsy.</a:t>
            </a:r>
            <a:endParaRPr sz="900" dirty="0">
              <a:solidFill>
                <a:schemeClr val="dk1"/>
              </a:solidFill>
              <a:latin typeface="Arial" panose="020B0604020202020204" pitchFamily="34" charset="0"/>
              <a:ea typeface="Arial"/>
              <a:cs typeface="Arial" panose="020B0604020202020204" pitchFamily="34" charset="0"/>
              <a:sym typeface="Arial"/>
            </a:endParaRPr>
          </a:p>
        </p:txBody>
      </p:sp>
      <p:pic>
        <p:nvPicPr>
          <p:cNvPr id="767" name="Google Shape;767;p9" descr="A graph with numbers and letters&#10;&#10;Description automatically generated"/>
          <p:cNvPicPr preferRelativeResize="0"/>
          <p:nvPr/>
        </p:nvPicPr>
        <p:blipFill rotWithShape="1">
          <a:blip r:embed="rId8">
            <a:alphaModFix/>
          </a:blip>
          <a:srcRect t="15293"/>
          <a:stretch/>
        </p:blipFill>
        <p:spPr>
          <a:xfrm>
            <a:off x="7408655" y="4384100"/>
            <a:ext cx="2782311" cy="1649771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77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2" name="Google Shape;772;p10"/>
          <p:cNvSpPr txBox="1"/>
          <p:nvPr/>
        </p:nvSpPr>
        <p:spPr>
          <a:xfrm>
            <a:off x="226032" y="833465"/>
            <a:ext cx="2173040" cy="195434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Montserrat"/>
              <a:buNone/>
            </a:pPr>
            <a:r>
              <a:rPr lang="en-US" sz="1100" b="1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SUPPLEMENTARY FIGURE S3: Spectrum of </a:t>
            </a:r>
            <a:r>
              <a:rPr lang="en-US" sz="1100" b="1" i="1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PIK3CA mutations </a:t>
            </a:r>
            <a:r>
              <a:rPr lang="en-US" sz="1100" b="1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detected in tissue and liquid specimens of HR(+)HER2(-) metastatic breast cancer patients.</a:t>
            </a:r>
            <a:endParaRPr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Montserrat"/>
              <a:buNone/>
            </a:pPr>
            <a:r>
              <a:rPr lang="en-US" sz="1100" i="1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PIK3CA 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mutations detected in TBx (A) and LBx (B). HR: hormone receptor; LBx: liquid biopsy; </a:t>
            </a:r>
            <a:r>
              <a:rPr lang="en-US" sz="1100" dirty="0" err="1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mBC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: metastatic breast cancer; TBx: tissue biopsy.</a:t>
            </a:r>
            <a:endParaRPr sz="1100" dirty="0">
              <a:solidFill>
                <a:schemeClr val="dk1"/>
              </a:solidFill>
              <a:latin typeface="Arial" panose="020B0604020202020204" pitchFamily="34" charset="0"/>
              <a:ea typeface="Arial"/>
              <a:cs typeface="Arial" panose="020B0604020202020204" pitchFamily="34" charset="0"/>
              <a:sym typeface="Arial"/>
            </a:endParaRPr>
          </a:p>
        </p:txBody>
      </p:sp>
      <p:sp>
        <p:nvSpPr>
          <p:cNvPr id="773" name="Google Shape;773;p10"/>
          <p:cNvSpPr txBox="1"/>
          <p:nvPr/>
        </p:nvSpPr>
        <p:spPr>
          <a:xfrm>
            <a:off x="969045" y="262950"/>
            <a:ext cx="9234766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A) </a:t>
            </a:r>
            <a:r>
              <a:rPr lang="en-US" sz="1200" b="1" i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IK3CA</a:t>
            </a:r>
            <a:r>
              <a:rPr lang="en-US" sz="12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mutations detected in TBx of HR(+)HER2(-) mBC (n=2,442/5,780)</a:t>
            </a:r>
            <a:endParaRPr/>
          </a:p>
        </p:txBody>
      </p:sp>
      <p:sp>
        <p:nvSpPr>
          <p:cNvPr id="774" name="Google Shape;774;p10"/>
          <p:cNvSpPr txBox="1"/>
          <p:nvPr/>
        </p:nvSpPr>
        <p:spPr>
          <a:xfrm>
            <a:off x="874597" y="3639308"/>
            <a:ext cx="9234765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B) </a:t>
            </a:r>
            <a:r>
              <a:rPr lang="en-US" sz="1200" b="1" i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IK3CA</a:t>
            </a:r>
            <a:r>
              <a:rPr lang="en-US" sz="12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mutations detected in LBx of HR(+)HER2(-) mBC (n=564/1,670) </a:t>
            </a:r>
            <a:endParaRPr/>
          </a:p>
        </p:txBody>
      </p:sp>
      <p:pic>
        <p:nvPicPr>
          <p:cNvPr id="775" name="Google Shape;775;p10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9042557" y="163294"/>
            <a:ext cx="738880" cy="559674"/>
          </a:xfrm>
          <a:prstGeom prst="rect">
            <a:avLst/>
          </a:prstGeom>
          <a:noFill/>
          <a:ln>
            <a:noFill/>
          </a:ln>
        </p:spPr>
      </p:pic>
      <p:pic>
        <p:nvPicPr>
          <p:cNvPr id="776" name="Google Shape;776;p10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9156648" y="3605483"/>
            <a:ext cx="301869" cy="621647"/>
          </a:xfrm>
          <a:prstGeom prst="rect">
            <a:avLst/>
          </a:prstGeom>
          <a:noFill/>
          <a:ln>
            <a:noFill/>
          </a:ln>
        </p:spPr>
      </p:pic>
      <p:pic>
        <p:nvPicPr>
          <p:cNvPr id="777" name="Google Shape;777;p10" descr="A graph of a number of blue squares&#10;&#10;Description automatically generated with medium confidence"/>
          <p:cNvPicPr preferRelativeResize="0"/>
          <p:nvPr/>
        </p:nvPicPr>
        <p:blipFill rotWithShape="1">
          <a:blip r:embed="rId5">
            <a:alphaModFix/>
          </a:blip>
          <a:srcRect t="13288"/>
          <a:stretch/>
        </p:blipFill>
        <p:spPr>
          <a:xfrm>
            <a:off x="2433277" y="607599"/>
            <a:ext cx="4994722" cy="3031709"/>
          </a:xfrm>
          <a:prstGeom prst="rect">
            <a:avLst/>
          </a:prstGeom>
          <a:noFill/>
          <a:ln>
            <a:noFill/>
          </a:ln>
        </p:spPr>
      </p:pic>
      <p:pic>
        <p:nvPicPr>
          <p:cNvPr id="778" name="Google Shape;778;p10" descr="A graph with a number of blue and green bars&#10;&#10;Description automatically generated"/>
          <p:cNvPicPr preferRelativeResize="0"/>
          <p:nvPr/>
        </p:nvPicPr>
        <p:blipFill rotWithShape="1">
          <a:blip r:embed="rId6">
            <a:alphaModFix/>
          </a:blip>
          <a:srcRect t="12566"/>
          <a:stretch/>
        </p:blipFill>
        <p:spPr>
          <a:xfrm>
            <a:off x="7726680" y="822624"/>
            <a:ext cx="4341627" cy="2214373"/>
          </a:xfrm>
          <a:prstGeom prst="rect">
            <a:avLst/>
          </a:prstGeom>
          <a:noFill/>
          <a:ln>
            <a:noFill/>
          </a:ln>
        </p:spPr>
      </p:pic>
      <p:sp>
        <p:nvSpPr>
          <p:cNvPr id="779" name="Google Shape;779;p10"/>
          <p:cNvSpPr/>
          <p:nvPr/>
        </p:nvSpPr>
        <p:spPr>
          <a:xfrm>
            <a:off x="7450527" y="826855"/>
            <a:ext cx="276153" cy="1991727"/>
          </a:xfrm>
          <a:prstGeom prst="leftBrace">
            <a:avLst>
              <a:gd name="adj1" fmla="val 8333"/>
              <a:gd name="adj2" fmla="val 59048"/>
            </a:avLst>
          </a:prstGeom>
          <a:noFill/>
          <a:ln w="9525" cap="flat" cmpd="sng">
            <a:solidFill>
              <a:schemeClr val="accent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780" name="Google Shape;780;p10" descr="A graph with orange bars&#10;&#10;Description automatically generated"/>
          <p:cNvPicPr preferRelativeResize="0"/>
          <p:nvPr/>
        </p:nvPicPr>
        <p:blipFill rotWithShape="1">
          <a:blip r:embed="rId7">
            <a:alphaModFix/>
          </a:blip>
          <a:srcRect t="14571"/>
          <a:stretch/>
        </p:blipFill>
        <p:spPr>
          <a:xfrm>
            <a:off x="2568471" y="3882480"/>
            <a:ext cx="4888064" cy="2923053"/>
          </a:xfrm>
          <a:prstGeom prst="rect">
            <a:avLst/>
          </a:prstGeom>
          <a:noFill/>
          <a:ln>
            <a:noFill/>
          </a:ln>
        </p:spPr>
      </p:pic>
      <p:sp>
        <p:nvSpPr>
          <p:cNvPr id="781" name="Google Shape;781;p10"/>
          <p:cNvSpPr/>
          <p:nvPr/>
        </p:nvSpPr>
        <p:spPr>
          <a:xfrm>
            <a:off x="7450527" y="4456973"/>
            <a:ext cx="276153" cy="1991727"/>
          </a:xfrm>
          <a:prstGeom prst="leftBrace">
            <a:avLst>
              <a:gd name="adj1" fmla="val 8333"/>
              <a:gd name="adj2" fmla="val 33083"/>
            </a:avLst>
          </a:prstGeom>
          <a:noFill/>
          <a:ln w="9525" cap="flat" cmpd="sng">
            <a:solidFill>
              <a:schemeClr val="accent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782" name="Google Shape;782;p10" descr="A graph with orange bars&#10;&#10;Description automatically generated"/>
          <p:cNvPicPr preferRelativeResize="0"/>
          <p:nvPr/>
        </p:nvPicPr>
        <p:blipFill rotWithShape="1">
          <a:blip r:embed="rId8">
            <a:alphaModFix/>
          </a:blip>
          <a:srcRect t="12662"/>
          <a:stretch/>
        </p:blipFill>
        <p:spPr>
          <a:xfrm>
            <a:off x="7833194" y="4456973"/>
            <a:ext cx="3250645" cy="1987339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78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87" name="Google Shape;787;p11" descr="A graph of a number of blue and green cells&#10;&#10;Description automatically generated with medium confidence"/>
          <p:cNvPicPr preferRelativeResize="0"/>
          <p:nvPr/>
        </p:nvPicPr>
        <p:blipFill rotWithShape="1">
          <a:blip r:embed="rId3">
            <a:alphaModFix/>
          </a:blip>
          <a:srcRect t="13288"/>
          <a:stretch/>
        </p:blipFill>
        <p:spPr>
          <a:xfrm>
            <a:off x="5100359" y="739881"/>
            <a:ext cx="4804651" cy="2916339"/>
          </a:xfrm>
          <a:prstGeom prst="rect">
            <a:avLst/>
          </a:prstGeom>
          <a:noFill/>
          <a:ln>
            <a:noFill/>
          </a:ln>
        </p:spPr>
      </p:pic>
      <p:sp>
        <p:nvSpPr>
          <p:cNvPr id="788" name="Google Shape;788;p11"/>
          <p:cNvSpPr txBox="1"/>
          <p:nvPr/>
        </p:nvSpPr>
        <p:spPr>
          <a:xfrm>
            <a:off x="195209" y="833465"/>
            <a:ext cx="2486346" cy="1615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Montserrat"/>
              <a:buNone/>
            </a:pPr>
            <a:r>
              <a:rPr lang="en-US" sz="1100" b="1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SUPPLEMENTARY FIGURE S4: Spectrum of </a:t>
            </a:r>
            <a:r>
              <a:rPr lang="en-US" sz="1100" b="1" i="1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AKT1 </a:t>
            </a:r>
            <a:r>
              <a:rPr lang="en-US" sz="1100" b="1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mutations detected in tissue and liquid specimens of HR(+)HER2(-) metastatic breast cancer patients.</a:t>
            </a:r>
            <a:endParaRPr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Montserrat"/>
              <a:buNone/>
            </a:pPr>
            <a:r>
              <a:rPr lang="en-US" sz="1100" i="1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AKT1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 mutations detected in TBx (A) and LBx (B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  <a:sym typeface="Montserrat"/>
              </a:rPr>
              <a:t>. 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HR: hormone receptor; LBx: liquid biopsy; </a:t>
            </a:r>
            <a:r>
              <a:rPr lang="en-US" sz="1100" dirty="0" err="1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mBC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: metastatic breast cancer; TBx: tissue biopsy.</a:t>
            </a:r>
            <a:endParaRPr sz="1100" dirty="0">
              <a:solidFill>
                <a:schemeClr val="dk1"/>
              </a:solidFill>
              <a:latin typeface="Arial" panose="020B0604020202020204" pitchFamily="34" charset="0"/>
              <a:ea typeface="Arial"/>
              <a:cs typeface="Arial" panose="020B0604020202020204" pitchFamily="34" charset="0"/>
              <a:sym typeface="Arial"/>
            </a:endParaRPr>
          </a:p>
        </p:txBody>
      </p:sp>
      <p:sp>
        <p:nvSpPr>
          <p:cNvPr id="789" name="Google Shape;789;p11"/>
          <p:cNvSpPr txBox="1"/>
          <p:nvPr/>
        </p:nvSpPr>
        <p:spPr>
          <a:xfrm>
            <a:off x="969045" y="262950"/>
            <a:ext cx="9234766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A) </a:t>
            </a:r>
            <a:r>
              <a:rPr lang="en-US" sz="1200" b="1" i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KT1</a:t>
            </a:r>
            <a:r>
              <a:rPr lang="en-US" sz="12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mutations detected in TBx of HR(+)HER2(-) mBC (n=289/5,780)</a:t>
            </a:r>
            <a:endParaRPr/>
          </a:p>
        </p:txBody>
      </p:sp>
      <p:sp>
        <p:nvSpPr>
          <p:cNvPr id="790" name="Google Shape;790;p11"/>
          <p:cNvSpPr txBox="1"/>
          <p:nvPr/>
        </p:nvSpPr>
        <p:spPr>
          <a:xfrm>
            <a:off x="874597" y="3639308"/>
            <a:ext cx="9234765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B) </a:t>
            </a:r>
            <a:r>
              <a:rPr lang="en-US" sz="1200" b="1" i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KT1</a:t>
            </a:r>
            <a:r>
              <a:rPr lang="en-US" sz="12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mutations detected in LBx of HR(+)HER2(-) mBC (n=70/1,670) </a:t>
            </a:r>
            <a:endParaRPr/>
          </a:p>
        </p:txBody>
      </p:sp>
      <p:pic>
        <p:nvPicPr>
          <p:cNvPr id="791" name="Google Shape;791;p11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9042557" y="163294"/>
            <a:ext cx="738880" cy="559674"/>
          </a:xfrm>
          <a:prstGeom prst="rect">
            <a:avLst/>
          </a:prstGeom>
          <a:noFill/>
          <a:ln>
            <a:noFill/>
          </a:ln>
        </p:spPr>
      </p:pic>
      <p:pic>
        <p:nvPicPr>
          <p:cNvPr id="792" name="Google Shape;792;p11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9156648" y="3622417"/>
            <a:ext cx="301869" cy="621647"/>
          </a:xfrm>
          <a:prstGeom prst="rect">
            <a:avLst/>
          </a:prstGeom>
          <a:noFill/>
          <a:ln>
            <a:noFill/>
          </a:ln>
        </p:spPr>
      </p:pic>
      <p:pic>
        <p:nvPicPr>
          <p:cNvPr id="793" name="Google Shape;793;p11" descr="A graph with a bar and a number of numbers&#10;&#10;Description automatically generated with medium confidence"/>
          <p:cNvPicPr preferRelativeResize="0"/>
          <p:nvPr/>
        </p:nvPicPr>
        <p:blipFill rotWithShape="1">
          <a:blip r:embed="rId6">
            <a:alphaModFix/>
          </a:blip>
          <a:srcRect t="13381"/>
          <a:stretch/>
        </p:blipFill>
        <p:spPr>
          <a:xfrm>
            <a:off x="3070043" y="539949"/>
            <a:ext cx="1865555" cy="2827884"/>
          </a:xfrm>
          <a:prstGeom prst="rect">
            <a:avLst/>
          </a:prstGeom>
          <a:noFill/>
          <a:ln>
            <a:noFill/>
          </a:ln>
        </p:spPr>
      </p:pic>
      <p:sp>
        <p:nvSpPr>
          <p:cNvPr id="794" name="Google Shape;794;p11"/>
          <p:cNvSpPr/>
          <p:nvPr/>
        </p:nvSpPr>
        <p:spPr>
          <a:xfrm>
            <a:off x="4853212" y="722968"/>
            <a:ext cx="247147" cy="2681183"/>
          </a:xfrm>
          <a:prstGeom prst="leftBrace">
            <a:avLst>
              <a:gd name="adj1" fmla="val 8333"/>
              <a:gd name="adj2" fmla="val 72521"/>
            </a:avLst>
          </a:prstGeom>
          <a:noFill/>
          <a:ln w="9525" cap="flat" cmpd="sng">
            <a:solidFill>
              <a:schemeClr val="accent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795" name="Google Shape;795;p11" descr="A graph with a bar and a number of numbers&#10;&#10;Description automatically generated with medium confidence"/>
          <p:cNvPicPr preferRelativeResize="0"/>
          <p:nvPr/>
        </p:nvPicPr>
        <p:blipFill rotWithShape="1">
          <a:blip r:embed="rId7">
            <a:alphaModFix/>
          </a:blip>
          <a:srcRect t="13949"/>
          <a:stretch/>
        </p:blipFill>
        <p:spPr>
          <a:xfrm>
            <a:off x="3070043" y="3972463"/>
            <a:ext cx="1888133" cy="2843271"/>
          </a:xfrm>
          <a:prstGeom prst="rect">
            <a:avLst/>
          </a:prstGeom>
          <a:noFill/>
          <a:ln>
            <a:noFill/>
          </a:ln>
        </p:spPr>
      </p:pic>
      <p:pic>
        <p:nvPicPr>
          <p:cNvPr id="796" name="Google Shape;796;p11" descr="A graph with orange squares&#10;&#10;Description automatically generated with medium confidence"/>
          <p:cNvPicPr preferRelativeResize="0"/>
          <p:nvPr/>
        </p:nvPicPr>
        <p:blipFill rotWithShape="1">
          <a:blip r:embed="rId8">
            <a:alphaModFix/>
          </a:blip>
          <a:srcRect t="11756"/>
          <a:stretch/>
        </p:blipFill>
        <p:spPr>
          <a:xfrm>
            <a:off x="5299025" y="4377880"/>
            <a:ext cx="3857623" cy="2382885"/>
          </a:xfrm>
          <a:prstGeom prst="rect">
            <a:avLst/>
          </a:prstGeom>
          <a:noFill/>
          <a:ln>
            <a:noFill/>
          </a:ln>
        </p:spPr>
      </p:pic>
      <p:sp>
        <p:nvSpPr>
          <p:cNvPr id="797" name="Google Shape;797;p11"/>
          <p:cNvSpPr/>
          <p:nvPr/>
        </p:nvSpPr>
        <p:spPr>
          <a:xfrm>
            <a:off x="4922090" y="4244064"/>
            <a:ext cx="178269" cy="2311584"/>
          </a:xfrm>
          <a:prstGeom prst="leftBrace">
            <a:avLst>
              <a:gd name="adj1" fmla="val 8333"/>
              <a:gd name="adj2" fmla="val 77012"/>
            </a:avLst>
          </a:prstGeom>
          <a:noFill/>
          <a:ln w="9525" cap="flat" cmpd="sng">
            <a:solidFill>
              <a:schemeClr val="accent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0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2" name="Google Shape;802;p12"/>
          <p:cNvSpPr txBox="1"/>
          <p:nvPr/>
        </p:nvSpPr>
        <p:spPr>
          <a:xfrm>
            <a:off x="184935" y="1630322"/>
            <a:ext cx="2511706" cy="212361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Montserrat"/>
              <a:buNone/>
            </a:pPr>
            <a:r>
              <a:rPr lang="en-US" sz="1100" b="1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SUPPLEMENTARY FIGURE S5: Spectrum of </a:t>
            </a:r>
            <a:r>
              <a:rPr lang="en-US" sz="1100" b="1" i="1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PTEN </a:t>
            </a:r>
            <a:r>
              <a:rPr lang="en-US" sz="1100" b="1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deactivating alterations (mutations, copy loss, and rearrangements) detected in tissue and liquid specimens of HR(+)HER2(-) metastatic breast cancer patients.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Montserrat"/>
              <a:buNone/>
            </a:pPr>
            <a:r>
              <a:rPr lang="en-US" sz="1100" i="1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PTEN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 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Montserrat"/>
              </a:rPr>
              <a:t>GAs detected in TBx (A) and LBx (B). GAs: genomic alterations; HR: hormone receptor; LBx: liquid biopsy; </a:t>
            </a:r>
            <a:r>
              <a:rPr lang="en-US" sz="1100" dirty="0" err="1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Montserrat"/>
              </a:rPr>
              <a:t>mBC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Montserrat"/>
              </a:rPr>
              <a:t>: metastatic breast cancer; TBx: tissue biopsy.</a:t>
            </a:r>
            <a:endParaRPr sz="1100" dirty="0">
              <a:solidFill>
                <a:schemeClr val="dk1"/>
              </a:solidFill>
              <a:latin typeface="Arial" panose="020B0604020202020204" pitchFamily="34" charset="0"/>
              <a:cs typeface="Arial" panose="020B0604020202020204" pitchFamily="34" charset="0"/>
              <a:sym typeface="Arial"/>
            </a:endParaRPr>
          </a:p>
        </p:txBody>
      </p:sp>
      <p:sp>
        <p:nvSpPr>
          <p:cNvPr id="803" name="Google Shape;803;p12"/>
          <p:cNvSpPr txBox="1"/>
          <p:nvPr/>
        </p:nvSpPr>
        <p:spPr>
          <a:xfrm>
            <a:off x="1138507" y="59451"/>
            <a:ext cx="9234766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A) </a:t>
            </a:r>
            <a:r>
              <a:rPr lang="en-US" sz="1200" b="1" i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TEN</a:t>
            </a:r>
            <a:r>
              <a:rPr lang="en-US" sz="12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GAs detected in TBx of HR(+)HER2(-) </a:t>
            </a:r>
            <a:r>
              <a:rPr lang="en-US" sz="1200" b="1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mBC</a:t>
            </a:r>
            <a:r>
              <a:rPr lang="en-US" sz="12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(n=602/5,780)</a:t>
            </a:r>
            <a:endParaRPr dirty="0"/>
          </a:p>
        </p:txBody>
      </p:sp>
      <p:sp>
        <p:nvSpPr>
          <p:cNvPr id="804" name="Google Shape;804;p12"/>
          <p:cNvSpPr txBox="1"/>
          <p:nvPr/>
        </p:nvSpPr>
        <p:spPr>
          <a:xfrm>
            <a:off x="1025805" y="3338544"/>
            <a:ext cx="9234765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B) </a:t>
            </a:r>
            <a:r>
              <a:rPr lang="en-US" sz="1200" b="1" i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TEN</a:t>
            </a:r>
            <a:r>
              <a:rPr lang="en-US" sz="12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GAs detected in LBx of HR(+)HER2(-) mBC (n=41/1,670) </a:t>
            </a:r>
            <a:endParaRPr/>
          </a:p>
        </p:txBody>
      </p:sp>
      <p:pic>
        <p:nvPicPr>
          <p:cNvPr id="805" name="Google Shape;805;p12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8613045" y="59451"/>
            <a:ext cx="738880" cy="559674"/>
          </a:xfrm>
          <a:prstGeom prst="rect">
            <a:avLst/>
          </a:prstGeom>
          <a:noFill/>
          <a:ln>
            <a:noFill/>
          </a:ln>
        </p:spPr>
      </p:pic>
      <p:pic>
        <p:nvPicPr>
          <p:cNvPr id="806" name="Google Shape;806;p12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8553097" y="3443117"/>
            <a:ext cx="301869" cy="621647"/>
          </a:xfrm>
          <a:prstGeom prst="rect">
            <a:avLst/>
          </a:prstGeom>
          <a:noFill/>
          <a:ln>
            <a:noFill/>
          </a:ln>
        </p:spPr>
      </p:pic>
      <p:pic>
        <p:nvPicPr>
          <p:cNvPr id="807" name="Google Shape;807;p12" descr="A graph with blue squares&#10;&#10;Description automatically generated"/>
          <p:cNvPicPr preferRelativeResize="0"/>
          <p:nvPr/>
        </p:nvPicPr>
        <p:blipFill rotWithShape="1">
          <a:blip r:embed="rId5">
            <a:alphaModFix/>
          </a:blip>
          <a:srcRect t="13713"/>
          <a:stretch/>
        </p:blipFill>
        <p:spPr>
          <a:xfrm>
            <a:off x="3247435" y="375594"/>
            <a:ext cx="4569933" cy="2760280"/>
          </a:xfrm>
          <a:prstGeom prst="rect">
            <a:avLst/>
          </a:prstGeom>
          <a:noFill/>
          <a:ln>
            <a:noFill/>
          </a:ln>
        </p:spPr>
      </p:pic>
      <p:pic>
        <p:nvPicPr>
          <p:cNvPr id="808" name="Google Shape;808;p12" descr="A graph with orange bars&#10;&#10;Description automatically generated"/>
          <p:cNvPicPr preferRelativeResize="0"/>
          <p:nvPr/>
        </p:nvPicPr>
        <p:blipFill rotWithShape="1">
          <a:blip r:embed="rId6">
            <a:alphaModFix/>
          </a:blip>
          <a:srcRect t="13484"/>
          <a:stretch/>
        </p:blipFill>
        <p:spPr>
          <a:xfrm>
            <a:off x="3146795" y="3615543"/>
            <a:ext cx="5146600" cy="3116826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1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3" name="Google Shape;813;p13"/>
          <p:cNvSpPr/>
          <p:nvPr/>
        </p:nvSpPr>
        <p:spPr>
          <a:xfrm>
            <a:off x="10001367" y="6002231"/>
            <a:ext cx="1641284" cy="701692"/>
          </a:xfrm>
          <a:prstGeom prst="rect">
            <a:avLst/>
          </a:prstGeom>
          <a:solidFill>
            <a:schemeClr val="lt1"/>
          </a:solidFill>
          <a:ln w="1270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2000">
              <a:solidFill>
                <a:schemeClr val="lt2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14" name="Google Shape;814;p13"/>
          <p:cNvSpPr txBox="1"/>
          <p:nvPr/>
        </p:nvSpPr>
        <p:spPr>
          <a:xfrm>
            <a:off x="0" y="154077"/>
            <a:ext cx="4762563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A) Other frameshift </a:t>
            </a:r>
            <a:r>
              <a:rPr lang="en-US" sz="1200" b="1" i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TEN</a:t>
            </a:r>
            <a:r>
              <a:rPr lang="en-US" sz="12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mutations detected in TBx</a:t>
            </a:r>
            <a:endParaRPr sz="1200" b="1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15" name="Google Shape;815;p13"/>
          <p:cNvSpPr txBox="1"/>
          <p:nvPr/>
        </p:nvSpPr>
        <p:spPr>
          <a:xfrm>
            <a:off x="6973937" y="150867"/>
            <a:ext cx="4762563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B) Other missense </a:t>
            </a:r>
            <a:r>
              <a:rPr lang="en-US" sz="1200" b="1" i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TEN</a:t>
            </a:r>
            <a:r>
              <a:rPr lang="en-US" sz="12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mutations detected in TBx</a:t>
            </a:r>
            <a:endParaRPr sz="1200" b="1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16" name="Google Shape;816;p13"/>
          <p:cNvSpPr txBox="1"/>
          <p:nvPr/>
        </p:nvSpPr>
        <p:spPr>
          <a:xfrm>
            <a:off x="0" y="3453185"/>
            <a:ext cx="3470265" cy="46166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C) Other premature stop codon </a:t>
            </a:r>
            <a:r>
              <a:rPr lang="en-US" sz="1200" b="1" i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TEN</a:t>
            </a:r>
            <a:r>
              <a:rPr lang="en-US" sz="12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mutations detected in TBx</a:t>
            </a:r>
            <a:endParaRPr sz="1200" b="1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17" name="Google Shape;817;p13"/>
          <p:cNvSpPr txBox="1"/>
          <p:nvPr/>
        </p:nvSpPr>
        <p:spPr>
          <a:xfrm>
            <a:off x="3680925" y="3453185"/>
            <a:ext cx="3470265" cy="46166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D) Splice site </a:t>
            </a:r>
            <a:r>
              <a:rPr lang="en-US" sz="1200" b="1" i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TEN</a:t>
            </a:r>
            <a:r>
              <a:rPr lang="en-US" sz="12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mutations detected in TBx</a:t>
            </a:r>
            <a:endParaRPr sz="1200" b="1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18" name="Google Shape;818;p13"/>
          <p:cNvSpPr txBox="1"/>
          <p:nvPr/>
        </p:nvSpPr>
        <p:spPr>
          <a:xfrm>
            <a:off x="8266235" y="3400432"/>
            <a:ext cx="3470265" cy="46166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E) Other nonframeshift </a:t>
            </a:r>
            <a:r>
              <a:rPr lang="en-US" sz="1200" b="1" i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TEN</a:t>
            </a:r>
            <a:r>
              <a:rPr lang="en-US" sz="12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mutations detected in TBx</a:t>
            </a:r>
            <a:endParaRPr sz="1200" b="1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19" name="Google Shape;819;p13"/>
          <p:cNvSpPr txBox="1"/>
          <p:nvPr/>
        </p:nvSpPr>
        <p:spPr>
          <a:xfrm>
            <a:off x="8266235" y="5640670"/>
            <a:ext cx="3881975" cy="11079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Montserrat"/>
              <a:buNone/>
            </a:pPr>
            <a:r>
              <a:rPr lang="en-US" sz="1100" b="1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SUPPLEMENTARY FIGURE S6: Spectrum of other </a:t>
            </a:r>
            <a:r>
              <a:rPr lang="en-US" sz="1100" b="1" i="1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PTEN </a:t>
            </a:r>
            <a:r>
              <a:rPr lang="en-US" sz="1100" b="1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deactivating mutations detected in tissue specimens of HR(+)HER2(-) metastatic breast cancer patients.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  <a:sym typeface="Montserrat"/>
              </a:rPr>
              <a:t> 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GAs: genomic alterations; HR: hormone receptor; LBx: liquid biopsy; </a:t>
            </a:r>
            <a:r>
              <a:rPr lang="en-US" sz="1100" dirty="0" err="1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mBC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: metastatic breast cancer; TBx: tissue biopsy.</a:t>
            </a:r>
            <a:endParaRPr sz="1100" dirty="0">
              <a:solidFill>
                <a:schemeClr val="dk1"/>
              </a:solidFill>
              <a:latin typeface="Arial" panose="020B0604020202020204" pitchFamily="34" charset="0"/>
              <a:ea typeface="Arial"/>
              <a:cs typeface="Arial" panose="020B0604020202020204" pitchFamily="34" charset="0"/>
              <a:sym typeface="Arial"/>
            </a:endParaRPr>
          </a:p>
        </p:txBody>
      </p:sp>
      <p:pic>
        <p:nvPicPr>
          <p:cNvPr id="820" name="Google Shape;820;p13" descr="A graph with blue and white lines&#10;&#10;Description automatically generated"/>
          <p:cNvPicPr preferRelativeResize="0"/>
          <p:nvPr/>
        </p:nvPicPr>
        <p:blipFill rotWithShape="1">
          <a:blip r:embed="rId3">
            <a:alphaModFix/>
          </a:blip>
          <a:srcRect t="11087"/>
          <a:stretch/>
        </p:blipFill>
        <p:spPr>
          <a:xfrm>
            <a:off x="71692" y="379202"/>
            <a:ext cx="6660210" cy="2960876"/>
          </a:xfrm>
          <a:prstGeom prst="rect">
            <a:avLst/>
          </a:prstGeom>
          <a:noFill/>
          <a:ln>
            <a:noFill/>
          </a:ln>
        </p:spPr>
      </p:pic>
      <p:pic>
        <p:nvPicPr>
          <p:cNvPr id="821" name="Google Shape;821;p13" descr="A graph of a number of blue and green bars&#10;&#10;Description automatically generated with medium confidence"/>
          <p:cNvPicPr preferRelativeResize="0"/>
          <p:nvPr/>
        </p:nvPicPr>
        <p:blipFill rotWithShape="1">
          <a:blip r:embed="rId4">
            <a:alphaModFix/>
          </a:blip>
          <a:srcRect t="12002"/>
          <a:stretch/>
        </p:blipFill>
        <p:spPr>
          <a:xfrm>
            <a:off x="7151190" y="439016"/>
            <a:ext cx="4585310" cy="2824486"/>
          </a:xfrm>
          <a:prstGeom prst="rect">
            <a:avLst/>
          </a:prstGeom>
          <a:noFill/>
          <a:ln>
            <a:noFill/>
          </a:ln>
        </p:spPr>
      </p:pic>
      <p:pic>
        <p:nvPicPr>
          <p:cNvPr id="822" name="Google Shape;822;p13" descr="A graph of a number of blue and green bars&#10;&#10;Description automatically generated with medium confidence"/>
          <p:cNvPicPr preferRelativeResize="0"/>
          <p:nvPr/>
        </p:nvPicPr>
        <p:blipFill rotWithShape="1">
          <a:blip r:embed="rId5">
            <a:alphaModFix/>
          </a:blip>
          <a:srcRect t="12002"/>
          <a:stretch/>
        </p:blipFill>
        <p:spPr>
          <a:xfrm>
            <a:off x="158166" y="3926000"/>
            <a:ext cx="3470265" cy="2137634"/>
          </a:xfrm>
          <a:prstGeom prst="rect">
            <a:avLst/>
          </a:prstGeom>
          <a:noFill/>
          <a:ln>
            <a:noFill/>
          </a:ln>
        </p:spPr>
      </p:pic>
      <p:pic>
        <p:nvPicPr>
          <p:cNvPr id="823" name="Google Shape;823;p13" descr="A graph of a tissue&#10;&#10;Description automatically generated with medium confidence"/>
          <p:cNvPicPr preferRelativeResize="0"/>
          <p:nvPr/>
        </p:nvPicPr>
        <p:blipFill rotWithShape="1">
          <a:blip r:embed="rId6">
            <a:alphaModFix/>
          </a:blip>
          <a:srcRect t="12002"/>
          <a:stretch/>
        </p:blipFill>
        <p:spPr>
          <a:xfrm>
            <a:off x="3685649" y="3914850"/>
            <a:ext cx="4373976" cy="2694307"/>
          </a:xfrm>
          <a:prstGeom prst="rect">
            <a:avLst/>
          </a:prstGeom>
          <a:noFill/>
          <a:ln>
            <a:noFill/>
          </a:ln>
        </p:spPr>
      </p:pic>
      <p:pic>
        <p:nvPicPr>
          <p:cNvPr id="824" name="Google Shape;824;p13" descr="A graph with blue squares&#10;&#10;Description automatically generated"/>
          <p:cNvPicPr preferRelativeResize="0"/>
          <p:nvPr/>
        </p:nvPicPr>
        <p:blipFill rotWithShape="1">
          <a:blip r:embed="rId7">
            <a:alphaModFix/>
          </a:blip>
          <a:srcRect t="12002"/>
          <a:stretch/>
        </p:blipFill>
        <p:spPr>
          <a:xfrm>
            <a:off x="8499647" y="3862097"/>
            <a:ext cx="2792129" cy="1719912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 descr="A graph of different colored bars&#10;&#10;Description automatically generated">
            <a:extLst>
              <a:ext uri="{FF2B5EF4-FFF2-40B4-BE49-F238E27FC236}">
                <a16:creationId xmlns:a16="http://schemas.microsoft.com/office/drawing/2014/main" id="{D9055422-7E31-E8BC-9C41-B9FE1DFA5F6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74566" y="1505206"/>
            <a:ext cx="7914037" cy="3297515"/>
          </a:xfrm>
          <a:prstGeom prst="rect">
            <a:avLst/>
          </a:prstGeom>
        </p:spPr>
      </p:pic>
      <p:sp>
        <p:nvSpPr>
          <p:cNvPr id="16" name="Google Shape;486;p2">
            <a:extLst>
              <a:ext uri="{FF2B5EF4-FFF2-40B4-BE49-F238E27FC236}">
                <a16:creationId xmlns:a16="http://schemas.microsoft.com/office/drawing/2014/main" id="{A3B7E31E-3214-AB38-8FC9-C333D3C53ECD}"/>
              </a:ext>
            </a:extLst>
          </p:cNvPr>
          <p:cNvSpPr txBox="1"/>
          <p:nvPr/>
        </p:nvSpPr>
        <p:spPr>
          <a:xfrm>
            <a:off x="6325774" y="3564317"/>
            <a:ext cx="338554" cy="1692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5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4.5%</a:t>
            </a:r>
            <a:endParaRPr dirty="0"/>
          </a:p>
        </p:txBody>
      </p:sp>
      <p:sp>
        <p:nvSpPr>
          <p:cNvPr id="18" name="Google Shape;488;p2">
            <a:extLst>
              <a:ext uri="{FF2B5EF4-FFF2-40B4-BE49-F238E27FC236}">
                <a16:creationId xmlns:a16="http://schemas.microsoft.com/office/drawing/2014/main" id="{A6EDA65A-42DD-12E3-82F9-8768E2BC11AC}"/>
              </a:ext>
            </a:extLst>
          </p:cNvPr>
          <p:cNvSpPr txBox="1"/>
          <p:nvPr/>
        </p:nvSpPr>
        <p:spPr>
          <a:xfrm>
            <a:off x="5071172" y="2581643"/>
            <a:ext cx="378630" cy="1692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5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41.0%</a:t>
            </a:r>
            <a:endParaRPr dirty="0"/>
          </a:p>
        </p:txBody>
      </p:sp>
      <p:sp>
        <p:nvSpPr>
          <p:cNvPr id="24" name="Google Shape;494;p2">
            <a:extLst>
              <a:ext uri="{FF2B5EF4-FFF2-40B4-BE49-F238E27FC236}">
                <a16:creationId xmlns:a16="http://schemas.microsoft.com/office/drawing/2014/main" id="{8C1C10C5-6282-CC5B-ADF1-C41D3CF0AC6A}"/>
              </a:ext>
            </a:extLst>
          </p:cNvPr>
          <p:cNvSpPr txBox="1"/>
          <p:nvPr/>
        </p:nvSpPr>
        <p:spPr>
          <a:xfrm>
            <a:off x="4459603" y="3457607"/>
            <a:ext cx="365806" cy="1692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5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8.3%</a:t>
            </a:r>
            <a:endParaRPr dirty="0"/>
          </a:p>
        </p:txBody>
      </p:sp>
      <p:sp>
        <p:nvSpPr>
          <p:cNvPr id="25" name="Google Shape;495;p2">
            <a:extLst>
              <a:ext uri="{FF2B5EF4-FFF2-40B4-BE49-F238E27FC236}">
                <a16:creationId xmlns:a16="http://schemas.microsoft.com/office/drawing/2014/main" id="{74BACE42-5CA3-FB94-1199-3E21A0034988}"/>
              </a:ext>
            </a:extLst>
          </p:cNvPr>
          <p:cNvSpPr txBox="1"/>
          <p:nvPr/>
        </p:nvSpPr>
        <p:spPr>
          <a:xfrm>
            <a:off x="3866233" y="3517374"/>
            <a:ext cx="375408" cy="1692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5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6.2%</a:t>
            </a:r>
            <a:endParaRPr dirty="0"/>
          </a:p>
        </p:txBody>
      </p:sp>
      <p:sp>
        <p:nvSpPr>
          <p:cNvPr id="30" name="Google Shape;500;p2">
            <a:extLst>
              <a:ext uri="{FF2B5EF4-FFF2-40B4-BE49-F238E27FC236}">
                <a16:creationId xmlns:a16="http://schemas.microsoft.com/office/drawing/2014/main" id="{884180C8-6D18-D53E-D9B7-5D78BA450961}"/>
              </a:ext>
            </a:extLst>
          </p:cNvPr>
          <p:cNvSpPr txBox="1"/>
          <p:nvPr/>
        </p:nvSpPr>
        <p:spPr>
          <a:xfrm>
            <a:off x="4056975" y="3429000"/>
            <a:ext cx="362497" cy="1692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5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9.5%</a:t>
            </a:r>
            <a:endParaRPr dirty="0"/>
          </a:p>
        </p:txBody>
      </p:sp>
      <p:sp>
        <p:nvSpPr>
          <p:cNvPr id="31" name="Google Shape;501;p2">
            <a:extLst>
              <a:ext uri="{FF2B5EF4-FFF2-40B4-BE49-F238E27FC236}">
                <a16:creationId xmlns:a16="http://schemas.microsoft.com/office/drawing/2014/main" id="{4BB3F86F-2C70-493C-27C4-47FCA3CA33B7}"/>
              </a:ext>
            </a:extLst>
          </p:cNvPr>
          <p:cNvSpPr txBox="1"/>
          <p:nvPr/>
        </p:nvSpPr>
        <p:spPr>
          <a:xfrm>
            <a:off x="4647787" y="2913788"/>
            <a:ext cx="373820" cy="1692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5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28.3%</a:t>
            </a:r>
            <a:endParaRPr dirty="0"/>
          </a:p>
        </p:txBody>
      </p:sp>
      <p:sp>
        <p:nvSpPr>
          <p:cNvPr id="35" name="Google Shape;505;p2">
            <a:extLst>
              <a:ext uri="{FF2B5EF4-FFF2-40B4-BE49-F238E27FC236}">
                <a16:creationId xmlns:a16="http://schemas.microsoft.com/office/drawing/2014/main" id="{F34F577D-12EF-0E46-AAB3-7860D851A12E}"/>
              </a:ext>
            </a:extLst>
          </p:cNvPr>
          <p:cNvSpPr txBox="1"/>
          <p:nvPr/>
        </p:nvSpPr>
        <p:spPr>
          <a:xfrm>
            <a:off x="7740721" y="3678068"/>
            <a:ext cx="335348" cy="1692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5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0%</a:t>
            </a:r>
            <a:endParaRPr dirty="0"/>
          </a:p>
        </p:txBody>
      </p:sp>
      <p:sp>
        <p:nvSpPr>
          <p:cNvPr id="46" name="Google Shape;516;p2">
            <a:extLst>
              <a:ext uri="{FF2B5EF4-FFF2-40B4-BE49-F238E27FC236}">
                <a16:creationId xmlns:a16="http://schemas.microsoft.com/office/drawing/2014/main" id="{208C20E1-020A-032A-36B9-D757A9C77753}"/>
              </a:ext>
            </a:extLst>
          </p:cNvPr>
          <p:cNvSpPr txBox="1"/>
          <p:nvPr/>
        </p:nvSpPr>
        <p:spPr>
          <a:xfrm>
            <a:off x="6707016" y="3678069"/>
            <a:ext cx="336952" cy="1692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5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0%</a:t>
            </a:r>
            <a:endParaRPr dirty="0"/>
          </a:p>
        </p:txBody>
      </p:sp>
      <p:sp>
        <p:nvSpPr>
          <p:cNvPr id="49" name="Google Shape;519;p2">
            <a:extLst>
              <a:ext uri="{FF2B5EF4-FFF2-40B4-BE49-F238E27FC236}">
                <a16:creationId xmlns:a16="http://schemas.microsoft.com/office/drawing/2014/main" id="{46337BDB-4F6C-9676-6425-BCAF71F13F05}"/>
              </a:ext>
            </a:extLst>
          </p:cNvPr>
          <p:cNvSpPr txBox="1"/>
          <p:nvPr/>
        </p:nvSpPr>
        <p:spPr>
          <a:xfrm>
            <a:off x="4812029" y="2784248"/>
            <a:ext cx="372218" cy="1692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5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33.7%</a:t>
            </a:r>
            <a:endParaRPr dirty="0"/>
          </a:p>
        </p:txBody>
      </p:sp>
      <p:sp>
        <p:nvSpPr>
          <p:cNvPr id="50" name="Google Shape;520;p2">
            <a:extLst>
              <a:ext uri="{FF2B5EF4-FFF2-40B4-BE49-F238E27FC236}">
                <a16:creationId xmlns:a16="http://schemas.microsoft.com/office/drawing/2014/main" id="{DBDC58C7-AAB2-C8CE-9F13-604F14967ACB}"/>
              </a:ext>
            </a:extLst>
          </p:cNvPr>
          <p:cNvSpPr txBox="1"/>
          <p:nvPr/>
        </p:nvSpPr>
        <p:spPr>
          <a:xfrm>
            <a:off x="4209808" y="2878425"/>
            <a:ext cx="373820" cy="1692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5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30.0%</a:t>
            </a:r>
            <a:endParaRPr dirty="0"/>
          </a:p>
        </p:txBody>
      </p:sp>
      <p:sp>
        <p:nvSpPr>
          <p:cNvPr id="51" name="Google Shape;560;p2">
            <a:extLst>
              <a:ext uri="{FF2B5EF4-FFF2-40B4-BE49-F238E27FC236}">
                <a16:creationId xmlns:a16="http://schemas.microsoft.com/office/drawing/2014/main" id="{3C767C6F-627D-411B-BDF2-9E24129EC056}"/>
              </a:ext>
            </a:extLst>
          </p:cNvPr>
          <p:cNvSpPr txBox="1"/>
          <p:nvPr/>
        </p:nvSpPr>
        <p:spPr>
          <a:xfrm>
            <a:off x="6495051" y="4646042"/>
            <a:ext cx="1020878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600" dirty="0">
                <a:solidFill>
                  <a:schemeClr val="dk1"/>
                </a:solidFill>
              </a:rPr>
              <a:t>&lt;2015</a:t>
            </a:r>
            <a:r>
              <a:rPr lang="en-US" sz="6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n=178</a:t>
            </a:r>
            <a:endParaRPr dirty="0"/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6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&gt;=2015 n=1,976</a:t>
            </a:r>
            <a:endParaRPr dirty="0"/>
          </a:p>
        </p:txBody>
      </p:sp>
      <p:sp>
        <p:nvSpPr>
          <p:cNvPr id="80" name="Google Shape;560;p2">
            <a:extLst>
              <a:ext uri="{FF2B5EF4-FFF2-40B4-BE49-F238E27FC236}">
                <a16:creationId xmlns:a16="http://schemas.microsoft.com/office/drawing/2014/main" id="{09306E76-F4C9-173B-B3DE-10467EEB8815}"/>
              </a:ext>
            </a:extLst>
          </p:cNvPr>
          <p:cNvSpPr txBox="1"/>
          <p:nvPr/>
        </p:nvSpPr>
        <p:spPr>
          <a:xfrm>
            <a:off x="7208690" y="4646041"/>
            <a:ext cx="1020878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600" dirty="0">
                <a:solidFill>
                  <a:schemeClr val="dk1"/>
                </a:solidFill>
              </a:rPr>
              <a:t>&lt;2015</a:t>
            </a:r>
            <a:r>
              <a:rPr lang="en-US" sz="6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n=21</a:t>
            </a:r>
            <a:endParaRPr dirty="0"/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6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&gt;=2015 n=251</a:t>
            </a:r>
            <a:endParaRPr dirty="0"/>
          </a:p>
        </p:txBody>
      </p:sp>
      <p:sp>
        <p:nvSpPr>
          <p:cNvPr id="81" name="Google Shape;560;p2">
            <a:extLst>
              <a:ext uri="{FF2B5EF4-FFF2-40B4-BE49-F238E27FC236}">
                <a16:creationId xmlns:a16="http://schemas.microsoft.com/office/drawing/2014/main" id="{1C0F3CF1-501C-9EE8-AD4F-A89FECDD565D}"/>
              </a:ext>
            </a:extLst>
          </p:cNvPr>
          <p:cNvSpPr txBox="1"/>
          <p:nvPr/>
        </p:nvSpPr>
        <p:spPr>
          <a:xfrm>
            <a:off x="7818323" y="4646040"/>
            <a:ext cx="1020878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600" dirty="0">
                <a:solidFill>
                  <a:schemeClr val="dk1"/>
                </a:solidFill>
              </a:rPr>
              <a:t>&lt;2015</a:t>
            </a:r>
            <a:r>
              <a:rPr lang="en-US" sz="6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n=20</a:t>
            </a:r>
            <a:endParaRPr dirty="0"/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6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&gt;=2015 n</a:t>
            </a:r>
            <a:r>
              <a:rPr lang="en-US" sz="600" dirty="0">
                <a:solidFill>
                  <a:schemeClr val="dk1"/>
                </a:solidFill>
              </a:rPr>
              <a:t>=196</a:t>
            </a:r>
            <a:endParaRPr dirty="0"/>
          </a:p>
        </p:txBody>
      </p:sp>
      <p:sp>
        <p:nvSpPr>
          <p:cNvPr id="82" name="Google Shape;505;p2">
            <a:extLst>
              <a:ext uri="{FF2B5EF4-FFF2-40B4-BE49-F238E27FC236}">
                <a16:creationId xmlns:a16="http://schemas.microsoft.com/office/drawing/2014/main" id="{17B0AE62-E64E-352E-8E0F-6EE1941BF62C}"/>
              </a:ext>
            </a:extLst>
          </p:cNvPr>
          <p:cNvSpPr txBox="1"/>
          <p:nvPr/>
        </p:nvSpPr>
        <p:spPr>
          <a:xfrm>
            <a:off x="6935332" y="3546973"/>
            <a:ext cx="335348" cy="1692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5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5.0%</a:t>
            </a:r>
            <a:endParaRPr dirty="0"/>
          </a:p>
        </p:txBody>
      </p:sp>
      <p:sp>
        <p:nvSpPr>
          <p:cNvPr id="83" name="Google Shape;505;p2">
            <a:extLst>
              <a:ext uri="{FF2B5EF4-FFF2-40B4-BE49-F238E27FC236}">
                <a16:creationId xmlns:a16="http://schemas.microsoft.com/office/drawing/2014/main" id="{CBC348A9-658B-43BD-85AD-C7A2EB60A540}"/>
              </a:ext>
            </a:extLst>
          </p:cNvPr>
          <p:cNvSpPr txBox="1"/>
          <p:nvPr/>
        </p:nvSpPr>
        <p:spPr>
          <a:xfrm>
            <a:off x="7121305" y="3517334"/>
            <a:ext cx="335348" cy="1692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500" dirty="0">
                <a:solidFill>
                  <a:schemeClr val="dk1"/>
                </a:solidFill>
              </a:rPr>
              <a:t>6</a:t>
            </a:r>
            <a:r>
              <a:rPr lang="en-US" sz="5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.0%</a:t>
            </a:r>
            <a:endParaRPr dirty="0"/>
          </a:p>
        </p:txBody>
      </p:sp>
      <p:sp>
        <p:nvSpPr>
          <p:cNvPr id="84" name="Google Shape;505;p2">
            <a:extLst>
              <a:ext uri="{FF2B5EF4-FFF2-40B4-BE49-F238E27FC236}">
                <a16:creationId xmlns:a16="http://schemas.microsoft.com/office/drawing/2014/main" id="{2C585C00-4772-6045-33BF-344744B587CA}"/>
              </a:ext>
            </a:extLst>
          </p:cNvPr>
          <p:cNvSpPr txBox="1"/>
          <p:nvPr/>
        </p:nvSpPr>
        <p:spPr>
          <a:xfrm>
            <a:off x="7307278" y="3472615"/>
            <a:ext cx="335348" cy="1692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500" dirty="0">
                <a:solidFill>
                  <a:schemeClr val="dk1"/>
                </a:solidFill>
              </a:rPr>
              <a:t>7.7</a:t>
            </a:r>
            <a:r>
              <a:rPr lang="en-US" sz="5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%</a:t>
            </a:r>
            <a:endParaRPr dirty="0"/>
          </a:p>
        </p:txBody>
      </p:sp>
      <p:sp>
        <p:nvSpPr>
          <p:cNvPr id="85" name="Google Shape;505;p2">
            <a:extLst>
              <a:ext uri="{FF2B5EF4-FFF2-40B4-BE49-F238E27FC236}">
                <a16:creationId xmlns:a16="http://schemas.microsoft.com/office/drawing/2014/main" id="{8B29F72C-D989-CA59-3DA8-B24AD7A49FC0}"/>
              </a:ext>
            </a:extLst>
          </p:cNvPr>
          <p:cNvSpPr txBox="1"/>
          <p:nvPr/>
        </p:nvSpPr>
        <p:spPr>
          <a:xfrm>
            <a:off x="5260487" y="3045923"/>
            <a:ext cx="373819" cy="1692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500" dirty="0">
                <a:solidFill>
                  <a:schemeClr val="dk1"/>
                </a:solidFill>
              </a:rPr>
              <a:t>23.8</a:t>
            </a:r>
            <a:r>
              <a:rPr lang="en-US" sz="5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%</a:t>
            </a:r>
            <a:endParaRPr dirty="0"/>
          </a:p>
        </p:txBody>
      </p:sp>
      <p:sp>
        <p:nvSpPr>
          <p:cNvPr id="86" name="Google Shape;488;p2">
            <a:extLst>
              <a:ext uri="{FF2B5EF4-FFF2-40B4-BE49-F238E27FC236}">
                <a16:creationId xmlns:a16="http://schemas.microsoft.com/office/drawing/2014/main" id="{2B192165-93C5-8E04-9C52-1E32398FD2EF}"/>
              </a:ext>
            </a:extLst>
          </p:cNvPr>
          <p:cNvSpPr txBox="1"/>
          <p:nvPr/>
        </p:nvSpPr>
        <p:spPr>
          <a:xfrm>
            <a:off x="5447396" y="2485430"/>
            <a:ext cx="378630" cy="1692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5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45.0%</a:t>
            </a:r>
            <a:endParaRPr dirty="0"/>
          </a:p>
        </p:txBody>
      </p:sp>
      <p:sp>
        <p:nvSpPr>
          <p:cNvPr id="87" name="Google Shape;488;p2">
            <a:extLst>
              <a:ext uri="{FF2B5EF4-FFF2-40B4-BE49-F238E27FC236}">
                <a16:creationId xmlns:a16="http://schemas.microsoft.com/office/drawing/2014/main" id="{0A2AFDCA-93CD-7392-366D-CEBEF2858ECB}"/>
              </a:ext>
            </a:extLst>
          </p:cNvPr>
          <p:cNvSpPr txBox="1"/>
          <p:nvPr/>
        </p:nvSpPr>
        <p:spPr>
          <a:xfrm>
            <a:off x="5686606" y="2497004"/>
            <a:ext cx="378630" cy="1692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5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43.9%</a:t>
            </a:r>
            <a:endParaRPr dirty="0"/>
          </a:p>
        </p:txBody>
      </p:sp>
      <p:sp>
        <p:nvSpPr>
          <p:cNvPr id="88" name="Google Shape;488;p2">
            <a:extLst>
              <a:ext uri="{FF2B5EF4-FFF2-40B4-BE49-F238E27FC236}">
                <a16:creationId xmlns:a16="http://schemas.microsoft.com/office/drawing/2014/main" id="{14538158-9EBA-020D-45FC-75DB76516BC4}"/>
              </a:ext>
            </a:extLst>
          </p:cNvPr>
          <p:cNvSpPr txBox="1"/>
          <p:nvPr/>
        </p:nvSpPr>
        <p:spPr>
          <a:xfrm>
            <a:off x="5875921" y="2641782"/>
            <a:ext cx="378630" cy="1692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5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38.2%</a:t>
            </a:r>
            <a:endParaRPr dirty="0"/>
          </a:p>
        </p:txBody>
      </p:sp>
      <p:sp>
        <p:nvSpPr>
          <p:cNvPr id="89" name="Google Shape;488;p2">
            <a:extLst>
              <a:ext uri="{FF2B5EF4-FFF2-40B4-BE49-F238E27FC236}">
                <a16:creationId xmlns:a16="http://schemas.microsoft.com/office/drawing/2014/main" id="{B5E9BEE6-249B-94E8-57A4-84421DD61C8F}"/>
              </a:ext>
            </a:extLst>
          </p:cNvPr>
          <p:cNvSpPr txBox="1"/>
          <p:nvPr/>
        </p:nvSpPr>
        <p:spPr>
          <a:xfrm>
            <a:off x="6062830" y="2582131"/>
            <a:ext cx="378630" cy="1692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5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40.8%</a:t>
            </a:r>
            <a:endParaRPr dirty="0"/>
          </a:p>
        </p:txBody>
      </p:sp>
      <p:sp>
        <p:nvSpPr>
          <p:cNvPr id="90" name="Google Shape;488;p2">
            <a:extLst>
              <a:ext uri="{FF2B5EF4-FFF2-40B4-BE49-F238E27FC236}">
                <a16:creationId xmlns:a16="http://schemas.microsoft.com/office/drawing/2014/main" id="{BF8C1C6B-D8CD-6BF2-4A96-E4FE1CF721EF}"/>
              </a:ext>
            </a:extLst>
          </p:cNvPr>
          <p:cNvSpPr txBox="1"/>
          <p:nvPr/>
        </p:nvSpPr>
        <p:spPr>
          <a:xfrm>
            <a:off x="7541684" y="3572859"/>
            <a:ext cx="378630" cy="1692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5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3.9%</a:t>
            </a:r>
            <a:endParaRPr dirty="0"/>
          </a:p>
        </p:txBody>
      </p:sp>
      <p:sp>
        <p:nvSpPr>
          <p:cNvPr id="91" name="Google Shape;516;p2">
            <a:extLst>
              <a:ext uri="{FF2B5EF4-FFF2-40B4-BE49-F238E27FC236}">
                <a16:creationId xmlns:a16="http://schemas.microsoft.com/office/drawing/2014/main" id="{A5023C5D-AD0B-6020-2A0E-8A5236CB7CD5}"/>
              </a:ext>
            </a:extLst>
          </p:cNvPr>
          <p:cNvSpPr txBox="1"/>
          <p:nvPr/>
        </p:nvSpPr>
        <p:spPr>
          <a:xfrm>
            <a:off x="6513349" y="3432695"/>
            <a:ext cx="336952" cy="1692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5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9.5%</a:t>
            </a:r>
            <a:endParaRPr dirty="0"/>
          </a:p>
        </p:txBody>
      </p:sp>
      <p:sp>
        <p:nvSpPr>
          <p:cNvPr id="92" name="Google Shape;516;p2">
            <a:extLst>
              <a:ext uri="{FF2B5EF4-FFF2-40B4-BE49-F238E27FC236}">
                <a16:creationId xmlns:a16="http://schemas.microsoft.com/office/drawing/2014/main" id="{A67A423A-978D-4456-0732-12B5F1C24D51}"/>
              </a:ext>
            </a:extLst>
          </p:cNvPr>
          <p:cNvSpPr txBox="1"/>
          <p:nvPr/>
        </p:nvSpPr>
        <p:spPr>
          <a:xfrm>
            <a:off x="7910306" y="3403167"/>
            <a:ext cx="363518" cy="1692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5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0.0%</a:t>
            </a:r>
            <a:endParaRPr dirty="0"/>
          </a:p>
        </p:txBody>
      </p:sp>
      <p:sp>
        <p:nvSpPr>
          <p:cNvPr id="93" name="Google Shape;516;p2">
            <a:extLst>
              <a:ext uri="{FF2B5EF4-FFF2-40B4-BE49-F238E27FC236}">
                <a16:creationId xmlns:a16="http://schemas.microsoft.com/office/drawing/2014/main" id="{A78D44B2-45B5-B4E1-8595-0C85AB19914D}"/>
              </a:ext>
            </a:extLst>
          </p:cNvPr>
          <p:cNvSpPr txBox="1"/>
          <p:nvPr/>
        </p:nvSpPr>
        <p:spPr>
          <a:xfrm>
            <a:off x="8157327" y="3485803"/>
            <a:ext cx="363518" cy="1692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5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6.8%</a:t>
            </a:r>
            <a:endParaRPr dirty="0"/>
          </a:p>
        </p:txBody>
      </p:sp>
      <p:sp>
        <p:nvSpPr>
          <p:cNvPr id="94" name="Google Shape;516;p2">
            <a:extLst>
              <a:ext uri="{FF2B5EF4-FFF2-40B4-BE49-F238E27FC236}">
                <a16:creationId xmlns:a16="http://schemas.microsoft.com/office/drawing/2014/main" id="{E3BC525E-3003-7CFA-0FD6-1581A16FA97A}"/>
              </a:ext>
            </a:extLst>
          </p:cNvPr>
          <p:cNvSpPr txBox="1"/>
          <p:nvPr/>
        </p:nvSpPr>
        <p:spPr>
          <a:xfrm>
            <a:off x="8349862" y="3580379"/>
            <a:ext cx="363518" cy="1692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5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3.6%</a:t>
            </a:r>
            <a:endParaRPr dirty="0"/>
          </a:p>
        </p:txBody>
      </p:sp>
      <p:sp>
        <p:nvSpPr>
          <p:cNvPr id="95" name="Google Shape;516;p2">
            <a:extLst>
              <a:ext uri="{FF2B5EF4-FFF2-40B4-BE49-F238E27FC236}">
                <a16:creationId xmlns:a16="http://schemas.microsoft.com/office/drawing/2014/main" id="{4E1C00DE-C611-4BE8-5B0A-2B3525746F1A}"/>
              </a:ext>
            </a:extLst>
          </p:cNvPr>
          <p:cNvSpPr txBox="1"/>
          <p:nvPr/>
        </p:nvSpPr>
        <p:spPr>
          <a:xfrm>
            <a:off x="8539804" y="3542245"/>
            <a:ext cx="363518" cy="1692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5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5.1%</a:t>
            </a:r>
            <a:endParaRPr dirty="0"/>
          </a:p>
        </p:txBody>
      </p:sp>
      <p:sp>
        <p:nvSpPr>
          <p:cNvPr id="96" name="Google Shape;516;p2">
            <a:extLst>
              <a:ext uri="{FF2B5EF4-FFF2-40B4-BE49-F238E27FC236}">
                <a16:creationId xmlns:a16="http://schemas.microsoft.com/office/drawing/2014/main" id="{E4C31124-9D9F-5290-8467-00BA6CD78AC4}"/>
              </a:ext>
            </a:extLst>
          </p:cNvPr>
          <p:cNvSpPr txBox="1"/>
          <p:nvPr/>
        </p:nvSpPr>
        <p:spPr>
          <a:xfrm>
            <a:off x="8994478" y="3678068"/>
            <a:ext cx="336952" cy="1692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5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0%</a:t>
            </a:r>
            <a:endParaRPr dirty="0"/>
          </a:p>
        </p:txBody>
      </p:sp>
      <p:sp>
        <p:nvSpPr>
          <p:cNvPr id="97" name="Google Shape;516;p2">
            <a:extLst>
              <a:ext uri="{FF2B5EF4-FFF2-40B4-BE49-F238E27FC236}">
                <a16:creationId xmlns:a16="http://schemas.microsoft.com/office/drawing/2014/main" id="{2B46EBF3-0805-97E2-D552-2FD5B65C0998}"/>
              </a:ext>
            </a:extLst>
          </p:cNvPr>
          <p:cNvSpPr txBox="1"/>
          <p:nvPr/>
        </p:nvSpPr>
        <p:spPr>
          <a:xfrm>
            <a:off x="9131385" y="3411142"/>
            <a:ext cx="363518" cy="1692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5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0.0%</a:t>
            </a:r>
            <a:endParaRPr dirty="0"/>
          </a:p>
        </p:txBody>
      </p:sp>
      <p:sp>
        <p:nvSpPr>
          <p:cNvPr id="98" name="Google Shape;488;p2">
            <a:extLst>
              <a:ext uri="{FF2B5EF4-FFF2-40B4-BE49-F238E27FC236}">
                <a16:creationId xmlns:a16="http://schemas.microsoft.com/office/drawing/2014/main" id="{30B599D1-E580-80B0-5594-92C4D14E4D7C}"/>
              </a:ext>
            </a:extLst>
          </p:cNvPr>
          <p:cNvSpPr txBox="1"/>
          <p:nvPr/>
        </p:nvSpPr>
        <p:spPr>
          <a:xfrm>
            <a:off x="8764298" y="3602389"/>
            <a:ext cx="378630" cy="1692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5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2.8%</a:t>
            </a:r>
            <a:endParaRPr dirty="0"/>
          </a:p>
        </p:txBody>
      </p:sp>
      <p:sp>
        <p:nvSpPr>
          <p:cNvPr id="99" name="Google Shape;516;p2">
            <a:extLst>
              <a:ext uri="{FF2B5EF4-FFF2-40B4-BE49-F238E27FC236}">
                <a16:creationId xmlns:a16="http://schemas.microsoft.com/office/drawing/2014/main" id="{FBB066A1-A6A6-525E-692D-8FFD7C692ECA}"/>
              </a:ext>
            </a:extLst>
          </p:cNvPr>
          <p:cNvSpPr txBox="1"/>
          <p:nvPr/>
        </p:nvSpPr>
        <p:spPr>
          <a:xfrm>
            <a:off x="9770620" y="3542245"/>
            <a:ext cx="363518" cy="1692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5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5.1%</a:t>
            </a:r>
            <a:endParaRPr dirty="0"/>
          </a:p>
        </p:txBody>
      </p:sp>
      <p:sp>
        <p:nvSpPr>
          <p:cNvPr id="100" name="Google Shape;516;p2">
            <a:extLst>
              <a:ext uri="{FF2B5EF4-FFF2-40B4-BE49-F238E27FC236}">
                <a16:creationId xmlns:a16="http://schemas.microsoft.com/office/drawing/2014/main" id="{3D357B58-0DF8-972F-67FF-DF6815270EA3}"/>
              </a:ext>
            </a:extLst>
          </p:cNvPr>
          <p:cNvSpPr txBox="1"/>
          <p:nvPr/>
        </p:nvSpPr>
        <p:spPr>
          <a:xfrm>
            <a:off x="9579124" y="3576388"/>
            <a:ext cx="363518" cy="1692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5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3.6%</a:t>
            </a:r>
            <a:endParaRPr dirty="0"/>
          </a:p>
        </p:txBody>
      </p:sp>
      <p:sp>
        <p:nvSpPr>
          <p:cNvPr id="101" name="Google Shape;516;p2">
            <a:extLst>
              <a:ext uri="{FF2B5EF4-FFF2-40B4-BE49-F238E27FC236}">
                <a16:creationId xmlns:a16="http://schemas.microsoft.com/office/drawing/2014/main" id="{4612E6C0-D714-A929-6063-8F8C47528CF0}"/>
              </a:ext>
            </a:extLst>
          </p:cNvPr>
          <p:cNvSpPr txBox="1"/>
          <p:nvPr/>
        </p:nvSpPr>
        <p:spPr>
          <a:xfrm>
            <a:off x="9397365" y="3557273"/>
            <a:ext cx="363518" cy="1692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5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4.5%</a:t>
            </a:r>
            <a:endParaRPr dirty="0"/>
          </a:p>
        </p:txBody>
      </p:sp>
      <p:sp>
        <p:nvSpPr>
          <p:cNvPr id="102" name="Google Shape;516;p2">
            <a:extLst>
              <a:ext uri="{FF2B5EF4-FFF2-40B4-BE49-F238E27FC236}">
                <a16:creationId xmlns:a16="http://schemas.microsoft.com/office/drawing/2014/main" id="{A38BBE78-B2CF-E476-1A82-FBA6D0A14014}"/>
              </a:ext>
            </a:extLst>
          </p:cNvPr>
          <p:cNvSpPr txBox="1"/>
          <p:nvPr/>
        </p:nvSpPr>
        <p:spPr>
          <a:xfrm>
            <a:off x="9984054" y="2248904"/>
            <a:ext cx="363518" cy="1692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5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53.4%</a:t>
            </a:r>
            <a:endParaRPr dirty="0"/>
          </a:p>
        </p:txBody>
      </p:sp>
      <p:sp>
        <p:nvSpPr>
          <p:cNvPr id="103" name="Google Shape;516;p2">
            <a:extLst>
              <a:ext uri="{FF2B5EF4-FFF2-40B4-BE49-F238E27FC236}">
                <a16:creationId xmlns:a16="http://schemas.microsoft.com/office/drawing/2014/main" id="{38A74B41-920B-8FFD-97B2-98477C6098EC}"/>
              </a:ext>
            </a:extLst>
          </p:cNvPr>
          <p:cNvSpPr txBox="1"/>
          <p:nvPr/>
        </p:nvSpPr>
        <p:spPr>
          <a:xfrm>
            <a:off x="10171600" y="2532255"/>
            <a:ext cx="363518" cy="1692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5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42.9%</a:t>
            </a:r>
            <a:endParaRPr dirty="0"/>
          </a:p>
        </p:txBody>
      </p:sp>
      <p:sp>
        <p:nvSpPr>
          <p:cNvPr id="104" name="Google Shape;516;p2">
            <a:extLst>
              <a:ext uri="{FF2B5EF4-FFF2-40B4-BE49-F238E27FC236}">
                <a16:creationId xmlns:a16="http://schemas.microsoft.com/office/drawing/2014/main" id="{294D7D81-96F2-8200-2E87-3D30505D9356}"/>
              </a:ext>
            </a:extLst>
          </p:cNvPr>
          <p:cNvSpPr txBox="1"/>
          <p:nvPr/>
        </p:nvSpPr>
        <p:spPr>
          <a:xfrm>
            <a:off x="10353359" y="2073880"/>
            <a:ext cx="363518" cy="1692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5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60.0%</a:t>
            </a:r>
            <a:endParaRPr dirty="0"/>
          </a:p>
        </p:txBody>
      </p:sp>
      <p:sp>
        <p:nvSpPr>
          <p:cNvPr id="105" name="Google Shape;516;p2">
            <a:extLst>
              <a:ext uri="{FF2B5EF4-FFF2-40B4-BE49-F238E27FC236}">
                <a16:creationId xmlns:a16="http://schemas.microsoft.com/office/drawing/2014/main" id="{6F86FE8F-D5C7-5A8B-BB87-5E12FDC17192}"/>
              </a:ext>
            </a:extLst>
          </p:cNvPr>
          <p:cNvSpPr txBox="1"/>
          <p:nvPr/>
        </p:nvSpPr>
        <p:spPr>
          <a:xfrm>
            <a:off x="10604144" y="2091241"/>
            <a:ext cx="363518" cy="1692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5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59.3%</a:t>
            </a:r>
            <a:endParaRPr dirty="0"/>
          </a:p>
        </p:txBody>
      </p:sp>
      <p:sp>
        <p:nvSpPr>
          <p:cNvPr id="106" name="Google Shape;516;p2">
            <a:extLst>
              <a:ext uri="{FF2B5EF4-FFF2-40B4-BE49-F238E27FC236}">
                <a16:creationId xmlns:a16="http://schemas.microsoft.com/office/drawing/2014/main" id="{8DFEFD5F-09EC-2200-29AE-765B6A8E8134}"/>
              </a:ext>
            </a:extLst>
          </p:cNvPr>
          <p:cNvSpPr txBox="1"/>
          <p:nvPr/>
        </p:nvSpPr>
        <p:spPr>
          <a:xfrm>
            <a:off x="10785903" y="1819087"/>
            <a:ext cx="363518" cy="1692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5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68.5%</a:t>
            </a:r>
            <a:endParaRPr dirty="0"/>
          </a:p>
        </p:txBody>
      </p:sp>
      <p:sp>
        <p:nvSpPr>
          <p:cNvPr id="107" name="Google Shape;516;p2">
            <a:extLst>
              <a:ext uri="{FF2B5EF4-FFF2-40B4-BE49-F238E27FC236}">
                <a16:creationId xmlns:a16="http://schemas.microsoft.com/office/drawing/2014/main" id="{6F23778F-C041-EC55-F11A-789C8CC5BBE3}"/>
              </a:ext>
            </a:extLst>
          </p:cNvPr>
          <p:cNvSpPr txBox="1"/>
          <p:nvPr/>
        </p:nvSpPr>
        <p:spPr>
          <a:xfrm>
            <a:off x="10975579" y="1751829"/>
            <a:ext cx="363518" cy="1692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5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71.9%</a:t>
            </a:r>
            <a:endParaRPr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E49E098-7298-DD90-B553-49D3481A3B6E}"/>
              </a:ext>
            </a:extLst>
          </p:cNvPr>
          <p:cNvSpPr txBox="1"/>
          <p:nvPr/>
        </p:nvSpPr>
        <p:spPr>
          <a:xfrm>
            <a:off x="253158" y="1937862"/>
            <a:ext cx="2938255" cy="144655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600"/>
              </a:spcAft>
            </a:pPr>
            <a:r>
              <a:rPr lang="en-US" sz="1100" b="1" dirty="0">
                <a:solidFill>
                  <a:schemeClr val="tx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SUPPLEMENTARY FIGURE S7</a:t>
            </a:r>
            <a:r>
              <a:rPr lang="en-US" sz="1100" b="1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Prevalence of </a:t>
            </a:r>
            <a:r>
              <a:rPr lang="en-US" sz="1100" b="1" i="1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SR1</a:t>
            </a:r>
            <a:r>
              <a:rPr lang="en-US" sz="1100" b="1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ut and PI3K/AKT pathway alterations detected in tissue specimens of HR(+)HER2(-) </a:t>
            </a:r>
            <a:r>
              <a:rPr lang="en-US" sz="1100" b="1" dirty="0" err="1"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BC</a:t>
            </a:r>
            <a:r>
              <a:rPr lang="en-US" sz="1100" b="1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 the first three metastatic lines of therapy collected prior to 2015 and collected in 2015 </a:t>
            </a:r>
            <a:r>
              <a:rPr lang="en-US" sz="1100" b="1"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r later. </a:t>
            </a:r>
            <a:r>
              <a:rPr lang="en-US" sz="11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-values are unadjusted.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L</a:t>
            </a:r>
            <a:r>
              <a:rPr lang="en-US" sz="11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ss: homozygous copy loss; mut: mutation.</a:t>
            </a:r>
          </a:p>
        </p:txBody>
      </p:sp>
      <p:sp>
        <p:nvSpPr>
          <p:cNvPr id="5" name="Google Shape;568;p2">
            <a:extLst>
              <a:ext uri="{FF2B5EF4-FFF2-40B4-BE49-F238E27FC236}">
                <a16:creationId xmlns:a16="http://schemas.microsoft.com/office/drawing/2014/main" id="{7CBB9FB4-7EAA-CD0A-7D3A-2513C03D256A}"/>
              </a:ext>
            </a:extLst>
          </p:cNvPr>
          <p:cNvSpPr txBox="1"/>
          <p:nvPr/>
        </p:nvSpPr>
        <p:spPr>
          <a:xfrm>
            <a:off x="10115067" y="4345958"/>
            <a:ext cx="978153" cy="60016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*p &lt;0.05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**p &lt;0.01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***p &lt;0.001</a:t>
            </a:r>
            <a:endParaRPr/>
          </a:p>
        </p:txBody>
      </p:sp>
      <p:cxnSp>
        <p:nvCxnSpPr>
          <p:cNvPr id="32" name="Google Shape;596;p2">
            <a:extLst>
              <a:ext uri="{FF2B5EF4-FFF2-40B4-BE49-F238E27FC236}">
                <a16:creationId xmlns:a16="http://schemas.microsoft.com/office/drawing/2014/main" id="{C860472D-3F5D-183E-3BF0-CC4948C6033C}"/>
              </a:ext>
            </a:extLst>
          </p:cNvPr>
          <p:cNvCxnSpPr>
            <a:cxnSpLocks/>
            <a:endCxn id="50" idx="0"/>
          </p:cNvCxnSpPr>
          <p:nvPr/>
        </p:nvCxnSpPr>
        <p:spPr>
          <a:xfrm rot="5400000" flipH="1" flipV="1">
            <a:off x="3887334" y="3010549"/>
            <a:ext cx="641508" cy="377260"/>
          </a:xfrm>
          <a:prstGeom prst="bentConnector3">
            <a:avLst>
              <a:gd name="adj1" fmla="val 116756"/>
            </a:avLst>
          </a:prstGeom>
          <a:noFill/>
          <a:ln w="12700" cap="flat" cmpd="sng">
            <a:solidFill>
              <a:schemeClr val="accent1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33" name="Google Shape;597;p2">
            <a:extLst>
              <a:ext uri="{FF2B5EF4-FFF2-40B4-BE49-F238E27FC236}">
                <a16:creationId xmlns:a16="http://schemas.microsoft.com/office/drawing/2014/main" id="{8C8FD5F2-F13C-C754-0B5E-836011B3B448}"/>
              </a:ext>
            </a:extLst>
          </p:cNvPr>
          <p:cNvSpPr txBox="1"/>
          <p:nvPr/>
        </p:nvSpPr>
        <p:spPr>
          <a:xfrm flipV="1">
            <a:off x="3956876" y="2584234"/>
            <a:ext cx="372843" cy="2000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**</a:t>
            </a:r>
            <a:endParaRPr sz="1400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37" name="Google Shape;596;p2">
            <a:extLst>
              <a:ext uri="{FF2B5EF4-FFF2-40B4-BE49-F238E27FC236}">
                <a16:creationId xmlns:a16="http://schemas.microsoft.com/office/drawing/2014/main" id="{5808480A-0FC1-E907-47AB-6DDECA263542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4469914" y="2941911"/>
            <a:ext cx="641508" cy="377260"/>
          </a:xfrm>
          <a:prstGeom prst="bentConnector3">
            <a:avLst>
              <a:gd name="adj1" fmla="val 116756"/>
            </a:avLst>
          </a:prstGeom>
          <a:noFill/>
          <a:ln w="12700" cap="flat" cmpd="sng">
            <a:solidFill>
              <a:schemeClr val="accent1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38" name="Google Shape;597;p2">
            <a:extLst>
              <a:ext uri="{FF2B5EF4-FFF2-40B4-BE49-F238E27FC236}">
                <a16:creationId xmlns:a16="http://schemas.microsoft.com/office/drawing/2014/main" id="{DDEE68E0-7765-FC8A-C842-3600E036FAA2}"/>
              </a:ext>
            </a:extLst>
          </p:cNvPr>
          <p:cNvSpPr txBox="1"/>
          <p:nvPr/>
        </p:nvSpPr>
        <p:spPr>
          <a:xfrm flipV="1">
            <a:off x="4551193" y="2526073"/>
            <a:ext cx="372843" cy="2000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***</a:t>
            </a:r>
            <a:endParaRPr sz="1400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39" name="Google Shape;596;p2">
            <a:extLst>
              <a:ext uri="{FF2B5EF4-FFF2-40B4-BE49-F238E27FC236}">
                <a16:creationId xmlns:a16="http://schemas.microsoft.com/office/drawing/2014/main" id="{3CAF5FC3-AE60-88F8-638D-1BEA3E241A27}"/>
              </a:ext>
            </a:extLst>
          </p:cNvPr>
          <p:cNvCxnSpPr>
            <a:cxnSpLocks/>
            <a:endCxn id="31" idx="0"/>
          </p:cNvCxnSpPr>
          <p:nvPr/>
        </p:nvCxnSpPr>
        <p:spPr>
          <a:xfrm rot="5400000" flipH="1" flipV="1">
            <a:off x="4448977" y="3066848"/>
            <a:ext cx="538780" cy="232660"/>
          </a:xfrm>
          <a:prstGeom prst="bentConnector3">
            <a:avLst>
              <a:gd name="adj1" fmla="val 118826"/>
            </a:avLst>
          </a:prstGeom>
          <a:noFill/>
          <a:ln w="12700" cap="flat" cmpd="sng">
            <a:solidFill>
              <a:schemeClr val="accent1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42" name="Google Shape;597;p2">
            <a:extLst>
              <a:ext uri="{FF2B5EF4-FFF2-40B4-BE49-F238E27FC236}">
                <a16:creationId xmlns:a16="http://schemas.microsoft.com/office/drawing/2014/main" id="{C30028A8-62C2-3B8F-18F9-76BCCECE34ED}"/>
              </a:ext>
            </a:extLst>
          </p:cNvPr>
          <p:cNvSpPr txBox="1"/>
          <p:nvPr/>
        </p:nvSpPr>
        <p:spPr>
          <a:xfrm flipV="1">
            <a:off x="4491901" y="2645862"/>
            <a:ext cx="372843" cy="2000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***</a:t>
            </a:r>
            <a:endParaRPr sz="1400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64077401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graph of a number of cells&#10;&#10;Description automatically generated with medium confidence">
            <a:extLst>
              <a:ext uri="{FF2B5EF4-FFF2-40B4-BE49-F238E27FC236}">
                <a16:creationId xmlns:a16="http://schemas.microsoft.com/office/drawing/2014/main" id="{C9D77DFD-C7B8-F0FD-075C-575D7FF7F53E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3495" b="4720"/>
          <a:stretch/>
        </p:blipFill>
        <p:spPr>
          <a:xfrm>
            <a:off x="1260357" y="1837527"/>
            <a:ext cx="2216954" cy="3176174"/>
          </a:xfrm>
          <a:prstGeom prst="rect">
            <a:avLst/>
          </a:prstGeom>
        </p:spPr>
      </p:pic>
      <p:pic>
        <p:nvPicPr>
          <p:cNvPr id="5" name="Picture 4" descr="A graph of a number of cells&#10;&#10;Description automatically generated with medium confidence">
            <a:extLst>
              <a:ext uri="{FF2B5EF4-FFF2-40B4-BE49-F238E27FC236}">
                <a16:creationId xmlns:a16="http://schemas.microsoft.com/office/drawing/2014/main" id="{7ADF01BD-7193-6F5D-0E7E-B4B6F5D6A73F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1956" b="4330"/>
          <a:stretch/>
        </p:blipFill>
        <p:spPr>
          <a:xfrm>
            <a:off x="3661135" y="1837528"/>
            <a:ext cx="2259021" cy="3176174"/>
          </a:xfrm>
          <a:prstGeom prst="rect">
            <a:avLst/>
          </a:prstGeom>
        </p:spPr>
      </p:pic>
      <p:pic>
        <p:nvPicPr>
          <p:cNvPr id="6" name="Picture 5" descr="A graph of a number of cells&#10;&#10;Description automatically generated with medium confidence">
            <a:extLst>
              <a:ext uri="{FF2B5EF4-FFF2-40B4-BE49-F238E27FC236}">
                <a16:creationId xmlns:a16="http://schemas.microsoft.com/office/drawing/2014/main" id="{BF54D702-4E5F-F5A5-0CED-41F23161A593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4448" b="4330"/>
          <a:stretch/>
        </p:blipFill>
        <p:spPr>
          <a:xfrm>
            <a:off x="5920156" y="1837527"/>
            <a:ext cx="2176299" cy="3176174"/>
          </a:xfrm>
          <a:prstGeom prst="rect">
            <a:avLst/>
          </a:prstGeom>
        </p:spPr>
      </p:pic>
      <p:pic>
        <p:nvPicPr>
          <p:cNvPr id="7" name="Picture 6" descr="A graph of a number of cells&#10;&#10;Description automatically generated with medium confidence">
            <a:extLst>
              <a:ext uri="{FF2B5EF4-FFF2-40B4-BE49-F238E27FC236}">
                <a16:creationId xmlns:a16="http://schemas.microsoft.com/office/drawing/2014/main" id="{0C8DDFA1-307A-9C88-18ED-9C74EAD92648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535"/>
          <a:stretch/>
        </p:blipFill>
        <p:spPr>
          <a:xfrm>
            <a:off x="8257195" y="1844298"/>
            <a:ext cx="3319949" cy="3169404"/>
          </a:xfrm>
          <a:prstGeom prst="rect">
            <a:avLst/>
          </a:prstGeom>
        </p:spPr>
      </p:pic>
      <p:sp>
        <p:nvSpPr>
          <p:cNvPr id="9" name="Google Shape;452;p1">
            <a:extLst>
              <a:ext uri="{FF2B5EF4-FFF2-40B4-BE49-F238E27FC236}">
                <a16:creationId xmlns:a16="http://schemas.microsoft.com/office/drawing/2014/main" id="{E61A3D01-FC6E-17B1-0D23-7BD46BAE2228}"/>
              </a:ext>
            </a:extLst>
          </p:cNvPr>
          <p:cNvSpPr txBox="1"/>
          <p:nvPr/>
        </p:nvSpPr>
        <p:spPr>
          <a:xfrm>
            <a:off x="4141656" y="1348994"/>
            <a:ext cx="1603445" cy="57704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5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atients with </a:t>
            </a:r>
            <a:r>
              <a:rPr lang="en-US" sz="105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LBx</a:t>
            </a:r>
            <a:r>
              <a:rPr lang="en-US" sz="105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collected at</a:t>
            </a:r>
            <a:endParaRPr dirty="0"/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5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</a:t>
            </a:r>
            <a:r>
              <a:rPr lang="en-US" sz="1050" baseline="300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t</a:t>
            </a:r>
            <a:r>
              <a:rPr lang="en-US" sz="105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line (n=288)</a:t>
            </a:r>
            <a:endParaRPr dirty="0"/>
          </a:p>
        </p:txBody>
      </p:sp>
      <p:sp>
        <p:nvSpPr>
          <p:cNvPr id="10" name="Google Shape;453;p1">
            <a:extLst>
              <a:ext uri="{FF2B5EF4-FFF2-40B4-BE49-F238E27FC236}">
                <a16:creationId xmlns:a16="http://schemas.microsoft.com/office/drawing/2014/main" id="{325FC49F-39F7-552C-823C-040BAD28A6A1}"/>
              </a:ext>
            </a:extLst>
          </p:cNvPr>
          <p:cNvSpPr txBox="1"/>
          <p:nvPr/>
        </p:nvSpPr>
        <p:spPr>
          <a:xfrm>
            <a:off x="6433198" y="1347631"/>
            <a:ext cx="1637129" cy="5770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5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atients with </a:t>
            </a:r>
            <a:r>
              <a:rPr lang="en-US" sz="105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LBx</a:t>
            </a:r>
            <a:r>
              <a:rPr lang="en-US" sz="105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collected at</a:t>
            </a:r>
            <a:endParaRPr dirty="0"/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5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2</a:t>
            </a:r>
            <a:r>
              <a:rPr lang="en-US" sz="1050" baseline="300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nd</a:t>
            </a:r>
            <a:r>
              <a:rPr lang="en-US" sz="105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line (n=196*)</a:t>
            </a:r>
            <a:endParaRPr dirty="0"/>
          </a:p>
        </p:txBody>
      </p:sp>
      <p:sp>
        <p:nvSpPr>
          <p:cNvPr id="11" name="Google Shape;454;p1">
            <a:extLst>
              <a:ext uri="{FF2B5EF4-FFF2-40B4-BE49-F238E27FC236}">
                <a16:creationId xmlns:a16="http://schemas.microsoft.com/office/drawing/2014/main" id="{B7B3523C-5543-9156-135C-87EA55050C34}"/>
              </a:ext>
            </a:extLst>
          </p:cNvPr>
          <p:cNvSpPr txBox="1"/>
          <p:nvPr/>
        </p:nvSpPr>
        <p:spPr>
          <a:xfrm>
            <a:off x="8758424" y="1348994"/>
            <a:ext cx="1701172" cy="5770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5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atients with </a:t>
            </a:r>
            <a:r>
              <a:rPr lang="en-US" sz="105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LBx</a:t>
            </a:r>
            <a:r>
              <a:rPr lang="en-US" sz="105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collected at</a:t>
            </a:r>
            <a:endParaRPr dirty="0"/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5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3</a:t>
            </a:r>
            <a:r>
              <a:rPr lang="en-US" sz="1050" baseline="300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rd</a:t>
            </a:r>
            <a:r>
              <a:rPr lang="en-US" sz="105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line (n=119)</a:t>
            </a:r>
            <a:endParaRPr dirty="0"/>
          </a:p>
        </p:txBody>
      </p:sp>
      <p:sp>
        <p:nvSpPr>
          <p:cNvPr id="12" name="Google Shape;452;p1">
            <a:extLst>
              <a:ext uri="{FF2B5EF4-FFF2-40B4-BE49-F238E27FC236}">
                <a16:creationId xmlns:a16="http://schemas.microsoft.com/office/drawing/2014/main" id="{5A222CE5-CF99-EAC5-F10C-4AFCE381393A}"/>
              </a:ext>
            </a:extLst>
          </p:cNvPr>
          <p:cNvSpPr txBox="1"/>
          <p:nvPr/>
        </p:nvSpPr>
        <p:spPr>
          <a:xfrm>
            <a:off x="1749497" y="1360534"/>
            <a:ext cx="1671378" cy="57704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5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ll patients with </a:t>
            </a:r>
            <a:r>
              <a:rPr lang="en-US" sz="105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LBx</a:t>
            </a:r>
            <a:r>
              <a:rPr lang="en-US" sz="105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and Metastasis site data</a:t>
            </a:r>
            <a:endParaRPr dirty="0"/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5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n=1663)</a:t>
            </a:r>
            <a:endParaRPr dirty="0"/>
          </a:p>
        </p:txBody>
      </p:sp>
      <p:sp>
        <p:nvSpPr>
          <p:cNvPr id="13" name="Google Shape;439;p1">
            <a:extLst>
              <a:ext uri="{FF2B5EF4-FFF2-40B4-BE49-F238E27FC236}">
                <a16:creationId xmlns:a16="http://schemas.microsoft.com/office/drawing/2014/main" id="{5E046A75-AAC4-3218-6A8A-9795CA510F34}"/>
              </a:ext>
            </a:extLst>
          </p:cNvPr>
          <p:cNvSpPr txBox="1"/>
          <p:nvPr/>
        </p:nvSpPr>
        <p:spPr>
          <a:xfrm>
            <a:off x="1599594" y="4886139"/>
            <a:ext cx="1191352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Bone only</a:t>
            </a:r>
            <a:endParaRPr sz="900" dirty="0"/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n=</a:t>
            </a:r>
            <a:r>
              <a:rPr lang="en-US" sz="900" dirty="0">
                <a:solidFill>
                  <a:schemeClr val="dk1"/>
                </a:solidFill>
              </a:rPr>
              <a:t>636</a:t>
            </a:r>
            <a:r>
              <a:rPr lang="en-US" sz="9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)</a:t>
            </a:r>
            <a:endParaRPr sz="900" dirty="0"/>
          </a:p>
        </p:txBody>
      </p:sp>
      <p:sp>
        <p:nvSpPr>
          <p:cNvPr id="14" name="Google Shape;439;p1">
            <a:extLst>
              <a:ext uri="{FF2B5EF4-FFF2-40B4-BE49-F238E27FC236}">
                <a16:creationId xmlns:a16="http://schemas.microsoft.com/office/drawing/2014/main" id="{2956FD72-52BD-4559-A803-C750F1602FF0}"/>
              </a:ext>
            </a:extLst>
          </p:cNvPr>
          <p:cNvSpPr txBox="1"/>
          <p:nvPr/>
        </p:nvSpPr>
        <p:spPr>
          <a:xfrm>
            <a:off x="2389413" y="4886138"/>
            <a:ext cx="1191352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Visceral</a:t>
            </a:r>
            <a:endParaRPr sz="900" dirty="0"/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n=1,027)</a:t>
            </a:r>
            <a:endParaRPr sz="900" dirty="0"/>
          </a:p>
        </p:txBody>
      </p:sp>
      <p:sp>
        <p:nvSpPr>
          <p:cNvPr id="15" name="Google Shape;439;p1">
            <a:extLst>
              <a:ext uri="{FF2B5EF4-FFF2-40B4-BE49-F238E27FC236}">
                <a16:creationId xmlns:a16="http://schemas.microsoft.com/office/drawing/2014/main" id="{8DF9A4A3-2D6A-D728-ED40-A25E8F493538}"/>
              </a:ext>
            </a:extLst>
          </p:cNvPr>
          <p:cNvSpPr txBox="1"/>
          <p:nvPr/>
        </p:nvSpPr>
        <p:spPr>
          <a:xfrm>
            <a:off x="4019355" y="4886139"/>
            <a:ext cx="1191352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Bone only</a:t>
            </a:r>
            <a:endParaRPr sz="900" dirty="0"/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n=</a:t>
            </a:r>
            <a:r>
              <a:rPr lang="en-US" sz="900" dirty="0">
                <a:solidFill>
                  <a:schemeClr val="dk1"/>
                </a:solidFill>
              </a:rPr>
              <a:t>88</a:t>
            </a:r>
            <a:r>
              <a:rPr lang="en-US" sz="9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)</a:t>
            </a:r>
            <a:endParaRPr sz="900" dirty="0"/>
          </a:p>
        </p:txBody>
      </p:sp>
      <p:sp>
        <p:nvSpPr>
          <p:cNvPr id="16" name="Google Shape;439;p1">
            <a:extLst>
              <a:ext uri="{FF2B5EF4-FFF2-40B4-BE49-F238E27FC236}">
                <a16:creationId xmlns:a16="http://schemas.microsoft.com/office/drawing/2014/main" id="{A1DA35F5-B80E-4C3A-7262-113ECC4799D1}"/>
              </a:ext>
            </a:extLst>
          </p:cNvPr>
          <p:cNvSpPr txBox="1"/>
          <p:nvPr/>
        </p:nvSpPr>
        <p:spPr>
          <a:xfrm>
            <a:off x="4809174" y="4886138"/>
            <a:ext cx="1191352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Visceral</a:t>
            </a:r>
            <a:endParaRPr sz="900" dirty="0"/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n=200)</a:t>
            </a:r>
            <a:endParaRPr sz="900" dirty="0"/>
          </a:p>
        </p:txBody>
      </p:sp>
      <p:sp>
        <p:nvSpPr>
          <p:cNvPr id="17" name="Google Shape;439;p1">
            <a:extLst>
              <a:ext uri="{FF2B5EF4-FFF2-40B4-BE49-F238E27FC236}">
                <a16:creationId xmlns:a16="http://schemas.microsoft.com/office/drawing/2014/main" id="{210E2787-DC57-798B-20FB-1FFDD1593A82}"/>
              </a:ext>
            </a:extLst>
          </p:cNvPr>
          <p:cNvSpPr txBox="1"/>
          <p:nvPr/>
        </p:nvSpPr>
        <p:spPr>
          <a:xfrm>
            <a:off x="6290339" y="4886139"/>
            <a:ext cx="1191352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Bone only</a:t>
            </a:r>
            <a:endParaRPr sz="900" dirty="0"/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n=64)</a:t>
            </a:r>
            <a:endParaRPr sz="900" dirty="0"/>
          </a:p>
        </p:txBody>
      </p:sp>
      <p:sp>
        <p:nvSpPr>
          <p:cNvPr id="18" name="Google Shape;439;p1">
            <a:extLst>
              <a:ext uri="{FF2B5EF4-FFF2-40B4-BE49-F238E27FC236}">
                <a16:creationId xmlns:a16="http://schemas.microsoft.com/office/drawing/2014/main" id="{A7ED599B-33E1-D31F-1292-4AF55234E3CA}"/>
              </a:ext>
            </a:extLst>
          </p:cNvPr>
          <p:cNvSpPr txBox="1"/>
          <p:nvPr/>
        </p:nvSpPr>
        <p:spPr>
          <a:xfrm>
            <a:off x="7080158" y="4886138"/>
            <a:ext cx="1191352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Visceral</a:t>
            </a:r>
            <a:endParaRPr sz="900" dirty="0"/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n=196)</a:t>
            </a:r>
            <a:endParaRPr sz="900" dirty="0"/>
          </a:p>
        </p:txBody>
      </p:sp>
      <p:sp>
        <p:nvSpPr>
          <p:cNvPr id="19" name="Google Shape;439;p1">
            <a:extLst>
              <a:ext uri="{FF2B5EF4-FFF2-40B4-BE49-F238E27FC236}">
                <a16:creationId xmlns:a16="http://schemas.microsoft.com/office/drawing/2014/main" id="{5F623087-B307-81B8-793C-D35A2BB26A4E}"/>
              </a:ext>
            </a:extLst>
          </p:cNvPr>
          <p:cNvSpPr txBox="1"/>
          <p:nvPr/>
        </p:nvSpPr>
        <p:spPr>
          <a:xfrm>
            <a:off x="8645066" y="4886139"/>
            <a:ext cx="1191352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Bone only</a:t>
            </a:r>
            <a:endParaRPr sz="900" dirty="0"/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n=23)</a:t>
            </a:r>
            <a:endParaRPr sz="900" dirty="0"/>
          </a:p>
        </p:txBody>
      </p:sp>
      <p:sp>
        <p:nvSpPr>
          <p:cNvPr id="20" name="Google Shape;439;p1">
            <a:extLst>
              <a:ext uri="{FF2B5EF4-FFF2-40B4-BE49-F238E27FC236}">
                <a16:creationId xmlns:a16="http://schemas.microsoft.com/office/drawing/2014/main" id="{5DAE5085-80A2-1E18-8416-47A2F3A8C3E6}"/>
              </a:ext>
            </a:extLst>
          </p:cNvPr>
          <p:cNvSpPr txBox="1"/>
          <p:nvPr/>
        </p:nvSpPr>
        <p:spPr>
          <a:xfrm>
            <a:off x="9434885" y="4886138"/>
            <a:ext cx="1191352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Visceral</a:t>
            </a:r>
            <a:endParaRPr sz="900" dirty="0"/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n=96)</a:t>
            </a:r>
            <a:endParaRPr sz="900" dirty="0"/>
          </a:p>
        </p:txBody>
      </p:sp>
      <p:sp>
        <p:nvSpPr>
          <p:cNvPr id="21" name="Google Shape;477;p1">
            <a:extLst>
              <a:ext uri="{FF2B5EF4-FFF2-40B4-BE49-F238E27FC236}">
                <a16:creationId xmlns:a16="http://schemas.microsoft.com/office/drawing/2014/main" id="{0B0C2602-0D25-EB67-0E26-0311DD81ED21}"/>
              </a:ext>
            </a:extLst>
          </p:cNvPr>
          <p:cNvSpPr txBox="1"/>
          <p:nvPr/>
        </p:nvSpPr>
        <p:spPr>
          <a:xfrm>
            <a:off x="362025" y="5497466"/>
            <a:ext cx="11277001" cy="60012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algn="just">
              <a:buClr>
                <a:schemeClr val="dk1"/>
              </a:buClr>
              <a:buSzPts val="1100"/>
            </a:pPr>
            <a:r>
              <a:rPr lang="en-US" sz="1100" b="1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SUPPLEMENTARY FIGURE S8: </a:t>
            </a:r>
            <a:r>
              <a:rPr lang="en-US" sz="1100" b="1" dirty="0" err="1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ctDNA</a:t>
            </a:r>
            <a:r>
              <a:rPr lang="en-US" sz="1100" b="1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 TF distribution in patient with bone-only metastasis vs. visceral (with or without bone) metastasis. 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All patients with </a:t>
            </a:r>
            <a:r>
              <a:rPr lang="en-US" sz="1100" dirty="0" err="1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LBx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 and metastasis site data (A); Patients with </a:t>
            </a:r>
            <a:r>
              <a:rPr lang="en-US" sz="1100" dirty="0" err="1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LBx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 collected at 1</a:t>
            </a:r>
            <a:r>
              <a:rPr lang="en-US" sz="1100" baseline="300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st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 line (B), at 2</a:t>
            </a:r>
            <a:r>
              <a:rPr lang="en-US" sz="1100" baseline="300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nd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 line (C), and at 3</a:t>
            </a:r>
            <a:r>
              <a:rPr lang="en-US" sz="1100" baseline="300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rd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 line (D).</a:t>
            </a:r>
            <a:r>
              <a:rPr lang="en-US" sz="11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values for the comparison of samples with </a:t>
            </a:r>
            <a:r>
              <a:rPr lang="en-US" sz="1100" dirty="0" err="1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DNA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F &lt;1% vs. ctDNA TF &gt;=1%.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 </a:t>
            </a:r>
            <a:r>
              <a:rPr lang="en-US" sz="1100" dirty="0" err="1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ctDNA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ea typeface="Montserrat"/>
                <a:cs typeface="Arial" panose="020B0604020202020204" pitchFamily="34" charset="0"/>
                <a:sym typeface="Montserrat"/>
              </a:rPr>
              <a:t> TF: circular tumor DNA tumor 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Montserrat"/>
              </a:rPr>
              <a:t>fraction; </a:t>
            </a:r>
            <a:r>
              <a:rPr lang="en-US" sz="1100" dirty="0" err="1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Montserrat"/>
              </a:rPr>
              <a:t>LBx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Montserrat"/>
              </a:rPr>
              <a:t>: liquid biopsy. *1 patients with </a:t>
            </a:r>
            <a:r>
              <a:rPr lang="en-US" sz="1100" dirty="0" err="1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Montserrat"/>
              </a:rPr>
              <a:t>LBx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Montserrat"/>
              </a:rPr>
              <a:t> collected at 2</a:t>
            </a:r>
            <a:r>
              <a:rPr lang="en-US" sz="1100" baseline="300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Montserrat"/>
              </a:rPr>
              <a:t>nd</a:t>
            </a:r>
            <a:r>
              <a:rPr lang="en-US" sz="110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Montserrat"/>
              </a:rPr>
              <a:t> line but with metastasis site data missing.</a:t>
            </a:r>
            <a:endParaRPr sz="1100" dirty="0">
              <a:solidFill>
                <a:schemeClr val="dk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Google Shape;474;p1">
            <a:extLst>
              <a:ext uri="{FF2B5EF4-FFF2-40B4-BE49-F238E27FC236}">
                <a16:creationId xmlns:a16="http://schemas.microsoft.com/office/drawing/2014/main" id="{F8709317-5F26-F56B-CA65-6184EDB2838F}"/>
              </a:ext>
            </a:extLst>
          </p:cNvPr>
          <p:cNvSpPr txBox="1"/>
          <p:nvPr/>
        </p:nvSpPr>
        <p:spPr>
          <a:xfrm>
            <a:off x="1260357" y="973623"/>
            <a:ext cx="566181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A)</a:t>
            </a:r>
            <a:endParaRPr dirty="0"/>
          </a:p>
        </p:txBody>
      </p:sp>
      <p:sp>
        <p:nvSpPr>
          <p:cNvPr id="23" name="Google Shape;474;p1">
            <a:extLst>
              <a:ext uri="{FF2B5EF4-FFF2-40B4-BE49-F238E27FC236}">
                <a16:creationId xmlns:a16="http://schemas.microsoft.com/office/drawing/2014/main" id="{33C36BFF-AA01-1891-CE2A-6E35CF8788E0}"/>
              </a:ext>
            </a:extLst>
          </p:cNvPr>
          <p:cNvSpPr txBox="1"/>
          <p:nvPr/>
        </p:nvSpPr>
        <p:spPr>
          <a:xfrm>
            <a:off x="3590639" y="973623"/>
            <a:ext cx="566181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B)</a:t>
            </a:r>
            <a:endParaRPr dirty="0"/>
          </a:p>
        </p:txBody>
      </p:sp>
      <p:sp>
        <p:nvSpPr>
          <p:cNvPr id="24" name="Google Shape;474;p1">
            <a:extLst>
              <a:ext uri="{FF2B5EF4-FFF2-40B4-BE49-F238E27FC236}">
                <a16:creationId xmlns:a16="http://schemas.microsoft.com/office/drawing/2014/main" id="{D1478C38-32DA-3931-217E-131830C676FF}"/>
              </a:ext>
            </a:extLst>
          </p:cNvPr>
          <p:cNvSpPr txBox="1"/>
          <p:nvPr/>
        </p:nvSpPr>
        <p:spPr>
          <a:xfrm>
            <a:off x="5812909" y="973623"/>
            <a:ext cx="566181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C)</a:t>
            </a:r>
            <a:endParaRPr dirty="0"/>
          </a:p>
        </p:txBody>
      </p:sp>
      <p:sp>
        <p:nvSpPr>
          <p:cNvPr id="25" name="Google Shape;474;p1">
            <a:extLst>
              <a:ext uri="{FF2B5EF4-FFF2-40B4-BE49-F238E27FC236}">
                <a16:creationId xmlns:a16="http://schemas.microsoft.com/office/drawing/2014/main" id="{C89F6E7B-96FA-BD95-0461-1C8F578D2882}"/>
              </a:ext>
            </a:extLst>
          </p:cNvPr>
          <p:cNvSpPr txBox="1"/>
          <p:nvPr/>
        </p:nvSpPr>
        <p:spPr>
          <a:xfrm>
            <a:off x="8167201" y="976404"/>
            <a:ext cx="566181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D)</a:t>
            </a:r>
            <a:endParaRPr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63D7BD0-3391-6530-1863-4D46883C332E}"/>
              </a:ext>
            </a:extLst>
          </p:cNvPr>
          <p:cNvSpPr txBox="1"/>
          <p:nvPr/>
        </p:nvSpPr>
        <p:spPr>
          <a:xfrm>
            <a:off x="2058235" y="5210517"/>
            <a:ext cx="101021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P-value=0.885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7734ABE0-B0A7-7702-2B5A-9774C20CCBE3}"/>
              </a:ext>
            </a:extLst>
          </p:cNvPr>
          <p:cNvSpPr txBox="1"/>
          <p:nvPr/>
        </p:nvSpPr>
        <p:spPr>
          <a:xfrm>
            <a:off x="4790645" y="5189858"/>
            <a:ext cx="4154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P=1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B816DC56-851F-717D-008F-D16B275B6A7F}"/>
              </a:ext>
            </a:extLst>
          </p:cNvPr>
          <p:cNvSpPr txBox="1"/>
          <p:nvPr/>
        </p:nvSpPr>
        <p:spPr>
          <a:xfrm>
            <a:off x="6920581" y="5189857"/>
            <a:ext cx="6623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P=0.173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3A401D1-5AF9-F735-C3EF-AC185B7177B7}"/>
              </a:ext>
            </a:extLst>
          </p:cNvPr>
          <p:cNvSpPr txBox="1"/>
          <p:nvPr/>
        </p:nvSpPr>
        <p:spPr>
          <a:xfrm>
            <a:off x="9277829" y="5213192"/>
            <a:ext cx="6623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P=0.058</a:t>
            </a:r>
          </a:p>
        </p:txBody>
      </p:sp>
    </p:spTree>
    <p:extLst>
      <p:ext uri="{BB962C8B-B14F-4D97-AF65-F5344CB8AC3E}">
        <p14:creationId xmlns:p14="http://schemas.microsoft.com/office/powerpoint/2010/main" val="27761256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2400</Words>
  <Application>Microsoft Macintosh PowerPoint</Application>
  <PresentationFormat>Widescreen</PresentationFormat>
  <Paragraphs>365</Paragraphs>
  <Slides>13</Slides>
  <Notes>1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9" baseType="lpstr">
      <vt:lpstr>Aptos Display</vt:lpstr>
      <vt:lpstr>Montserrat</vt:lpstr>
      <vt:lpstr>Aptos</vt:lpstr>
      <vt:lpstr>Arial</vt:lpstr>
      <vt:lpstr>Calibri</vt:lpstr>
      <vt:lpstr>Office Theme</vt:lpstr>
      <vt:lpstr>SUPPLEMENTARY FIGURES AND TABLE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yon Graf</dc:creator>
  <cp:lastModifiedBy>Julia Quintanilha</cp:lastModifiedBy>
  <cp:revision>3</cp:revision>
  <dcterms:created xsi:type="dcterms:W3CDTF">2020-10-26T18:38:31Z</dcterms:created>
  <dcterms:modified xsi:type="dcterms:W3CDTF">2024-04-16T12:42:4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8BD069CA59325E40A41A47408702D800</vt:lpwstr>
  </property>
</Properties>
</file>